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62" r:id="rId3"/>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36" userDrawn="1">
          <p15:clr>
            <a:srgbClr val="A4A3A4"/>
          </p15:clr>
        </p15:guide>
        <p15:guide id="2" pos="1958" userDrawn="1">
          <p15:clr>
            <a:srgbClr val="A4A3A4"/>
          </p15:clr>
        </p15:guide>
        <p15:guide id="3" orient="horz" pos="1774" userDrawn="1">
          <p15:clr>
            <a:srgbClr val="A4A3A4"/>
          </p15:clr>
        </p15:guide>
        <p15:guide id="4" orient="horz" pos="1706" userDrawn="1">
          <p15:clr>
            <a:srgbClr val="A4A3A4"/>
          </p15:clr>
        </p15:guide>
        <p15:guide id="5" pos="1890" userDrawn="1">
          <p15:clr>
            <a:srgbClr val="A4A3A4"/>
          </p15:clr>
        </p15:guide>
        <p15:guide id="6" pos="5813" userDrawn="1">
          <p15:clr>
            <a:srgbClr val="A4A3A4"/>
          </p15:clr>
        </p15:guide>
        <p15:guide id="7" pos="5858" userDrawn="1">
          <p15:clr>
            <a:srgbClr val="A4A3A4"/>
          </p15:clr>
        </p15:guide>
        <p15:guide id="8" orient="horz" pos="119"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2638" autoAdjust="0"/>
    <p:restoredTop sz="79900" autoAdjust="0"/>
  </p:normalViewPr>
  <p:slideViewPr>
    <p:cSldViewPr snapToGrid="0">
      <p:cViewPr varScale="1">
        <p:scale>
          <a:sx n="65" d="100"/>
          <a:sy n="65" d="100"/>
        </p:scale>
        <p:origin x="475" y="43"/>
      </p:cViewPr>
      <p:guideLst>
        <p:guide orient="horz" pos="436"/>
        <p:guide pos="1958"/>
        <p:guide orient="horz" pos="1774"/>
        <p:guide orient="horz" pos="1706"/>
        <p:guide pos="1890"/>
        <p:guide pos="5813"/>
        <p:guide pos="5858"/>
        <p:guide orient="horz" pos="11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5.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40DAEE2-815E-445E-B4F1-6C15B16CEF8B}"/>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p>
        </p:txBody>
      </p:sp>
      <p:sp>
        <p:nvSpPr>
          <p:cNvPr id="3" name="Untertitel 2">
            <a:extLst>
              <a:ext uri="{FF2B5EF4-FFF2-40B4-BE49-F238E27FC236}">
                <a16:creationId xmlns:a16="http://schemas.microsoft.com/office/drawing/2014/main" id="{38759162-B7EF-4D7A-94E6-54DFA2EC9EA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3DAB2D59-E43C-4BC5-9619-F751C05E0849}"/>
              </a:ext>
            </a:extLst>
          </p:cNvPr>
          <p:cNvSpPr>
            <a:spLocks noGrp="1"/>
          </p:cNvSpPr>
          <p:nvPr>
            <p:ph type="dt" sz="half" idx="10"/>
          </p:nvPr>
        </p:nvSpPr>
        <p:spPr/>
        <p:txBody>
          <a:bodyPr/>
          <a:lstStyle/>
          <a:p>
            <a:fld id="{90B7CE6C-A634-4C34-8C1A-E04C7C38E696}" type="datetimeFigureOut">
              <a:rPr lang="de-DE" smtClean="0"/>
              <a:t>23.12.2021</a:t>
            </a:fld>
            <a:endParaRPr lang="de-DE"/>
          </a:p>
        </p:txBody>
      </p:sp>
      <p:sp>
        <p:nvSpPr>
          <p:cNvPr id="5" name="Fußzeilenplatzhalter 4">
            <a:extLst>
              <a:ext uri="{FF2B5EF4-FFF2-40B4-BE49-F238E27FC236}">
                <a16:creationId xmlns:a16="http://schemas.microsoft.com/office/drawing/2014/main" id="{8A92F7A9-6858-42C2-87E7-BC7B78A1278D}"/>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731304FF-53AE-485C-AB80-9CDB86879098}"/>
              </a:ext>
            </a:extLst>
          </p:cNvPr>
          <p:cNvSpPr>
            <a:spLocks noGrp="1"/>
          </p:cNvSpPr>
          <p:nvPr>
            <p:ph type="sldNum" sz="quarter" idx="12"/>
          </p:nvPr>
        </p:nvSpPr>
        <p:spPr/>
        <p:txBody>
          <a:bodyPr/>
          <a:lstStyle/>
          <a:p>
            <a:fld id="{2C4ED143-EA90-41AA-8C76-823181B48DE1}" type="slidenum">
              <a:rPr lang="de-DE" smtClean="0"/>
              <a:t>‹Nr.›</a:t>
            </a:fld>
            <a:endParaRPr lang="de-DE"/>
          </a:p>
        </p:txBody>
      </p:sp>
    </p:spTree>
    <p:extLst>
      <p:ext uri="{BB962C8B-B14F-4D97-AF65-F5344CB8AC3E}">
        <p14:creationId xmlns:p14="http://schemas.microsoft.com/office/powerpoint/2010/main" val="42044826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4C96625-139E-4181-AF83-53619DADA7BF}"/>
              </a:ext>
            </a:extLst>
          </p:cNvPr>
          <p:cNvSpPr>
            <a:spLocks noGrp="1"/>
          </p:cNvSpPr>
          <p:nvPr>
            <p:ph type="title"/>
          </p:nvPr>
        </p:nvSpPr>
        <p:spPr/>
        <p:txBody>
          <a:bodyPr/>
          <a:lstStyle/>
          <a:p>
            <a:r>
              <a:rPr lang="de-DE"/>
              <a:t>Mastertitelformat bearbeiten</a:t>
            </a:r>
          </a:p>
        </p:txBody>
      </p:sp>
      <p:sp>
        <p:nvSpPr>
          <p:cNvPr id="3" name="Vertikaler Textplatzhalter 2">
            <a:extLst>
              <a:ext uri="{FF2B5EF4-FFF2-40B4-BE49-F238E27FC236}">
                <a16:creationId xmlns:a16="http://schemas.microsoft.com/office/drawing/2014/main" id="{16931280-3E2F-4865-AA83-9DC760EC3A49}"/>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87F8914C-470B-4FED-963A-A1C113D49D0F}"/>
              </a:ext>
            </a:extLst>
          </p:cNvPr>
          <p:cNvSpPr>
            <a:spLocks noGrp="1"/>
          </p:cNvSpPr>
          <p:nvPr>
            <p:ph type="dt" sz="half" idx="10"/>
          </p:nvPr>
        </p:nvSpPr>
        <p:spPr/>
        <p:txBody>
          <a:bodyPr/>
          <a:lstStyle/>
          <a:p>
            <a:fld id="{90B7CE6C-A634-4C34-8C1A-E04C7C38E696}" type="datetimeFigureOut">
              <a:rPr lang="de-DE" smtClean="0"/>
              <a:t>23.12.2021</a:t>
            </a:fld>
            <a:endParaRPr lang="de-DE"/>
          </a:p>
        </p:txBody>
      </p:sp>
      <p:sp>
        <p:nvSpPr>
          <p:cNvPr id="5" name="Fußzeilenplatzhalter 4">
            <a:extLst>
              <a:ext uri="{FF2B5EF4-FFF2-40B4-BE49-F238E27FC236}">
                <a16:creationId xmlns:a16="http://schemas.microsoft.com/office/drawing/2014/main" id="{F98343BF-3B60-4DA4-B43C-DFFDB7DD5E27}"/>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34A95716-5E42-4DF9-9163-32DFB3987144}"/>
              </a:ext>
            </a:extLst>
          </p:cNvPr>
          <p:cNvSpPr>
            <a:spLocks noGrp="1"/>
          </p:cNvSpPr>
          <p:nvPr>
            <p:ph type="sldNum" sz="quarter" idx="12"/>
          </p:nvPr>
        </p:nvSpPr>
        <p:spPr/>
        <p:txBody>
          <a:bodyPr/>
          <a:lstStyle/>
          <a:p>
            <a:fld id="{2C4ED143-EA90-41AA-8C76-823181B48DE1}" type="slidenum">
              <a:rPr lang="de-DE" smtClean="0"/>
              <a:t>‹Nr.›</a:t>
            </a:fld>
            <a:endParaRPr lang="de-DE"/>
          </a:p>
        </p:txBody>
      </p:sp>
    </p:spTree>
    <p:extLst>
      <p:ext uri="{BB962C8B-B14F-4D97-AF65-F5344CB8AC3E}">
        <p14:creationId xmlns:p14="http://schemas.microsoft.com/office/powerpoint/2010/main" val="26067586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BFEBB31D-AE23-43A1-A3F6-F7B443A87C70}"/>
              </a:ext>
            </a:extLst>
          </p:cNvPr>
          <p:cNvSpPr>
            <a:spLocks noGrp="1"/>
          </p:cNvSpPr>
          <p:nvPr>
            <p:ph type="title" orient="vert"/>
          </p:nvPr>
        </p:nvSpPr>
        <p:spPr>
          <a:xfrm>
            <a:off x="8724900" y="365125"/>
            <a:ext cx="2628900" cy="5811838"/>
          </a:xfrm>
        </p:spPr>
        <p:txBody>
          <a:bodyPr vert="eaVert"/>
          <a:lstStyle/>
          <a:p>
            <a:r>
              <a:rPr lang="de-DE"/>
              <a:t>Mastertitelformat bearbeiten</a:t>
            </a:r>
          </a:p>
        </p:txBody>
      </p:sp>
      <p:sp>
        <p:nvSpPr>
          <p:cNvPr id="3" name="Vertikaler Textplatzhalter 2">
            <a:extLst>
              <a:ext uri="{FF2B5EF4-FFF2-40B4-BE49-F238E27FC236}">
                <a16:creationId xmlns:a16="http://schemas.microsoft.com/office/drawing/2014/main" id="{CB4EAACB-5D5E-4121-B682-AD8D1152BBA4}"/>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59188D0E-D9C5-4F2F-9C72-8FB4D9ED3589}"/>
              </a:ext>
            </a:extLst>
          </p:cNvPr>
          <p:cNvSpPr>
            <a:spLocks noGrp="1"/>
          </p:cNvSpPr>
          <p:nvPr>
            <p:ph type="dt" sz="half" idx="10"/>
          </p:nvPr>
        </p:nvSpPr>
        <p:spPr/>
        <p:txBody>
          <a:bodyPr/>
          <a:lstStyle/>
          <a:p>
            <a:fld id="{90B7CE6C-A634-4C34-8C1A-E04C7C38E696}" type="datetimeFigureOut">
              <a:rPr lang="de-DE" smtClean="0"/>
              <a:t>23.12.2021</a:t>
            </a:fld>
            <a:endParaRPr lang="de-DE"/>
          </a:p>
        </p:txBody>
      </p:sp>
      <p:sp>
        <p:nvSpPr>
          <p:cNvPr id="5" name="Fußzeilenplatzhalter 4">
            <a:extLst>
              <a:ext uri="{FF2B5EF4-FFF2-40B4-BE49-F238E27FC236}">
                <a16:creationId xmlns:a16="http://schemas.microsoft.com/office/drawing/2014/main" id="{FF8A7C32-02DD-4839-8CC3-E05450E34C86}"/>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723AF017-DC82-4012-8FA1-E5E5DF758406}"/>
              </a:ext>
            </a:extLst>
          </p:cNvPr>
          <p:cNvSpPr>
            <a:spLocks noGrp="1"/>
          </p:cNvSpPr>
          <p:nvPr>
            <p:ph type="sldNum" sz="quarter" idx="12"/>
          </p:nvPr>
        </p:nvSpPr>
        <p:spPr/>
        <p:txBody>
          <a:bodyPr/>
          <a:lstStyle/>
          <a:p>
            <a:fld id="{2C4ED143-EA90-41AA-8C76-823181B48DE1}" type="slidenum">
              <a:rPr lang="de-DE" smtClean="0"/>
              <a:t>‹Nr.›</a:t>
            </a:fld>
            <a:endParaRPr lang="de-DE"/>
          </a:p>
        </p:txBody>
      </p:sp>
    </p:spTree>
    <p:extLst>
      <p:ext uri="{BB962C8B-B14F-4D97-AF65-F5344CB8AC3E}">
        <p14:creationId xmlns:p14="http://schemas.microsoft.com/office/powerpoint/2010/main" val="32710611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730CA9B-E078-4540-BB95-BCE738E0E8A2}"/>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EF6588E5-A7F6-47CE-AF9F-7CC6E75B77D1}"/>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B0956E5F-5818-4467-A2D6-79BA031CC846}"/>
              </a:ext>
            </a:extLst>
          </p:cNvPr>
          <p:cNvSpPr>
            <a:spLocks noGrp="1"/>
          </p:cNvSpPr>
          <p:nvPr>
            <p:ph type="dt" sz="half" idx="10"/>
          </p:nvPr>
        </p:nvSpPr>
        <p:spPr/>
        <p:txBody>
          <a:bodyPr/>
          <a:lstStyle/>
          <a:p>
            <a:fld id="{90B7CE6C-A634-4C34-8C1A-E04C7C38E696}" type="datetimeFigureOut">
              <a:rPr lang="de-DE" smtClean="0"/>
              <a:t>23.12.2021</a:t>
            </a:fld>
            <a:endParaRPr lang="de-DE"/>
          </a:p>
        </p:txBody>
      </p:sp>
      <p:sp>
        <p:nvSpPr>
          <p:cNvPr id="5" name="Fußzeilenplatzhalter 4">
            <a:extLst>
              <a:ext uri="{FF2B5EF4-FFF2-40B4-BE49-F238E27FC236}">
                <a16:creationId xmlns:a16="http://schemas.microsoft.com/office/drawing/2014/main" id="{4717E28B-0C81-4867-BAF4-431ACB75E3D3}"/>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2D4C929B-E1ED-4FAE-8377-9FB0C639A5E2}"/>
              </a:ext>
            </a:extLst>
          </p:cNvPr>
          <p:cNvSpPr>
            <a:spLocks noGrp="1"/>
          </p:cNvSpPr>
          <p:nvPr>
            <p:ph type="sldNum" sz="quarter" idx="12"/>
          </p:nvPr>
        </p:nvSpPr>
        <p:spPr/>
        <p:txBody>
          <a:bodyPr/>
          <a:lstStyle/>
          <a:p>
            <a:fld id="{2C4ED143-EA90-41AA-8C76-823181B48DE1}" type="slidenum">
              <a:rPr lang="de-DE" smtClean="0"/>
              <a:t>‹Nr.›</a:t>
            </a:fld>
            <a:endParaRPr lang="de-DE"/>
          </a:p>
        </p:txBody>
      </p:sp>
    </p:spTree>
    <p:extLst>
      <p:ext uri="{BB962C8B-B14F-4D97-AF65-F5344CB8AC3E}">
        <p14:creationId xmlns:p14="http://schemas.microsoft.com/office/powerpoint/2010/main" val="20852130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F49A6A4-060C-46A8-8F4D-FCFB89EA10F9}"/>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p>
        </p:txBody>
      </p:sp>
      <p:sp>
        <p:nvSpPr>
          <p:cNvPr id="3" name="Textplatzhalter 2">
            <a:extLst>
              <a:ext uri="{FF2B5EF4-FFF2-40B4-BE49-F238E27FC236}">
                <a16:creationId xmlns:a16="http://schemas.microsoft.com/office/drawing/2014/main" id="{4866DAA7-F34B-40ED-A20C-E63B6D3B474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8CA46D3F-5D9A-4087-9CCC-EC188EA42DF9}"/>
              </a:ext>
            </a:extLst>
          </p:cNvPr>
          <p:cNvSpPr>
            <a:spLocks noGrp="1"/>
          </p:cNvSpPr>
          <p:nvPr>
            <p:ph type="dt" sz="half" idx="10"/>
          </p:nvPr>
        </p:nvSpPr>
        <p:spPr/>
        <p:txBody>
          <a:bodyPr/>
          <a:lstStyle/>
          <a:p>
            <a:fld id="{90B7CE6C-A634-4C34-8C1A-E04C7C38E696}" type="datetimeFigureOut">
              <a:rPr lang="de-DE" smtClean="0"/>
              <a:t>23.12.2021</a:t>
            </a:fld>
            <a:endParaRPr lang="de-DE"/>
          </a:p>
        </p:txBody>
      </p:sp>
      <p:sp>
        <p:nvSpPr>
          <p:cNvPr id="5" name="Fußzeilenplatzhalter 4">
            <a:extLst>
              <a:ext uri="{FF2B5EF4-FFF2-40B4-BE49-F238E27FC236}">
                <a16:creationId xmlns:a16="http://schemas.microsoft.com/office/drawing/2014/main" id="{CD7D31FC-B62C-4066-BDC0-29F79644A41A}"/>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463DB7BE-5C07-46B7-B7C5-BF9781AABF50}"/>
              </a:ext>
            </a:extLst>
          </p:cNvPr>
          <p:cNvSpPr>
            <a:spLocks noGrp="1"/>
          </p:cNvSpPr>
          <p:nvPr>
            <p:ph type="sldNum" sz="quarter" idx="12"/>
          </p:nvPr>
        </p:nvSpPr>
        <p:spPr/>
        <p:txBody>
          <a:bodyPr/>
          <a:lstStyle/>
          <a:p>
            <a:fld id="{2C4ED143-EA90-41AA-8C76-823181B48DE1}" type="slidenum">
              <a:rPr lang="de-DE" smtClean="0"/>
              <a:t>‹Nr.›</a:t>
            </a:fld>
            <a:endParaRPr lang="de-DE"/>
          </a:p>
        </p:txBody>
      </p:sp>
    </p:spTree>
    <p:extLst>
      <p:ext uri="{BB962C8B-B14F-4D97-AF65-F5344CB8AC3E}">
        <p14:creationId xmlns:p14="http://schemas.microsoft.com/office/powerpoint/2010/main" val="12070046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B0B84D3-2867-4C70-AA3C-949EC0E6FCF2}"/>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FCB0DBD7-9DF2-430A-8B93-67698F1E4232}"/>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a:extLst>
              <a:ext uri="{FF2B5EF4-FFF2-40B4-BE49-F238E27FC236}">
                <a16:creationId xmlns:a16="http://schemas.microsoft.com/office/drawing/2014/main" id="{95849A5E-795E-4EA3-801B-45B907FABA7B}"/>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a:extLst>
              <a:ext uri="{FF2B5EF4-FFF2-40B4-BE49-F238E27FC236}">
                <a16:creationId xmlns:a16="http://schemas.microsoft.com/office/drawing/2014/main" id="{D97B82A0-4B2A-40CC-B0ED-32DC0FF1C96C}"/>
              </a:ext>
            </a:extLst>
          </p:cNvPr>
          <p:cNvSpPr>
            <a:spLocks noGrp="1"/>
          </p:cNvSpPr>
          <p:nvPr>
            <p:ph type="dt" sz="half" idx="10"/>
          </p:nvPr>
        </p:nvSpPr>
        <p:spPr/>
        <p:txBody>
          <a:bodyPr/>
          <a:lstStyle/>
          <a:p>
            <a:fld id="{90B7CE6C-A634-4C34-8C1A-E04C7C38E696}" type="datetimeFigureOut">
              <a:rPr lang="de-DE" smtClean="0"/>
              <a:t>23.12.2021</a:t>
            </a:fld>
            <a:endParaRPr lang="de-DE"/>
          </a:p>
        </p:txBody>
      </p:sp>
      <p:sp>
        <p:nvSpPr>
          <p:cNvPr id="6" name="Fußzeilenplatzhalter 5">
            <a:extLst>
              <a:ext uri="{FF2B5EF4-FFF2-40B4-BE49-F238E27FC236}">
                <a16:creationId xmlns:a16="http://schemas.microsoft.com/office/drawing/2014/main" id="{CE8EA16F-1D2E-4C09-B2A8-67BB895DF5DD}"/>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10377525-69EE-4DE9-A2DC-9EEA38B120F1}"/>
              </a:ext>
            </a:extLst>
          </p:cNvPr>
          <p:cNvSpPr>
            <a:spLocks noGrp="1"/>
          </p:cNvSpPr>
          <p:nvPr>
            <p:ph type="sldNum" sz="quarter" idx="12"/>
          </p:nvPr>
        </p:nvSpPr>
        <p:spPr/>
        <p:txBody>
          <a:bodyPr/>
          <a:lstStyle/>
          <a:p>
            <a:fld id="{2C4ED143-EA90-41AA-8C76-823181B48DE1}" type="slidenum">
              <a:rPr lang="de-DE" smtClean="0"/>
              <a:t>‹Nr.›</a:t>
            </a:fld>
            <a:endParaRPr lang="de-DE"/>
          </a:p>
        </p:txBody>
      </p:sp>
    </p:spTree>
    <p:extLst>
      <p:ext uri="{BB962C8B-B14F-4D97-AF65-F5344CB8AC3E}">
        <p14:creationId xmlns:p14="http://schemas.microsoft.com/office/powerpoint/2010/main" val="26728489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7F49D36-A10A-4E5F-B1FC-89646FDD11BF}"/>
              </a:ext>
            </a:extLst>
          </p:cNvPr>
          <p:cNvSpPr>
            <a:spLocks noGrp="1"/>
          </p:cNvSpPr>
          <p:nvPr>
            <p:ph type="title"/>
          </p:nvPr>
        </p:nvSpPr>
        <p:spPr>
          <a:xfrm>
            <a:off x="839788" y="365125"/>
            <a:ext cx="10515600" cy="1325563"/>
          </a:xfrm>
        </p:spPr>
        <p:txBody>
          <a:bodyPr/>
          <a:lstStyle/>
          <a:p>
            <a:r>
              <a:rPr lang="de-DE"/>
              <a:t>Mastertitelformat bearbeiten</a:t>
            </a:r>
          </a:p>
        </p:txBody>
      </p:sp>
      <p:sp>
        <p:nvSpPr>
          <p:cNvPr id="3" name="Textplatzhalter 2">
            <a:extLst>
              <a:ext uri="{FF2B5EF4-FFF2-40B4-BE49-F238E27FC236}">
                <a16:creationId xmlns:a16="http://schemas.microsoft.com/office/drawing/2014/main" id="{3BA40D6B-B05F-4FC4-ADE9-551F57B9872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AF5919CB-F603-44AD-B0D9-EEEB752B08D6}"/>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a:extLst>
              <a:ext uri="{FF2B5EF4-FFF2-40B4-BE49-F238E27FC236}">
                <a16:creationId xmlns:a16="http://schemas.microsoft.com/office/drawing/2014/main" id="{83EA0D29-B7FF-4C97-9D88-EC0DB905F18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BDC77816-0A25-46D4-BF56-B6F0D9A48DD8}"/>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a:extLst>
              <a:ext uri="{FF2B5EF4-FFF2-40B4-BE49-F238E27FC236}">
                <a16:creationId xmlns:a16="http://schemas.microsoft.com/office/drawing/2014/main" id="{F5E4B3C9-4012-48A7-B280-68647A7E8207}"/>
              </a:ext>
            </a:extLst>
          </p:cNvPr>
          <p:cNvSpPr>
            <a:spLocks noGrp="1"/>
          </p:cNvSpPr>
          <p:nvPr>
            <p:ph type="dt" sz="half" idx="10"/>
          </p:nvPr>
        </p:nvSpPr>
        <p:spPr/>
        <p:txBody>
          <a:bodyPr/>
          <a:lstStyle/>
          <a:p>
            <a:fld id="{90B7CE6C-A634-4C34-8C1A-E04C7C38E696}" type="datetimeFigureOut">
              <a:rPr lang="de-DE" smtClean="0"/>
              <a:t>23.12.2021</a:t>
            </a:fld>
            <a:endParaRPr lang="de-DE"/>
          </a:p>
        </p:txBody>
      </p:sp>
      <p:sp>
        <p:nvSpPr>
          <p:cNvPr id="8" name="Fußzeilenplatzhalter 7">
            <a:extLst>
              <a:ext uri="{FF2B5EF4-FFF2-40B4-BE49-F238E27FC236}">
                <a16:creationId xmlns:a16="http://schemas.microsoft.com/office/drawing/2014/main" id="{C5A6E945-8F19-4947-87D0-E7FEA25CCA15}"/>
              </a:ext>
            </a:extLst>
          </p:cNvPr>
          <p:cNvSpPr>
            <a:spLocks noGrp="1"/>
          </p:cNvSpPr>
          <p:nvPr>
            <p:ph type="ftr" sz="quarter" idx="11"/>
          </p:nvPr>
        </p:nvSpPr>
        <p:spPr/>
        <p:txBody>
          <a:bodyPr/>
          <a:lstStyle/>
          <a:p>
            <a:endParaRPr lang="de-DE"/>
          </a:p>
        </p:txBody>
      </p:sp>
      <p:sp>
        <p:nvSpPr>
          <p:cNvPr id="9" name="Foliennummernplatzhalter 8">
            <a:extLst>
              <a:ext uri="{FF2B5EF4-FFF2-40B4-BE49-F238E27FC236}">
                <a16:creationId xmlns:a16="http://schemas.microsoft.com/office/drawing/2014/main" id="{8243C466-A1C7-41E9-A7AA-3AA837DCD057}"/>
              </a:ext>
            </a:extLst>
          </p:cNvPr>
          <p:cNvSpPr>
            <a:spLocks noGrp="1"/>
          </p:cNvSpPr>
          <p:nvPr>
            <p:ph type="sldNum" sz="quarter" idx="12"/>
          </p:nvPr>
        </p:nvSpPr>
        <p:spPr/>
        <p:txBody>
          <a:bodyPr/>
          <a:lstStyle/>
          <a:p>
            <a:fld id="{2C4ED143-EA90-41AA-8C76-823181B48DE1}" type="slidenum">
              <a:rPr lang="de-DE" smtClean="0"/>
              <a:t>‹Nr.›</a:t>
            </a:fld>
            <a:endParaRPr lang="de-DE"/>
          </a:p>
        </p:txBody>
      </p:sp>
    </p:spTree>
    <p:extLst>
      <p:ext uri="{BB962C8B-B14F-4D97-AF65-F5344CB8AC3E}">
        <p14:creationId xmlns:p14="http://schemas.microsoft.com/office/powerpoint/2010/main" val="33023526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3F4F68F-8675-4C87-B78D-E42D091795B7}"/>
              </a:ext>
            </a:extLst>
          </p:cNvPr>
          <p:cNvSpPr>
            <a:spLocks noGrp="1"/>
          </p:cNvSpPr>
          <p:nvPr>
            <p:ph type="title"/>
          </p:nvPr>
        </p:nvSpPr>
        <p:spPr/>
        <p:txBody>
          <a:bodyPr/>
          <a:lstStyle/>
          <a:p>
            <a:r>
              <a:rPr lang="de-DE"/>
              <a:t>Mastertitelformat bearbeiten</a:t>
            </a:r>
          </a:p>
        </p:txBody>
      </p:sp>
      <p:sp>
        <p:nvSpPr>
          <p:cNvPr id="3" name="Datumsplatzhalter 2">
            <a:extLst>
              <a:ext uri="{FF2B5EF4-FFF2-40B4-BE49-F238E27FC236}">
                <a16:creationId xmlns:a16="http://schemas.microsoft.com/office/drawing/2014/main" id="{C7559334-6FB9-4446-8C16-7F49A6097036}"/>
              </a:ext>
            </a:extLst>
          </p:cNvPr>
          <p:cNvSpPr>
            <a:spLocks noGrp="1"/>
          </p:cNvSpPr>
          <p:nvPr>
            <p:ph type="dt" sz="half" idx="10"/>
          </p:nvPr>
        </p:nvSpPr>
        <p:spPr/>
        <p:txBody>
          <a:bodyPr/>
          <a:lstStyle/>
          <a:p>
            <a:fld id="{90B7CE6C-A634-4C34-8C1A-E04C7C38E696}" type="datetimeFigureOut">
              <a:rPr lang="de-DE" smtClean="0"/>
              <a:t>23.12.2021</a:t>
            </a:fld>
            <a:endParaRPr lang="de-DE"/>
          </a:p>
        </p:txBody>
      </p:sp>
      <p:sp>
        <p:nvSpPr>
          <p:cNvPr id="4" name="Fußzeilenplatzhalter 3">
            <a:extLst>
              <a:ext uri="{FF2B5EF4-FFF2-40B4-BE49-F238E27FC236}">
                <a16:creationId xmlns:a16="http://schemas.microsoft.com/office/drawing/2014/main" id="{1E30186C-1C8C-4FAA-A503-DE7CE5919BD5}"/>
              </a:ext>
            </a:extLst>
          </p:cNvPr>
          <p:cNvSpPr>
            <a:spLocks noGrp="1"/>
          </p:cNvSpPr>
          <p:nvPr>
            <p:ph type="ftr" sz="quarter" idx="11"/>
          </p:nvPr>
        </p:nvSpPr>
        <p:spPr/>
        <p:txBody>
          <a:bodyPr/>
          <a:lstStyle/>
          <a:p>
            <a:endParaRPr lang="de-DE"/>
          </a:p>
        </p:txBody>
      </p:sp>
      <p:sp>
        <p:nvSpPr>
          <p:cNvPr id="5" name="Foliennummernplatzhalter 4">
            <a:extLst>
              <a:ext uri="{FF2B5EF4-FFF2-40B4-BE49-F238E27FC236}">
                <a16:creationId xmlns:a16="http://schemas.microsoft.com/office/drawing/2014/main" id="{19C5F03A-8ACD-48CE-B718-06DF464B7112}"/>
              </a:ext>
            </a:extLst>
          </p:cNvPr>
          <p:cNvSpPr>
            <a:spLocks noGrp="1"/>
          </p:cNvSpPr>
          <p:nvPr>
            <p:ph type="sldNum" sz="quarter" idx="12"/>
          </p:nvPr>
        </p:nvSpPr>
        <p:spPr/>
        <p:txBody>
          <a:bodyPr/>
          <a:lstStyle/>
          <a:p>
            <a:fld id="{2C4ED143-EA90-41AA-8C76-823181B48DE1}" type="slidenum">
              <a:rPr lang="de-DE" smtClean="0"/>
              <a:t>‹Nr.›</a:t>
            </a:fld>
            <a:endParaRPr lang="de-DE"/>
          </a:p>
        </p:txBody>
      </p:sp>
    </p:spTree>
    <p:extLst>
      <p:ext uri="{BB962C8B-B14F-4D97-AF65-F5344CB8AC3E}">
        <p14:creationId xmlns:p14="http://schemas.microsoft.com/office/powerpoint/2010/main" val="32498440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8C8526FA-37FB-44C2-8756-68F90C9D87D6}"/>
              </a:ext>
            </a:extLst>
          </p:cNvPr>
          <p:cNvSpPr>
            <a:spLocks noGrp="1"/>
          </p:cNvSpPr>
          <p:nvPr>
            <p:ph type="dt" sz="half" idx="10"/>
          </p:nvPr>
        </p:nvSpPr>
        <p:spPr/>
        <p:txBody>
          <a:bodyPr/>
          <a:lstStyle/>
          <a:p>
            <a:fld id="{90B7CE6C-A634-4C34-8C1A-E04C7C38E696}" type="datetimeFigureOut">
              <a:rPr lang="de-DE" smtClean="0"/>
              <a:t>23.12.2021</a:t>
            </a:fld>
            <a:endParaRPr lang="de-DE"/>
          </a:p>
        </p:txBody>
      </p:sp>
      <p:sp>
        <p:nvSpPr>
          <p:cNvPr id="3" name="Fußzeilenplatzhalter 2">
            <a:extLst>
              <a:ext uri="{FF2B5EF4-FFF2-40B4-BE49-F238E27FC236}">
                <a16:creationId xmlns:a16="http://schemas.microsoft.com/office/drawing/2014/main" id="{0D6BAF06-4DAB-45DB-A292-226C5F52F275}"/>
              </a:ext>
            </a:extLst>
          </p:cNvPr>
          <p:cNvSpPr>
            <a:spLocks noGrp="1"/>
          </p:cNvSpPr>
          <p:nvPr>
            <p:ph type="ftr" sz="quarter" idx="11"/>
          </p:nvPr>
        </p:nvSpPr>
        <p:spPr/>
        <p:txBody>
          <a:bodyPr/>
          <a:lstStyle/>
          <a:p>
            <a:endParaRPr lang="de-DE"/>
          </a:p>
        </p:txBody>
      </p:sp>
      <p:sp>
        <p:nvSpPr>
          <p:cNvPr id="4" name="Foliennummernplatzhalter 3">
            <a:extLst>
              <a:ext uri="{FF2B5EF4-FFF2-40B4-BE49-F238E27FC236}">
                <a16:creationId xmlns:a16="http://schemas.microsoft.com/office/drawing/2014/main" id="{4E33D3BF-1854-4A61-9AB1-4CD1735CB1CD}"/>
              </a:ext>
            </a:extLst>
          </p:cNvPr>
          <p:cNvSpPr>
            <a:spLocks noGrp="1"/>
          </p:cNvSpPr>
          <p:nvPr>
            <p:ph type="sldNum" sz="quarter" idx="12"/>
          </p:nvPr>
        </p:nvSpPr>
        <p:spPr/>
        <p:txBody>
          <a:bodyPr/>
          <a:lstStyle/>
          <a:p>
            <a:fld id="{2C4ED143-EA90-41AA-8C76-823181B48DE1}" type="slidenum">
              <a:rPr lang="de-DE" smtClean="0"/>
              <a:t>‹Nr.›</a:t>
            </a:fld>
            <a:endParaRPr lang="de-DE"/>
          </a:p>
        </p:txBody>
      </p:sp>
    </p:spTree>
    <p:extLst>
      <p:ext uri="{BB962C8B-B14F-4D97-AF65-F5344CB8AC3E}">
        <p14:creationId xmlns:p14="http://schemas.microsoft.com/office/powerpoint/2010/main" val="9519448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346F153-9ECF-408C-A055-563689EF6D95}"/>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Inhaltsplatzhalter 2">
            <a:extLst>
              <a:ext uri="{FF2B5EF4-FFF2-40B4-BE49-F238E27FC236}">
                <a16:creationId xmlns:a16="http://schemas.microsoft.com/office/drawing/2014/main" id="{79069C9F-3D86-463B-AD34-47CA7FBD3F9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a:extLst>
              <a:ext uri="{FF2B5EF4-FFF2-40B4-BE49-F238E27FC236}">
                <a16:creationId xmlns:a16="http://schemas.microsoft.com/office/drawing/2014/main" id="{CCF0F166-3B8B-4E14-B275-8EFB5C95603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11658B8C-A329-4486-9095-53B23CD0C240}"/>
              </a:ext>
            </a:extLst>
          </p:cNvPr>
          <p:cNvSpPr>
            <a:spLocks noGrp="1"/>
          </p:cNvSpPr>
          <p:nvPr>
            <p:ph type="dt" sz="half" idx="10"/>
          </p:nvPr>
        </p:nvSpPr>
        <p:spPr/>
        <p:txBody>
          <a:bodyPr/>
          <a:lstStyle/>
          <a:p>
            <a:fld id="{90B7CE6C-A634-4C34-8C1A-E04C7C38E696}" type="datetimeFigureOut">
              <a:rPr lang="de-DE" smtClean="0"/>
              <a:t>23.12.2021</a:t>
            </a:fld>
            <a:endParaRPr lang="de-DE"/>
          </a:p>
        </p:txBody>
      </p:sp>
      <p:sp>
        <p:nvSpPr>
          <p:cNvPr id="6" name="Fußzeilenplatzhalter 5">
            <a:extLst>
              <a:ext uri="{FF2B5EF4-FFF2-40B4-BE49-F238E27FC236}">
                <a16:creationId xmlns:a16="http://schemas.microsoft.com/office/drawing/2014/main" id="{A4CAA420-7F49-4A4A-B2F2-E5DA463709FC}"/>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DAC5A91D-66B6-4933-ABB4-0D1D6642D6FD}"/>
              </a:ext>
            </a:extLst>
          </p:cNvPr>
          <p:cNvSpPr>
            <a:spLocks noGrp="1"/>
          </p:cNvSpPr>
          <p:nvPr>
            <p:ph type="sldNum" sz="quarter" idx="12"/>
          </p:nvPr>
        </p:nvSpPr>
        <p:spPr/>
        <p:txBody>
          <a:bodyPr/>
          <a:lstStyle/>
          <a:p>
            <a:fld id="{2C4ED143-EA90-41AA-8C76-823181B48DE1}" type="slidenum">
              <a:rPr lang="de-DE" smtClean="0"/>
              <a:t>‹Nr.›</a:t>
            </a:fld>
            <a:endParaRPr lang="de-DE"/>
          </a:p>
        </p:txBody>
      </p:sp>
    </p:spTree>
    <p:extLst>
      <p:ext uri="{BB962C8B-B14F-4D97-AF65-F5344CB8AC3E}">
        <p14:creationId xmlns:p14="http://schemas.microsoft.com/office/powerpoint/2010/main" val="15292641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C2F2973-D145-4F51-809A-4A6131A91C5C}"/>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Bildplatzhalter 2">
            <a:extLst>
              <a:ext uri="{FF2B5EF4-FFF2-40B4-BE49-F238E27FC236}">
                <a16:creationId xmlns:a16="http://schemas.microsoft.com/office/drawing/2014/main" id="{F28CAD9A-3332-4051-83A2-B872E7588D0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a:extLst>
              <a:ext uri="{FF2B5EF4-FFF2-40B4-BE49-F238E27FC236}">
                <a16:creationId xmlns:a16="http://schemas.microsoft.com/office/drawing/2014/main" id="{09975850-B70A-4DBF-9207-A47E29AA9E3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F9331287-6C97-47A0-8671-8AEF2C82BA95}"/>
              </a:ext>
            </a:extLst>
          </p:cNvPr>
          <p:cNvSpPr>
            <a:spLocks noGrp="1"/>
          </p:cNvSpPr>
          <p:nvPr>
            <p:ph type="dt" sz="half" idx="10"/>
          </p:nvPr>
        </p:nvSpPr>
        <p:spPr/>
        <p:txBody>
          <a:bodyPr/>
          <a:lstStyle/>
          <a:p>
            <a:fld id="{90B7CE6C-A634-4C34-8C1A-E04C7C38E696}" type="datetimeFigureOut">
              <a:rPr lang="de-DE" smtClean="0"/>
              <a:t>23.12.2021</a:t>
            </a:fld>
            <a:endParaRPr lang="de-DE"/>
          </a:p>
        </p:txBody>
      </p:sp>
      <p:sp>
        <p:nvSpPr>
          <p:cNvPr id="6" name="Fußzeilenplatzhalter 5">
            <a:extLst>
              <a:ext uri="{FF2B5EF4-FFF2-40B4-BE49-F238E27FC236}">
                <a16:creationId xmlns:a16="http://schemas.microsoft.com/office/drawing/2014/main" id="{9A2DACD2-8177-4D24-ABB1-E5ECC78DC62E}"/>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04F93BB3-E3F8-465E-8E46-76AB29560B38}"/>
              </a:ext>
            </a:extLst>
          </p:cNvPr>
          <p:cNvSpPr>
            <a:spLocks noGrp="1"/>
          </p:cNvSpPr>
          <p:nvPr>
            <p:ph type="sldNum" sz="quarter" idx="12"/>
          </p:nvPr>
        </p:nvSpPr>
        <p:spPr/>
        <p:txBody>
          <a:bodyPr/>
          <a:lstStyle/>
          <a:p>
            <a:fld id="{2C4ED143-EA90-41AA-8C76-823181B48DE1}" type="slidenum">
              <a:rPr lang="de-DE" smtClean="0"/>
              <a:t>‹Nr.›</a:t>
            </a:fld>
            <a:endParaRPr lang="de-DE"/>
          </a:p>
        </p:txBody>
      </p:sp>
    </p:spTree>
    <p:extLst>
      <p:ext uri="{BB962C8B-B14F-4D97-AF65-F5344CB8AC3E}">
        <p14:creationId xmlns:p14="http://schemas.microsoft.com/office/powerpoint/2010/main" val="28155421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05C60D97-5D3A-4F5D-AB15-31F59C052F4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p>
        </p:txBody>
      </p:sp>
      <p:sp>
        <p:nvSpPr>
          <p:cNvPr id="3" name="Textplatzhalter 2">
            <a:extLst>
              <a:ext uri="{FF2B5EF4-FFF2-40B4-BE49-F238E27FC236}">
                <a16:creationId xmlns:a16="http://schemas.microsoft.com/office/drawing/2014/main" id="{EB55F2E6-600B-4766-B338-9C88C7114E7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F0114A24-4820-45F7-9A00-87E6ACB82B6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0B7CE6C-A634-4C34-8C1A-E04C7C38E696}" type="datetimeFigureOut">
              <a:rPr lang="de-DE" smtClean="0"/>
              <a:t>23.12.2021</a:t>
            </a:fld>
            <a:endParaRPr lang="de-DE"/>
          </a:p>
        </p:txBody>
      </p:sp>
      <p:sp>
        <p:nvSpPr>
          <p:cNvPr id="5" name="Fußzeilenplatzhalter 4">
            <a:extLst>
              <a:ext uri="{FF2B5EF4-FFF2-40B4-BE49-F238E27FC236}">
                <a16:creationId xmlns:a16="http://schemas.microsoft.com/office/drawing/2014/main" id="{46633A3B-EDCF-4D2B-97B3-C5D4CB543C8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a:extLst>
              <a:ext uri="{FF2B5EF4-FFF2-40B4-BE49-F238E27FC236}">
                <a16:creationId xmlns:a16="http://schemas.microsoft.com/office/drawing/2014/main" id="{6C9DC9A4-D713-4826-844D-A51BF49BFA6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C4ED143-EA90-41AA-8C76-823181B48DE1}" type="slidenum">
              <a:rPr lang="de-DE" smtClean="0"/>
              <a:t>‹Nr.›</a:t>
            </a:fld>
            <a:endParaRPr lang="de-DE"/>
          </a:p>
        </p:txBody>
      </p:sp>
    </p:spTree>
    <p:extLst>
      <p:ext uri="{BB962C8B-B14F-4D97-AF65-F5344CB8AC3E}">
        <p14:creationId xmlns:p14="http://schemas.microsoft.com/office/powerpoint/2010/main" val="6759441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3.png"/><Relationship Id="rId5" Type="http://schemas.microsoft.com/office/2007/relationships/hdphoto" Target="../media/hdphoto2.wdp"/><Relationship Id="rId4" Type="http://schemas.openxmlformats.org/officeDocument/2006/relationships/image" Target="../media/image2.png"/><Relationship Id="rId9" Type="http://schemas.microsoft.com/office/2007/relationships/hdphoto" Target="../media/hdphoto4.wdp"/></Relationships>
</file>

<file path=ppt/slides/_rels/slide2.xml.rels><?xml version="1.0" encoding="UTF-8" standalone="yes"?>
<Relationships xmlns="http://schemas.openxmlformats.org/package/2006/relationships"><Relationship Id="rId8" Type="http://schemas.openxmlformats.org/officeDocument/2006/relationships/image" Target="../media/image9.tiff"/><Relationship Id="rId13" Type="http://schemas.openxmlformats.org/officeDocument/2006/relationships/image" Target="../media/image12.tiff"/><Relationship Id="rId18" Type="http://schemas.microsoft.com/office/2007/relationships/hdphoto" Target="../media/hdphoto10.wdp"/><Relationship Id="rId3" Type="http://schemas.openxmlformats.org/officeDocument/2006/relationships/image" Target="../media/image6.png"/><Relationship Id="rId21" Type="http://schemas.openxmlformats.org/officeDocument/2006/relationships/image" Target="../media/image17.png"/><Relationship Id="rId7" Type="http://schemas.openxmlformats.org/officeDocument/2006/relationships/image" Target="../media/image8.tiff"/><Relationship Id="rId12" Type="http://schemas.microsoft.com/office/2007/relationships/hdphoto" Target="../media/hdphoto8.wdp"/><Relationship Id="rId17" Type="http://schemas.openxmlformats.org/officeDocument/2006/relationships/image" Target="../media/image15.png"/><Relationship Id="rId2" Type="http://schemas.openxmlformats.org/officeDocument/2006/relationships/slideLayout" Target="../slideLayouts/slideLayout2.xml"/><Relationship Id="rId16" Type="http://schemas.microsoft.com/office/2007/relationships/hdphoto" Target="../media/hdphoto9.wdp"/><Relationship Id="rId20" Type="http://schemas.microsoft.com/office/2007/relationships/hdphoto" Target="../media/hdphoto11.wdp"/><Relationship Id="rId1" Type="http://schemas.openxmlformats.org/officeDocument/2006/relationships/vmlDrawing" Target="../drawings/vmlDrawing1.vml"/><Relationship Id="rId6" Type="http://schemas.microsoft.com/office/2007/relationships/hdphoto" Target="../media/hdphoto6.wdp"/><Relationship Id="rId11" Type="http://schemas.openxmlformats.org/officeDocument/2006/relationships/image" Target="../media/image11.png"/><Relationship Id="rId24" Type="http://schemas.openxmlformats.org/officeDocument/2006/relationships/image" Target="../media/image5.emf"/><Relationship Id="rId5" Type="http://schemas.openxmlformats.org/officeDocument/2006/relationships/image" Target="../media/image7.png"/><Relationship Id="rId15" Type="http://schemas.openxmlformats.org/officeDocument/2006/relationships/image" Target="../media/image14.png"/><Relationship Id="rId23" Type="http://schemas.openxmlformats.org/officeDocument/2006/relationships/oleObject" Target="../embeddings/oleObject1.bin"/><Relationship Id="rId10" Type="http://schemas.microsoft.com/office/2007/relationships/hdphoto" Target="../media/hdphoto7.wdp"/><Relationship Id="rId19" Type="http://schemas.openxmlformats.org/officeDocument/2006/relationships/image" Target="../media/image16.png"/><Relationship Id="rId4" Type="http://schemas.microsoft.com/office/2007/relationships/hdphoto" Target="../media/hdphoto5.wdp"/><Relationship Id="rId9" Type="http://schemas.openxmlformats.org/officeDocument/2006/relationships/image" Target="../media/image10.png"/><Relationship Id="rId14" Type="http://schemas.openxmlformats.org/officeDocument/2006/relationships/image" Target="../media/image13.tiff"/><Relationship Id="rId22" Type="http://schemas.microsoft.com/office/2007/relationships/hdphoto" Target="../media/hdphoto12.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el 1">
            <a:extLst>
              <a:ext uri="{FF2B5EF4-FFF2-40B4-BE49-F238E27FC236}">
                <a16:creationId xmlns:a16="http://schemas.microsoft.com/office/drawing/2014/main" id="{AA9F0C41-3999-439E-9CC3-802E8567A594}"/>
              </a:ext>
            </a:extLst>
          </p:cNvPr>
          <p:cNvSpPr txBox="1">
            <a:spLocks/>
          </p:cNvSpPr>
          <p:nvPr/>
        </p:nvSpPr>
        <p:spPr>
          <a:xfrm>
            <a:off x="5876527" y="355300"/>
            <a:ext cx="2678375" cy="342232"/>
          </a:xfrm>
          <a:prstGeom prst="rect">
            <a:avLst/>
          </a:prstGeom>
        </p:spPr>
        <p:txBody>
          <a:bodyPr vert="horz" lIns="51435" tIns="25718" rIns="51435" bIns="25718"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de-DE" sz="1600" b="1" dirty="0">
                <a:latin typeface="Times New Roman" panose="02020603050405020304" pitchFamily="18" charset="0"/>
                <a:cs typeface="Times New Roman" panose="02020603050405020304" pitchFamily="18" charset="0"/>
              </a:rPr>
              <a:t>MMP</a:t>
            </a:r>
          </a:p>
          <a:p>
            <a:r>
              <a:rPr lang="de-DE" sz="1600" b="1" dirty="0">
                <a:latin typeface="Times New Roman" panose="02020603050405020304" pitchFamily="18" charset="0"/>
                <a:cs typeface="Times New Roman" panose="02020603050405020304" pitchFamily="18" charset="0"/>
              </a:rPr>
              <a:t>Anti-Lama3 </a:t>
            </a:r>
            <a:r>
              <a:rPr lang="de-DE" sz="1600" b="1" dirty="0" err="1">
                <a:latin typeface="Times New Roman" panose="02020603050405020304" pitchFamily="18" charset="0"/>
                <a:cs typeface="Times New Roman" panose="02020603050405020304" pitchFamily="18" charset="0"/>
              </a:rPr>
              <a:t>IgG</a:t>
            </a:r>
            <a:endParaRPr lang="de-DE" sz="1600" b="1" dirty="0">
              <a:latin typeface="Times New Roman" panose="02020603050405020304" pitchFamily="18" charset="0"/>
              <a:cs typeface="Times New Roman" panose="02020603050405020304" pitchFamily="18" charset="0"/>
            </a:endParaRPr>
          </a:p>
        </p:txBody>
      </p:sp>
      <p:sp>
        <p:nvSpPr>
          <p:cNvPr id="7" name="Titel 1">
            <a:extLst>
              <a:ext uri="{FF2B5EF4-FFF2-40B4-BE49-F238E27FC236}">
                <a16:creationId xmlns:a16="http://schemas.microsoft.com/office/drawing/2014/main" id="{A374A980-C4AB-4E7B-A1DF-1574BDC70DA9}"/>
              </a:ext>
            </a:extLst>
          </p:cNvPr>
          <p:cNvSpPr txBox="1">
            <a:spLocks/>
          </p:cNvSpPr>
          <p:nvPr/>
        </p:nvSpPr>
        <p:spPr>
          <a:xfrm>
            <a:off x="3125740" y="349384"/>
            <a:ext cx="2674587" cy="342232"/>
          </a:xfrm>
          <a:prstGeom prst="rect">
            <a:avLst/>
          </a:prstGeom>
        </p:spPr>
        <p:txBody>
          <a:bodyPr vert="horz" lIns="51435" tIns="25718" rIns="51435" bIns="25718"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de-DE" sz="1600" b="1" dirty="0">
                <a:latin typeface="Times New Roman" panose="02020603050405020304" pitchFamily="18" charset="0"/>
                <a:cs typeface="Times New Roman" panose="02020603050405020304" pitchFamily="18" charset="0"/>
              </a:rPr>
              <a:t>Control</a:t>
            </a:r>
          </a:p>
          <a:p>
            <a:r>
              <a:rPr lang="de-DE" sz="1600" b="1" dirty="0">
                <a:latin typeface="Times New Roman" panose="02020603050405020304" pitchFamily="18" charset="0"/>
                <a:cs typeface="Times New Roman" panose="02020603050405020304" pitchFamily="18" charset="0"/>
              </a:rPr>
              <a:t>Normal </a:t>
            </a:r>
            <a:r>
              <a:rPr lang="de-DE" sz="1600" b="1" dirty="0" err="1">
                <a:latin typeface="Times New Roman" panose="02020603050405020304" pitchFamily="18" charset="0"/>
                <a:cs typeface="Times New Roman" panose="02020603050405020304" pitchFamily="18" charset="0"/>
              </a:rPr>
              <a:t>rabbit</a:t>
            </a:r>
            <a:r>
              <a:rPr lang="de-DE" sz="1600" b="1" dirty="0">
                <a:latin typeface="Times New Roman" panose="02020603050405020304" pitchFamily="18" charset="0"/>
                <a:cs typeface="Times New Roman" panose="02020603050405020304" pitchFamily="18" charset="0"/>
              </a:rPr>
              <a:t> </a:t>
            </a:r>
            <a:r>
              <a:rPr lang="de-DE" sz="1600" b="1" dirty="0" err="1">
                <a:latin typeface="Times New Roman" panose="02020603050405020304" pitchFamily="18" charset="0"/>
                <a:cs typeface="Times New Roman" panose="02020603050405020304" pitchFamily="18" charset="0"/>
              </a:rPr>
              <a:t>IgG</a:t>
            </a:r>
            <a:endParaRPr lang="de-DE" sz="1400" b="1" dirty="0">
              <a:latin typeface="Times New Roman" panose="02020603050405020304" pitchFamily="18" charset="0"/>
              <a:cs typeface="Times New Roman" panose="02020603050405020304" pitchFamily="18" charset="0"/>
            </a:endParaRPr>
          </a:p>
        </p:txBody>
      </p:sp>
      <p:sp>
        <p:nvSpPr>
          <p:cNvPr id="17" name="Titel 1">
            <a:extLst>
              <a:ext uri="{FF2B5EF4-FFF2-40B4-BE49-F238E27FC236}">
                <a16:creationId xmlns:a16="http://schemas.microsoft.com/office/drawing/2014/main" id="{8D1E6A3C-D62E-4D68-BBC6-8DD0CC3FD531}"/>
              </a:ext>
            </a:extLst>
          </p:cNvPr>
          <p:cNvSpPr>
            <a:spLocks noGrp="1"/>
          </p:cNvSpPr>
          <p:nvPr>
            <p:ph type="ctrTitle"/>
          </p:nvPr>
        </p:nvSpPr>
        <p:spPr>
          <a:xfrm rot="16200000">
            <a:off x="1912291" y="1453585"/>
            <a:ext cx="1981336" cy="445567"/>
          </a:xfrm>
        </p:spPr>
        <p:txBody>
          <a:bodyPr>
            <a:noAutofit/>
          </a:bodyPr>
          <a:lstStyle/>
          <a:p>
            <a:r>
              <a:rPr lang="de-DE" sz="1600" b="1" dirty="0" err="1">
                <a:latin typeface="Times New Roman" panose="02020603050405020304" pitchFamily="18" charset="0"/>
                <a:cs typeface="Times New Roman" panose="02020603050405020304" pitchFamily="18" charset="0"/>
              </a:rPr>
              <a:t>Lesional</a:t>
            </a:r>
            <a:r>
              <a:rPr lang="de-DE" sz="1600" b="1" dirty="0">
                <a:latin typeface="Times New Roman" panose="02020603050405020304" pitchFamily="18" charset="0"/>
                <a:cs typeface="Times New Roman" panose="02020603050405020304" pitchFamily="18" charset="0"/>
              </a:rPr>
              <a:t> </a:t>
            </a:r>
            <a:r>
              <a:rPr lang="de-DE" sz="1600" b="1" dirty="0" err="1">
                <a:latin typeface="Times New Roman" panose="02020603050405020304" pitchFamily="18" charset="0"/>
                <a:cs typeface="Times New Roman" panose="02020603050405020304" pitchFamily="18" charset="0"/>
              </a:rPr>
              <a:t>skin</a:t>
            </a:r>
            <a:endParaRPr lang="de-DE" sz="1600" b="1" dirty="0">
              <a:latin typeface="Times New Roman" panose="02020603050405020304" pitchFamily="18" charset="0"/>
              <a:cs typeface="Times New Roman" panose="02020603050405020304" pitchFamily="18" charset="0"/>
            </a:endParaRPr>
          </a:p>
        </p:txBody>
      </p:sp>
      <p:pic>
        <p:nvPicPr>
          <p:cNvPr id="24" name="Grafik 23">
            <a:extLst>
              <a:ext uri="{FF2B5EF4-FFF2-40B4-BE49-F238E27FC236}">
                <a16:creationId xmlns:a16="http://schemas.microsoft.com/office/drawing/2014/main" id="{2D90F1CF-1DC5-45DB-B2E9-CCC02238F880}"/>
              </a:ext>
            </a:extLst>
          </p:cNvPr>
          <p:cNvPicPr>
            <a:picLocks noChangeAspect="1"/>
          </p:cNvPicPr>
          <p:nvPr/>
        </p:nvPicPr>
        <p:blipFill>
          <a:blip r:embed="rId2" cstate="hqprint">
            <a:extLst>
              <a:ext uri="{BEBA8EAE-BF5A-486C-A8C5-ECC9F3942E4B}">
                <a14:imgProps xmlns:a14="http://schemas.microsoft.com/office/drawing/2010/main">
                  <a14:imgLayer r:embed="rId3">
                    <a14:imgEffect>
                      <a14:brightnessContrast bright="3000"/>
                    </a14:imgEffect>
                  </a14:imgLayer>
                </a14:imgProps>
              </a:ext>
              <a:ext uri="{28A0092B-C50C-407E-A947-70E740481C1C}">
                <a14:useLocalDpi xmlns:a14="http://schemas.microsoft.com/office/drawing/2010/main"/>
              </a:ext>
            </a:extLst>
          </a:blip>
          <a:stretch>
            <a:fillRect/>
          </a:stretch>
        </p:blipFill>
        <p:spPr>
          <a:xfrm>
            <a:off x="5927558" y="691616"/>
            <a:ext cx="2678375" cy="2016659"/>
          </a:xfrm>
          <a:prstGeom prst="rect">
            <a:avLst/>
          </a:prstGeom>
          <a:ln w="12700">
            <a:solidFill>
              <a:schemeClr val="tx1"/>
            </a:solidFill>
          </a:ln>
        </p:spPr>
      </p:pic>
      <p:pic>
        <p:nvPicPr>
          <p:cNvPr id="51" name="Grafik 50">
            <a:extLst>
              <a:ext uri="{FF2B5EF4-FFF2-40B4-BE49-F238E27FC236}">
                <a16:creationId xmlns:a16="http://schemas.microsoft.com/office/drawing/2014/main" id="{9CF108E8-4619-491C-8DAC-98932B9DE353}"/>
              </a:ext>
            </a:extLst>
          </p:cNvPr>
          <p:cNvPicPr>
            <a:picLocks noChangeAspect="1"/>
          </p:cNvPicPr>
          <p:nvPr/>
        </p:nvPicPr>
        <p:blipFill>
          <a:blip r:embed="rId4" cstate="hqprint">
            <a:extLst>
              <a:ext uri="{BEBA8EAE-BF5A-486C-A8C5-ECC9F3942E4B}">
                <a14:imgProps xmlns:a14="http://schemas.microsoft.com/office/drawing/2010/main">
                  <a14:imgLayer r:embed="rId5">
                    <a14:imgEffect>
                      <a14:brightnessContrast bright="4000"/>
                    </a14:imgEffect>
                  </a14:imgLayer>
                </a14:imgProps>
              </a:ext>
              <a:ext uri="{28A0092B-C50C-407E-A947-70E740481C1C}">
                <a14:useLocalDpi xmlns:a14="http://schemas.microsoft.com/office/drawing/2010/main"/>
              </a:ext>
            </a:extLst>
          </a:blip>
          <a:stretch>
            <a:fillRect/>
          </a:stretch>
        </p:blipFill>
        <p:spPr>
          <a:xfrm>
            <a:off x="5905714" y="2819436"/>
            <a:ext cx="2677500" cy="2016000"/>
          </a:xfrm>
          <a:prstGeom prst="rect">
            <a:avLst/>
          </a:prstGeom>
          <a:ln w="12700">
            <a:solidFill>
              <a:schemeClr val="tx1"/>
            </a:solidFill>
          </a:ln>
        </p:spPr>
      </p:pic>
      <p:pic>
        <p:nvPicPr>
          <p:cNvPr id="53" name="Grafik 52">
            <a:extLst>
              <a:ext uri="{FF2B5EF4-FFF2-40B4-BE49-F238E27FC236}">
                <a16:creationId xmlns:a16="http://schemas.microsoft.com/office/drawing/2014/main" id="{15FB4D94-5B62-49E0-BCBD-1E283B067756}"/>
              </a:ext>
            </a:extLst>
          </p:cNvPr>
          <p:cNvPicPr>
            <a:picLocks noChangeAspect="1"/>
          </p:cNvPicPr>
          <p:nvPr/>
        </p:nvPicPr>
        <p:blipFill>
          <a:blip r:embed="rId6" cstate="hqprint">
            <a:extLst>
              <a:ext uri="{BEBA8EAE-BF5A-486C-A8C5-ECC9F3942E4B}">
                <a14:imgProps xmlns:a14="http://schemas.microsoft.com/office/drawing/2010/main">
                  <a14:imgLayer r:embed="rId7">
                    <a14:imgEffect>
                      <a14:brightnessContrast bright="5000"/>
                    </a14:imgEffect>
                  </a14:imgLayer>
                </a14:imgProps>
              </a:ext>
              <a:ext uri="{28A0092B-C50C-407E-A947-70E740481C1C}">
                <a14:useLocalDpi xmlns:a14="http://schemas.microsoft.com/office/drawing/2010/main"/>
              </a:ext>
            </a:extLst>
          </a:blip>
          <a:stretch>
            <a:fillRect/>
          </a:stretch>
        </p:blipFill>
        <p:spPr>
          <a:xfrm>
            <a:off x="3125738" y="2819435"/>
            <a:ext cx="2677500" cy="2016000"/>
          </a:xfrm>
          <a:prstGeom prst="rect">
            <a:avLst/>
          </a:prstGeom>
          <a:ln w="12700">
            <a:solidFill>
              <a:schemeClr val="tx1"/>
            </a:solidFill>
          </a:ln>
        </p:spPr>
      </p:pic>
      <p:pic>
        <p:nvPicPr>
          <p:cNvPr id="55" name="Grafik 54">
            <a:extLst>
              <a:ext uri="{FF2B5EF4-FFF2-40B4-BE49-F238E27FC236}">
                <a16:creationId xmlns:a16="http://schemas.microsoft.com/office/drawing/2014/main" id="{482ACD15-29F2-4542-B476-7AAF6CA05A21}"/>
              </a:ext>
            </a:extLst>
          </p:cNvPr>
          <p:cNvPicPr>
            <a:picLocks noChangeAspect="1"/>
          </p:cNvPicPr>
          <p:nvPr/>
        </p:nvPicPr>
        <p:blipFill>
          <a:blip r:embed="rId8" cstate="hqprint">
            <a:extLst>
              <a:ext uri="{BEBA8EAE-BF5A-486C-A8C5-ECC9F3942E4B}">
                <a14:imgProps xmlns:a14="http://schemas.microsoft.com/office/drawing/2010/main">
                  <a14:imgLayer r:embed="rId9">
                    <a14:imgEffect>
                      <a14:brightnessContrast bright="7000"/>
                    </a14:imgEffect>
                  </a14:imgLayer>
                </a14:imgProps>
              </a:ext>
              <a:ext uri="{28A0092B-C50C-407E-A947-70E740481C1C}">
                <a14:useLocalDpi xmlns:a14="http://schemas.microsoft.com/office/drawing/2010/main"/>
              </a:ext>
            </a:extLst>
          </a:blip>
          <a:stretch>
            <a:fillRect/>
          </a:stretch>
        </p:blipFill>
        <p:spPr>
          <a:xfrm>
            <a:off x="3125739" y="691615"/>
            <a:ext cx="2677500" cy="2016000"/>
          </a:xfrm>
          <a:prstGeom prst="rect">
            <a:avLst/>
          </a:prstGeom>
          <a:ln w="12700">
            <a:solidFill>
              <a:schemeClr val="tx1"/>
            </a:solidFill>
          </a:ln>
        </p:spPr>
      </p:pic>
      <p:sp>
        <p:nvSpPr>
          <p:cNvPr id="21" name="Titel 1">
            <a:extLst>
              <a:ext uri="{FF2B5EF4-FFF2-40B4-BE49-F238E27FC236}">
                <a16:creationId xmlns:a16="http://schemas.microsoft.com/office/drawing/2014/main" id="{25D9C5E6-570F-47E0-A297-4F9BB90EE9F3}"/>
              </a:ext>
            </a:extLst>
          </p:cNvPr>
          <p:cNvSpPr txBox="1">
            <a:spLocks/>
          </p:cNvSpPr>
          <p:nvPr/>
        </p:nvSpPr>
        <p:spPr>
          <a:xfrm rot="16200000">
            <a:off x="1899591" y="3574485"/>
            <a:ext cx="1981336" cy="445567"/>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de-DE" sz="1600" b="1" dirty="0" err="1">
                <a:latin typeface="Times New Roman" panose="02020603050405020304" pitchFamily="18" charset="0"/>
                <a:cs typeface="Times New Roman" panose="02020603050405020304" pitchFamily="18" charset="0"/>
              </a:rPr>
              <a:t>Perilesional</a:t>
            </a:r>
            <a:r>
              <a:rPr lang="de-DE" sz="1600" b="1" dirty="0">
                <a:latin typeface="Times New Roman" panose="02020603050405020304" pitchFamily="18" charset="0"/>
                <a:cs typeface="Times New Roman" panose="02020603050405020304" pitchFamily="18" charset="0"/>
              </a:rPr>
              <a:t> </a:t>
            </a:r>
            <a:r>
              <a:rPr lang="de-DE" sz="1600" b="1" dirty="0" err="1">
                <a:latin typeface="Times New Roman" panose="02020603050405020304" pitchFamily="18" charset="0"/>
                <a:cs typeface="Times New Roman" panose="02020603050405020304" pitchFamily="18" charset="0"/>
              </a:rPr>
              <a:t>skin</a:t>
            </a:r>
            <a:endParaRPr lang="de-DE" sz="1600" b="1" dirty="0">
              <a:latin typeface="Times New Roman" panose="02020603050405020304" pitchFamily="18" charset="0"/>
              <a:cs typeface="Times New Roman" panose="02020603050405020304" pitchFamily="18" charset="0"/>
            </a:endParaRPr>
          </a:p>
        </p:txBody>
      </p:sp>
      <p:sp>
        <p:nvSpPr>
          <p:cNvPr id="11" name="Textfeld 10">
            <a:extLst>
              <a:ext uri="{FF2B5EF4-FFF2-40B4-BE49-F238E27FC236}">
                <a16:creationId xmlns:a16="http://schemas.microsoft.com/office/drawing/2014/main" id="{9A7F52BB-6CA1-497D-B0EC-888072EEC13D}"/>
              </a:ext>
            </a:extLst>
          </p:cNvPr>
          <p:cNvSpPr txBox="1"/>
          <p:nvPr/>
        </p:nvSpPr>
        <p:spPr>
          <a:xfrm>
            <a:off x="245101" y="5065090"/>
            <a:ext cx="11663869" cy="1477328"/>
          </a:xfrm>
          <a:prstGeom prst="rect">
            <a:avLst/>
          </a:prstGeom>
          <a:noFill/>
        </p:spPr>
        <p:txBody>
          <a:bodyPr wrap="square">
            <a:spAutoFit/>
          </a:bodyPr>
          <a:lstStyle/>
          <a:p>
            <a:pPr algn="just">
              <a:spcBef>
                <a:spcPts val="600"/>
              </a:spcBef>
              <a:spcAft>
                <a:spcPts val="1200"/>
              </a:spcAft>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Supplemental Figure 1: Mice with mucous membrane pemphigoid (MMP) showed subepithelial split formation and a dense inflammatory infiltrate in skin</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Hematoxylin &amp; eosin staining of skin biopsies obtained on Day 28 showed crust formation, thickened epidermis and separation along the basement membrane zone in lesional skin and inflammatory cell infiltrates in the upper dermis in both lesional and perilesional skin biopsies of MMP mice treated with anti-Lama3 IgG. No histological changes were apparent in control mice treated with normal rabbit IgG. Scale bar = 100 µm.</a:t>
            </a:r>
            <a:endParaRPr lang="en-DE" sz="18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945149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ieren 1">
            <a:extLst>
              <a:ext uri="{FF2B5EF4-FFF2-40B4-BE49-F238E27FC236}">
                <a16:creationId xmlns:a16="http://schemas.microsoft.com/office/drawing/2014/main" id="{BE9AFE0F-AFE8-4866-BEB4-F7F05802A601}"/>
              </a:ext>
            </a:extLst>
          </p:cNvPr>
          <p:cNvGrpSpPr/>
          <p:nvPr/>
        </p:nvGrpSpPr>
        <p:grpSpPr>
          <a:xfrm>
            <a:off x="709505" y="84342"/>
            <a:ext cx="8518633" cy="5046718"/>
            <a:chOff x="368693" y="-73665"/>
            <a:chExt cx="11640451" cy="6942816"/>
          </a:xfrm>
        </p:grpSpPr>
        <p:sp>
          <p:nvSpPr>
            <p:cNvPr id="6" name="Titel 1">
              <a:extLst>
                <a:ext uri="{FF2B5EF4-FFF2-40B4-BE49-F238E27FC236}">
                  <a16:creationId xmlns:a16="http://schemas.microsoft.com/office/drawing/2014/main" id="{09214636-D271-4F9A-815D-8B5152B1B75F}"/>
                </a:ext>
              </a:extLst>
            </p:cNvPr>
            <p:cNvSpPr txBox="1">
              <a:spLocks/>
            </p:cNvSpPr>
            <p:nvPr/>
          </p:nvSpPr>
          <p:spPr>
            <a:xfrm rot="16200000">
              <a:off x="-464212" y="1474502"/>
              <a:ext cx="2016660" cy="342956"/>
            </a:xfrm>
            <a:prstGeom prst="rect">
              <a:avLst/>
            </a:prstGeom>
          </p:spPr>
          <p:txBody>
            <a:bodyPr vert="horz" lIns="51435" tIns="25718" rIns="51435" bIns="25718"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de-DE" sz="1400" b="1" dirty="0">
                  <a:latin typeface="Times New Roman" panose="02020603050405020304" pitchFamily="18" charset="0"/>
                  <a:cs typeface="Times New Roman" panose="02020603050405020304" pitchFamily="18" charset="0"/>
                </a:rPr>
                <a:t>F4/80</a:t>
              </a:r>
            </a:p>
          </p:txBody>
        </p:sp>
        <p:sp>
          <p:nvSpPr>
            <p:cNvPr id="7" name="Titel 1">
              <a:extLst>
                <a:ext uri="{FF2B5EF4-FFF2-40B4-BE49-F238E27FC236}">
                  <a16:creationId xmlns:a16="http://schemas.microsoft.com/office/drawing/2014/main" id="{78210979-1E58-44A1-B1BB-4FEE5F97C018}"/>
                </a:ext>
              </a:extLst>
            </p:cNvPr>
            <p:cNvSpPr txBox="1">
              <a:spLocks/>
            </p:cNvSpPr>
            <p:nvPr/>
          </p:nvSpPr>
          <p:spPr>
            <a:xfrm rot="16200000">
              <a:off x="-466448" y="3538158"/>
              <a:ext cx="2016662" cy="346380"/>
            </a:xfrm>
            <a:prstGeom prst="rect">
              <a:avLst/>
            </a:prstGeom>
          </p:spPr>
          <p:txBody>
            <a:bodyPr vert="horz" lIns="51435" tIns="25718" rIns="51435" bIns="25718"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de-DE" sz="1400" b="1" dirty="0">
                  <a:latin typeface="Times New Roman" panose="02020603050405020304" pitchFamily="18" charset="0"/>
                  <a:cs typeface="Times New Roman" panose="02020603050405020304" pitchFamily="18" charset="0"/>
                </a:rPr>
                <a:t>CD11c</a:t>
              </a:r>
            </a:p>
          </p:txBody>
        </p:sp>
        <p:sp>
          <p:nvSpPr>
            <p:cNvPr id="8" name="Titel 1">
              <a:extLst>
                <a:ext uri="{FF2B5EF4-FFF2-40B4-BE49-F238E27FC236}">
                  <a16:creationId xmlns:a16="http://schemas.microsoft.com/office/drawing/2014/main" id="{C3F6F75A-7FF7-4DC3-B6C6-CB2C2315BB54}"/>
                </a:ext>
              </a:extLst>
            </p:cNvPr>
            <p:cNvSpPr txBox="1">
              <a:spLocks/>
            </p:cNvSpPr>
            <p:nvPr/>
          </p:nvSpPr>
          <p:spPr>
            <a:xfrm>
              <a:off x="689055" y="-61526"/>
              <a:ext cx="5479139" cy="45156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de-DE" sz="1600" b="1" dirty="0">
                  <a:latin typeface="Times New Roman" panose="02020603050405020304" pitchFamily="18" charset="0"/>
                  <a:cs typeface="Times New Roman" panose="02020603050405020304" pitchFamily="18" charset="0"/>
                </a:rPr>
                <a:t>Lesional </a:t>
              </a:r>
              <a:r>
                <a:rPr lang="de-DE" sz="1600" b="1" dirty="0" err="1">
                  <a:latin typeface="Times New Roman" panose="02020603050405020304" pitchFamily="18" charset="0"/>
                  <a:cs typeface="Times New Roman" panose="02020603050405020304" pitchFamily="18" charset="0"/>
                </a:rPr>
                <a:t>skin</a:t>
              </a:r>
              <a:endParaRPr lang="de-DE" sz="1600" b="1" dirty="0">
                <a:latin typeface="Times New Roman" panose="02020603050405020304" pitchFamily="18" charset="0"/>
                <a:cs typeface="Times New Roman" panose="02020603050405020304" pitchFamily="18" charset="0"/>
              </a:endParaRPr>
            </a:p>
          </p:txBody>
        </p:sp>
        <p:sp>
          <p:nvSpPr>
            <p:cNvPr id="14" name="Titel 1">
              <a:extLst>
                <a:ext uri="{FF2B5EF4-FFF2-40B4-BE49-F238E27FC236}">
                  <a16:creationId xmlns:a16="http://schemas.microsoft.com/office/drawing/2014/main" id="{89F67412-F14E-4EDE-8FC8-BA2899086F9A}"/>
                </a:ext>
              </a:extLst>
            </p:cNvPr>
            <p:cNvSpPr txBox="1">
              <a:spLocks/>
            </p:cNvSpPr>
            <p:nvPr/>
          </p:nvSpPr>
          <p:spPr>
            <a:xfrm>
              <a:off x="6566326" y="-73665"/>
              <a:ext cx="5417874" cy="45156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de-DE" sz="1600" b="1" dirty="0" err="1">
                  <a:latin typeface="Times New Roman" panose="02020603050405020304" pitchFamily="18" charset="0"/>
                  <a:cs typeface="Times New Roman" panose="02020603050405020304" pitchFamily="18" charset="0"/>
                </a:rPr>
                <a:t>Perilesional</a:t>
              </a:r>
              <a:r>
                <a:rPr lang="de-DE" sz="1600" b="1" dirty="0">
                  <a:latin typeface="Times New Roman" panose="02020603050405020304" pitchFamily="18" charset="0"/>
                  <a:cs typeface="Times New Roman" panose="02020603050405020304" pitchFamily="18" charset="0"/>
                </a:rPr>
                <a:t> </a:t>
              </a:r>
              <a:r>
                <a:rPr lang="de-DE" sz="1600" b="1" dirty="0" err="1">
                  <a:latin typeface="Times New Roman" panose="02020603050405020304" pitchFamily="18" charset="0"/>
                  <a:cs typeface="Times New Roman" panose="02020603050405020304" pitchFamily="18" charset="0"/>
                </a:rPr>
                <a:t>skin</a:t>
              </a:r>
              <a:endParaRPr lang="de-DE" sz="1600" b="1" dirty="0">
                <a:latin typeface="Times New Roman" panose="02020603050405020304" pitchFamily="18" charset="0"/>
                <a:cs typeface="Times New Roman" panose="02020603050405020304" pitchFamily="18" charset="0"/>
              </a:endParaRPr>
            </a:p>
          </p:txBody>
        </p:sp>
        <p:pic>
          <p:nvPicPr>
            <p:cNvPr id="16" name="Grafik 15">
              <a:extLst>
                <a:ext uri="{FF2B5EF4-FFF2-40B4-BE49-F238E27FC236}">
                  <a16:creationId xmlns:a16="http://schemas.microsoft.com/office/drawing/2014/main" id="{B780F72D-53A2-4FAF-ACE9-53088D5AA5CD}"/>
                </a:ext>
              </a:extLst>
            </p:cNvPr>
            <p:cNvPicPr>
              <a:picLocks noChangeAspect="1"/>
            </p:cNvPicPr>
            <p:nvPr/>
          </p:nvPicPr>
          <p:blipFill>
            <a:blip r:embed="rId3" cstate="hqprint">
              <a:extLst>
                <a:ext uri="{BEBA8EAE-BF5A-486C-A8C5-ECC9F3942E4B}">
                  <a14:imgProps xmlns:a14="http://schemas.microsoft.com/office/drawing/2010/main">
                    <a14:imgLayer r:embed="rId4">
                      <a14:imgEffect>
                        <a14:brightnessContrast bright="20000"/>
                      </a14:imgEffect>
                    </a14:imgLayer>
                  </a14:imgProps>
                </a:ext>
                <a:ext uri="{28A0092B-C50C-407E-A947-70E740481C1C}">
                  <a14:useLocalDpi xmlns:a14="http://schemas.microsoft.com/office/drawing/2010/main"/>
                </a:ext>
              </a:extLst>
            </a:blip>
            <a:stretch>
              <a:fillRect/>
            </a:stretch>
          </p:blipFill>
          <p:spPr>
            <a:xfrm>
              <a:off x="718738" y="637650"/>
              <a:ext cx="2678377" cy="2016660"/>
            </a:xfrm>
            <a:prstGeom prst="rect">
              <a:avLst/>
            </a:prstGeom>
          </p:spPr>
        </p:pic>
        <p:cxnSp>
          <p:nvCxnSpPr>
            <p:cNvPr id="17" name="Gerader Verbinder 16">
              <a:extLst>
                <a:ext uri="{FF2B5EF4-FFF2-40B4-BE49-F238E27FC236}">
                  <a16:creationId xmlns:a16="http://schemas.microsoft.com/office/drawing/2014/main" id="{B8D13F69-FBA9-4F16-AE3C-96B4F1F374F4}"/>
                </a:ext>
              </a:extLst>
            </p:cNvPr>
            <p:cNvCxnSpPr>
              <a:cxnSpLocks/>
            </p:cNvCxnSpPr>
            <p:nvPr/>
          </p:nvCxnSpPr>
          <p:spPr>
            <a:xfrm>
              <a:off x="2895487" y="2553240"/>
              <a:ext cx="371475"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18" name="Grafik 17">
              <a:extLst>
                <a:ext uri="{FF2B5EF4-FFF2-40B4-BE49-F238E27FC236}">
                  <a16:creationId xmlns:a16="http://schemas.microsoft.com/office/drawing/2014/main" id="{1FBDAEAE-896A-4E57-8BE2-D828247248EA}"/>
                </a:ext>
              </a:extLst>
            </p:cNvPr>
            <p:cNvPicPr>
              <a:picLocks noChangeAspect="1"/>
            </p:cNvPicPr>
            <p:nvPr/>
          </p:nvPicPr>
          <p:blipFill>
            <a:blip r:embed="rId5" cstate="hqprint">
              <a:extLst>
                <a:ext uri="{BEBA8EAE-BF5A-486C-A8C5-ECC9F3942E4B}">
                  <a14:imgProps xmlns:a14="http://schemas.microsoft.com/office/drawing/2010/main">
                    <a14:imgLayer r:embed="rId6">
                      <a14:imgEffect>
                        <a14:brightnessContrast bright="20000"/>
                      </a14:imgEffect>
                    </a14:imgLayer>
                  </a14:imgProps>
                </a:ext>
                <a:ext uri="{28A0092B-C50C-407E-A947-70E740481C1C}">
                  <a14:useLocalDpi xmlns:a14="http://schemas.microsoft.com/office/drawing/2010/main"/>
                </a:ext>
              </a:extLst>
            </a:blip>
            <a:stretch>
              <a:fillRect/>
            </a:stretch>
          </p:blipFill>
          <p:spPr>
            <a:xfrm>
              <a:off x="718738" y="2721489"/>
              <a:ext cx="2678376" cy="2016660"/>
            </a:xfrm>
            <a:prstGeom prst="rect">
              <a:avLst/>
            </a:prstGeom>
          </p:spPr>
        </p:pic>
        <p:cxnSp>
          <p:nvCxnSpPr>
            <p:cNvPr id="19" name="Gerader Verbinder 18">
              <a:extLst>
                <a:ext uri="{FF2B5EF4-FFF2-40B4-BE49-F238E27FC236}">
                  <a16:creationId xmlns:a16="http://schemas.microsoft.com/office/drawing/2014/main" id="{2920CC10-4522-4E37-A598-9443F2D434CA}"/>
                </a:ext>
              </a:extLst>
            </p:cNvPr>
            <p:cNvCxnSpPr>
              <a:cxnSpLocks/>
            </p:cNvCxnSpPr>
            <p:nvPr/>
          </p:nvCxnSpPr>
          <p:spPr>
            <a:xfrm>
              <a:off x="2895487" y="4619587"/>
              <a:ext cx="371475"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20" name="Freihandform: Form 19">
              <a:extLst>
                <a:ext uri="{FF2B5EF4-FFF2-40B4-BE49-F238E27FC236}">
                  <a16:creationId xmlns:a16="http://schemas.microsoft.com/office/drawing/2014/main" id="{294C84EE-2B06-45BF-BC40-5CEBAA8CA3DE}"/>
                </a:ext>
              </a:extLst>
            </p:cNvPr>
            <p:cNvSpPr/>
            <p:nvPr/>
          </p:nvSpPr>
          <p:spPr>
            <a:xfrm>
              <a:off x="716642" y="1093534"/>
              <a:ext cx="2681288" cy="172720"/>
            </a:xfrm>
            <a:custGeom>
              <a:avLst/>
              <a:gdLst>
                <a:gd name="connsiteX0" fmla="*/ 0 w 2681288"/>
                <a:gd name="connsiteY0" fmla="*/ 71438 h 172720"/>
                <a:gd name="connsiteX1" fmla="*/ 66675 w 2681288"/>
                <a:gd name="connsiteY1" fmla="*/ 147638 h 172720"/>
                <a:gd name="connsiteX2" fmla="*/ 161925 w 2681288"/>
                <a:gd name="connsiteY2" fmla="*/ 119063 h 172720"/>
                <a:gd name="connsiteX3" fmla="*/ 252413 w 2681288"/>
                <a:gd name="connsiteY3" fmla="*/ 157163 h 172720"/>
                <a:gd name="connsiteX4" fmla="*/ 438150 w 2681288"/>
                <a:gd name="connsiteY4" fmla="*/ 104775 h 172720"/>
                <a:gd name="connsiteX5" fmla="*/ 600075 w 2681288"/>
                <a:gd name="connsiteY5" fmla="*/ 157163 h 172720"/>
                <a:gd name="connsiteX6" fmla="*/ 676275 w 2681288"/>
                <a:gd name="connsiteY6" fmla="*/ 128588 h 172720"/>
                <a:gd name="connsiteX7" fmla="*/ 742950 w 2681288"/>
                <a:gd name="connsiteY7" fmla="*/ 171450 h 172720"/>
                <a:gd name="connsiteX8" fmla="*/ 957263 w 2681288"/>
                <a:gd name="connsiteY8" fmla="*/ 90488 h 172720"/>
                <a:gd name="connsiteX9" fmla="*/ 1104900 w 2681288"/>
                <a:gd name="connsiteY9" fmla="*/ 133350 h 172720"/>
                <a:gd name="connsiteX10" fmla="*/ 1223963 w 2681288"/>
                <a:gd name="connsiteY10" fmla="*/ 142875 h 172720"/>
                <a:gd name="connsiteX11" fmla="*/ 1319213 w 2681288"/>
                <a:gd name="connsiteY11" fmla="*/ 104775 h 172720"/>
                <a:gd name="connsiteX12" fmla="*/ 1447800 w 2681288"/>
                <a:gd name="connsiteY12" fmla="*/ 138113 h 172720"/>
                <a:gd name="connsiteX13" fmla="*/ 1581150 w 2681288"/>
                <a:gd name="connsiteY13" fmla="*/ 157163 h 172720"/>
                <a:gd name="connsiteX14" fmla="*/ 1700213 w 2681288"/>
                <a:gd name="connsiteY14" fmla="*/ 128588 h 172720"/>
                <a:gd name="connsiteX15" fmla="*/ 1781175 w 2681288"/>
                <a:gd name="connsiteY15" fmla="*/ 138113 h 172720"/>
                <a:gd name="connsiteX16" fmla="*/ 1919288 w 2681288"/>
                <a:gd name="connsiteY16" fmla="*/ 114300 h 172720"/>
                <a:gd name="connsiteX17" fmla="*/ 2171700 w 2681288"/>
                <a:gd name="connsiteY17" fmla="*/ 161925 h 172720"/>
                <a:gd name="connsiteX18" fmla="*/ 2271713 w 2681288"/>
                <a:gd name="connsiteY18" fmla="*/ 166688 h 172720"/>
                <a:gd name="connsiteX19" fmla="*/ 2419350 w 2681288"/>
                <a:gd name="connsiteY19" fmla="*/ 90488 h 172720"/>
                <a:gd name="connsiteX20" fmla="*/ 2681288 w 2681288"/>
                <a:gd name="connsiteY20" fmla="*/ 0 h 1727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2681288" h="172720">
                  <a:moveTo>
                    <a:pt x="0" y="71438"/>
                  </a:moveTo>
                  <a:cubicBezTo>
                    <a:pt x="19844" y="105569"/>
                    <a:pt x="39688" y="139701"/>
                    <a:pt x="66675" y="147638"/>
                  </a:cubicBezTo>
                  <a:cubicBezTo>
                    <a:pt x="93662" y="155575"/>
                    <a:pt x="130969" y="117476"/>
                    <a:pt x="161925" y="119063"/>
                  </a:cubicBezTo>
                  <a:cubicBezTo>
                    <a:pt x="192881" y="120651"/>
                    <a:pt x="206376" y="159544"/>
                    <a:pt x="252413" y="157163"/>
                  </a:cubicBezTo>
                  <a:cubicBezTo>
                    <a:pt x="298450" y="154782"/>
                    <a:pt x="380206" y="104775"/>
                    <a:pt x="438150" y="104775"/>
                  </a:cubicBezTo>
                  <a:cubicBezTo>
                    <a:pt x="496094" y="104775"/>
                    <a:pt x="560387" y="153194"/>
                    <a:pt x="600075" y="157163"/>
                  </a:cubicBezTo>
                  <a:cubicBezTo>
                    <a:pt x="639763" y="161132"/>
                    <a:pt x="652462" y="126207"/>
                    <a:pt x="676275" y="128588"/>
                  </a:cubicBezTo>
                  <a:cubicBezTo>
                    <a:pt x="700088" y="130969"/>
                    <a:pt x="696119" y="177800"/>
                    <a:pt x="742950" y="171450"/>
                  </a:cubicBezTo>
                  <a:cubicBezTo>
                    <a:pt x="789781" y="165100"/>
                    <a:pt x="896938" y="96838"/>
                    <a:pt x="957263" y="90488"/>
                  </a:cubicBezTo>
                  <a:cubicBezTo>
                    <a:pt x="1017588" y="84138"/>
                    <a:pt x="1060450" y="124619"/>
                    <a:pt x="1104900" y="133350"/>
                  </a:cubicBezTo>
                  <a:cubicBezTo>
                    <a:pt x="1149350" y="142081"/>
                    <a:pt x="1188244" y="147637"/>
                    <a:pt x="1223963" y="142875"/>
                  </a:cubicBezTo>
                  <a:cubicBezTo>
                    <a:pt x="1259682" y="138113"/>
                    <a:pt x="1281907" y="105569"/>
                    <a:pt x="1319213" y="104775"/>
                  </a:cubicBezTo>
                  <a:cubicBezTo>
                    <a:pt x="1356519" y="103981"/>
                    <a:pt x="1404144" y="129382"/>
                    <a:pt x="1447800" y="138113"/>
                  </a:cubicBezTo>
                  <a:cubicBezTo>
                    <a:pt x="1491456" y="146844"/>
                    <a:pt x="1539081" y="158750"/>
                    <a:pt x="1581150" y="157163"/>
                  </a:cubicBezTo>
                  <a:cubicBezTo>
                    <a:pt x="1623219" y="155576"/>
                    <a:pt x="1666876" y="131763"/>
                    <a:pt x="1700213" y="128588"/>
                  </a:cubicBezTo>
                  <a:cubicBezTo>
                    <a:pt x="1733550" y="125413"/>
                    <a:pt x="1744663" y="140494"/>
                    <a:pt x="1781175" y="138113"/>
                  </a:cubicBezTo>
                  <a:cubicBezTo>
                    <a:pt x="1817687" y="135732"/>
                    <a:pt x="1854201" y="110331"/>
                    <a:pt x="1919288" y="114300"/>
                  </a:cubicBezTo>
                  <a:cubicBezTo>
                    <a:pt x="1984375" y="118269"/>
                    <a:pt x="2112963" y="153194"/>
                    <a:pt x="2171700" y="161925"/>
                  </a:cubicBezTo>
                  <a:cubicBezTo>
                    <a:pt x="2230438" y="170656"/>
                    <a:pt x="2230438" y="178594"/>
                    <a:pt x="2271713" y="166688"/>
                  </a:cubicBezTo>
                  <a:cubicBezTo>
                    <a:pt x="2312988" y="154782"/>
                    <a:pt x="2351088" y="118269"/>
                    <a:pt x="2419350" y="90488"/>
                  </a:cubicBezTo>
                  <a:cubicBezTo>
                    <a:pt x="2487612" y="62707"/>
                    <a:pt x="2584450" y="31353"/>
                    <a:pt x="2681288" y="0"/>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1" name="Freihandform: Form 20">
              <a:extLst>
                <a:ext uri="{FF2B5EF4-FFF2-40B4-BE49-F238E27FC236}">
                  <a16:creationId xmlns:a16="http://schemas.microsoft.com/office/drawing/2014/main" id="{87A0D5AE-8925-4DEF-BE23-6558B8F6B77A}"/>
                </a:ext>
              </a:extLst>
            </p:cNvPr>
            <p:cNvSpPr/>
            <p:nvPr/>
          </p:nvSpPr>
          <p:spPr>
            <a:xfrm>
              <a:off x="716642" y="3059869"/>
              <a:ext cx="2676525" cy="292178"/>
            </a:xfrm>
            <a:custGeom>
              <a:avLst/>
              <a:gdLst>
                <a:gd name="connsiteX0" fmla="*/ 0 w 2676525"/>
                <a:gd name="connsiteY0" fmla="*/ 204787 h 292178"/>
                <a:gd name="connsiteX1" fmla="*/ 138113 w 2676525"/>
                <a:gd name="connsiteY1" fmla="*/ 271462 h 292178"/>
                <a:gd name="connsiteX2" fmla="*/ 238125 w 2676525"/>
                <a:gd name="connsiteY2" fmla="*/ 290512 h 292178"/>
                <a:gd name="connsiteX3" fmla="*/ 323850 w 2676525"/>
                <a:gd name="connsiteY3" fmla="*/ 271462 h 292178"/>
                <a:gd name="connsiteX4" fmla="*/ 385763 w 2676525"/>
                <a:gd name="connsiteY4" fmla="*/ 285750 h 292178"/>
                <a:gd name="connsiteX5" fmla="*/ 923925 w 2676525"/>
                <a:gd name="connsiteY5" fmla="*/ 147637 h 292178"/>
                <a:gd name="connsiteX6" fmla="*/ 1014413 w 2676525"/>
                <a:gd name="connsiteY6" fmla="*/ 161925 h 292178"/>
                <a:gd name="connsiteX7" fmla="*/ 1104900 w 2676525"/>
                <a:gd name="connsiteY7" fmla="*/ 114300 h 292178"/>
                <a:gd name="connsiteX8" fmla="*/ 1404938 w 2676525"/>
                <a:gd name="connsiteY8" fmla="*/ 219075 h 292178"/>
                <a:gd name="connsiteX9" fmla="*/ 1552575 w 2676525"/>
                <a:gd name="connsiteY9" fmla="*/ 261937 h 292178"/>
                <a:gd name="connsiteX10" fmla="*/ 1738313 w 2676525"/>
                <a:gd name="connsiteY10" fmla="*/ 233362 h 292178"/>
                <a:gd name="connsiteX11" fmla="*/ 1909763 w 2676525"/>
                <a:gd name="connsiteY11" fmla="*/ 223837 h 292178"/>
                <a:gd name="connsiteX12" fmla="*/ 2157413 w 2676525"/>
                <a:gd name="connsiteY12" fmla="*/ 219075 h 292178"/>
                <a:gd name="connsiteX13" fmla="*/ 2409825 w 2676525"/>
                <a:gd name="connsiteY13" fmla="*/ 142875 h 292178"/>
                <a:gd name="connsiteX14" fmla="*/ 2676525 w 2676525"/>
                <a:gd name="connsiteY14" fmla="*/ 0 h 29217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Lst>
              <a:rect l="l" t="t" r="r" b="b"/>
              <a:pathLst>
                <a:path w="2676525" h="292178">
                  <a:moveTo>
                    <a:pt x="0" y="204787"/>
                  </a:moveTo>
                  <a:cubicBezTo>
                    <a:pt x="49213" y="230981"/>
                    <a:pt x="98426" y="257175"/>
                    <a:pt x="138113" y="271462"/>
                  </a:cubicBezTo>
                  <a:cubicBezTo>
                    <a:pt x="177800" y="285749"/>
                    <a:pt x="207169" y="290512"/>
                    <a:pt x="238125" y="290512"/>
                  </a:cubicBezTo>
                  <a:cubicBezTo>
                    <a:pt x="269081" y="290512"/>
                    <a:pt x="299244" y="272256"/>
                    <a:pt x="323850" y="271462"/>
                  </a:cubicBezTo>
                  <a:cubicBezTo>
                    <a:pt x="348456" y="270668"/>
                    <a:pt x="285751" y="306387"/>
                    <a:pt x="385763" y="285750"/>
                  </a:cubicBezTo>
                  <a:cubicBezTo>
                    <a:pt x="485775" y="265113"/>
                    <a:pt x="819150" y="168274"/>
                    <a:pt x="923925" y="147637"/>
                  </a:cubicBezTo>
                  <a:cubicBezTo>
                    <a:pt x="1028700" y="127000"/>
                    <a:pt x="984251" y="167481"/>
                    <a:pt x="1014413" y="161925"/>
                  </a:cubicBezTo>
                  <a:cubicBezTo>
                    <a:pt x="1044576" y="156369"/>
                    <a:pt x="1039813" y="104775"/>
                    <a:pt x="1104900" y="114300"/>
                  </a:cubicBezTo>
                  <a:cubicBezTo>
                    <a:pt x="1169987" y="123825"/>
                    <a:pt x="1330326" y="194469"/>
                    <a:pt x="1404938" y="219075"/>
                  </a:cubicBezTo>
                  <a:cubicBezTo>
                    <a:pt x="1479551" y="243681"/>
                    <a:pt x="1497013" y="259556"/>
                    <a:pt x="1552575" y="261937"/>
                  </a:cubicBezTo>
                  <a:cubicBezTo>
                    <a:pt x="1608137" y="264318"/>
                    <a:pt x="1678782" y="239712"/>
                    <a:pt x="1738313" y="233362"/>
                  </a:cubicBezTo>
                  <a:cubicBezTo>
                    <a:pt x="1797844" y="227012"/>
                    <a:pt x="1839913" y="226218"/>
                    <a:pt x="1909763" y="223837"/>
                  </a:cubicBezTo>
                  <a:cubicBezTo>
                    <a:pt x="1979613" y="221456"/>
                    <a:pt x="2074069" y="232569"/>
                    <a:pt x="2157413" y="219075"/>
                  </a:cubicBezTo>
                  <a:cubicBezTo>
                    <a:pt x="2240757" y="205581"/>
                    <a:pt x="2323306" y="179387"/>
                    <a:pt x="2409825" y="142875"/>
                  </a:cubicBezTo>
                  <a:cubicBezTo>
                    <a:pt x="2496344" y="106363"/>
                    <a:pt x="2586434" y="53181"/>
                    <a:pt x="2676525" y="0"/>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2" name="Titel 1">
              <a:extLst>
                <a:ext uri="{FF2B5EF4-FFF2-40B4-BE49-F238E27FC236}">
                  <a16:creationId xmlns:a16="http://schemas.microsoft.com/office/drawing/2014/main" id="{CC67D754-9943-4020-A532-AED9F4BF31E4}"/>
                </a:ext>
              </a:extLst>
            </p:cNvPr>
            <p:cNvSpPr txBox="1">
              <a:spLocks/>
            </p:cNvSpPr>
            <p:nvPr/>
          </p:nvSpPr>
          <p:spPr>
            <a:xfrm>
              <a:off x="715072" y="268078"/>
              <a:ext cx="2676525" cy="45156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de-DE" sz="1400" b="1" dirty="0">
                  <a:latin typeface="Times New Roman" panose="02020603050405020304" pitchFamily="18" charset="0"/>
                  <a:cs typeface="Times New Roman" panose="02020603050405020304" pitchFamily="18" charset="0"/>
                </a:rPr>
                <a:t>Vehicle</a:t>
              </a:r>
            </a:p>
          </p:txBody>
        </p:sp>
        <p:pic>
          <p:nvPicPr>
            <p:cNvPr id="32" name="Grafik 31">
              <a:extLst>
                <a:ext uri="{FF2B5EF4-FFF2-40B4-BE49-F238E27FC236}">
                  <a16:creationId xmlns:a16="http://schemas.microsoft.com/office/drawing/2014/main" id="{C1660463-8118-43B2-A6F8-81D1AB600103}"/>
                </a:ext>
              </a:extLst>
            </p:cNvPr>
            <p:cNvPicPr>
              <a:picLocks noChangeAspect="1"/>
            </p:cNvPicPr>
            <p:nvPr/>
          </p:nvPicPr>
          <p:blipFill>
            <a:blip r:embed="rId7" cstate="hqprint">
              <a:extLst>
                <a:ext uri="{28A0092B-C50C-407E-A947-70E740481C1C}">
                  <a14:useLocalDpi xmlns:a14="http://schemas.microsoft.com/office/drawing/2010/main"/>
                </a:ext>
              </a:extLst>
            </a:blip>
            <a:stretch>
              <a:fillRect/>
            </a:stretch>
          </p:blipFill>
          <p:spPr>
            <a:xfrm>
              <a:off x="3480583" y="624966"/>
              <a:ext cx="2678376" cy="2016659"/>
            </a:xfrm>
            <a:prstGeom prst="rect">
              <a:avLst/>
            </a:prstGeom>
          </p:spPr>
        </p:pic>
        <p:pic>
          <p:nvPicPr>
            <p:cNvPr id="33" name="Grafik 32">
              <a:extLst>
                <a:ext uri="{FF2B5EF4-FFF2-40B4-BE49-F238E27FC236}">
                  <a16:creationId xmlns:a16="http://schemas.microsoft.com/office/drawing/2014/main" id="{76DBECEC-F4C6-4324-97CA-03E55DE32715}"/>
                </a:ext>
              </a:extLst>
            </p:cNvPr>
            <p:cNvPicPr>
              <a:picLocks noChangeAspect="1"/>
            </p:cNvPicPr>
            <p:nvPr/>
          </p:nvPicPr>
          <p:blipFill>
            <a:blip r:embed="rId8" cstate="hqprint">
              <a:extLst>
                <a:ext uri="{28A0092B-C50C-407E-A947-70E740481C1C}">
                  <a14:useLocalDpi xmlns:a14="http://schemas.microsoft.com/office/drawing/2010/main"/>
                </a:ext>
              </a:extLst>
            </a:blip>
            <a:stretch>
              <a:fillRect/>
            </a:stretch>
          </p:blipFill>
          <p:spPr>
            <a:xfrm>
              <a:off x="3472222" y="2719832"/>
              <a:ext cx="2678378" cy="2016661"/>
            </a:xfrm>
            <a:prstGeom prst="rect">
              <a:avLst/>
            </a:prstGeom>
          </p:spPr>
        </p:pic>
        <p:sp>
          <p:nvSpPr>
            <p:cNvPr id="34" name="Freihandform: Form 33">
              <a:extLst>
                <a:ext uri="{FF2B5EF4-FFF2-40B4-BE49-F238E27FC236}">
                  <a16:creationId xmlns:a16="http://schemas.microsoft.com/office/drawing/2014/main" id="{1D3EFD2A-FC5F-41AB-9A06-2693D4F4FFBB}"/>
                </a:ext>
              </a:extLst>
            </p:cNvPr>
            <p:cNvSpPr/>
            <p:nvPr/>
          </p:nvSpPr>
          <p:spPr>
            <a:xfrm>
              <a:off x="3582183" y="629195"/>
              <a:ext cx="2559050" cy="749452"/>
            </a:xfrm>
            <a:custGeom>
              <a:avLst/>
              <a:gdLst>
                <a:gd name="connsiteX0" fmla="*/ 0 w 2559050"/>
                <a:gd name="connsiteY0" fmla="*/ 0 h 749452"/>
                <a:gd name="connsiteX1" fmla="*/ 76200 w 2559050"/>
                <a:gd name="connsiteY1" fmla="*/ 101600 h 749452"/>
                <a:gd name="connsiteX2" fmla="*/ 139700 w 2559050"/>
                <a:gd name="connsiteY2" fmla="*/ 177800 h 749452"/>
                <a:gd name="connsiteX3" fmla="*/ 273050 w 2559050"/>
                <a:gd name="connsiteY3" fmla="*/ 203200 h 749452"/>
                <a:gd name="connsiteX4" fmla="*/ 298450 w 2559050"/>
                <a:gd name="connsiteY4" fmla="*/ 349250 h 749452"/>
                <a:gd name="connsiteX5" fmla="*/ 469900 w 2559050"/>
                <a:gd name="connsiteY5" fmla="*/ 387350 h 749452"/>
                <a:gd name="connsiteX6" fmla="*/ 533400 w 2559050"/>
                <a:gd name="connsiteY6" fmla="*/ 514350 h 749452"/>
                <a:gd name="connsiteX7" fmla="*/ 704850 w 2559050"/>
                <a:gd name="connsiteY7" fmla="*/ 520700 h 749452"/>
                <a:gd name="connsiteX8" fmla="*/ 908050 w 2559050"/>
                <a:gd name="connsiteY8" fmla="*/ 514350 h 749452"/>
                <a:gd name="connsiteX9" fmla="*/ 1028700 w 2559050"/>
                <a:gd name="connsiteY9" fmla="*/ 463550 h 749452"/>
                <a:gd name="connsiteX10" fmla="*/ 1168400 w 2559050"/>
                <a:gd name="connsiteY10" fmla="*/ 584200 h 749452"/>
                <a:gd name="connsiteX11" fmla="*/ 1327150 w 2559050"/>
                <a:gd name="connsiteY11" fmla="*/ 647700 h 749452"/>
                <a:gd name="connsiteX12" fmla="*/ 1479550 w 2559050"/>
                <a:gd name="connsiteY12" fmla="*/ 590550 h 749452"/>
                <a:gd name="connsiteX13" fmla="*/ 1619250 w 2559050"/>
                <a:gd name="connsiteY13" fmla="*/ 704850 h 749452"/>
                <a:gd name="connsiteX14" fmla="*/ 1695450 w 2559050"/>
                <a:gd name="connsiteY14" fmla="*/ 749300 h 749452"/>
                <a:gd name="connsiteX15" fmla="*/ 1803400 w 2559050"/>
                <a:gd name="connsiteY15" fmla="*/ 692150 h 749452"/>
                <a:gd name="connsiteX16" fmla="*/ 1924050 w 2559050"/>
                <a:gd name="connsiteY16" fmla="*/ 704850 h 749452"/>
                <a:gd name="connsiteX17" fmla="*/ 2051050 w 2559050"/>
                <a:gd name="connsiteY17" fmla="*/ 673100 h 749452"/>
                <a:gd name="connsiteX18" fmla="*/ 2159000 w 2559050"/>
                <a:gd name="connsiteY18" fmla="*/ 692150 h 749452"/>
                <a:gd name="connsiteX19" fmla="*/ 2286000 w 2559050"/>
                <a:gd name="connsiteY19" fmla="*/ 666750 h 749452"/>
                <a:gd name="connsiteX20" fmla="*/ 2387600 w 2559050"/>
                <a:gd name="connsiteY20" fmla="*/ 742950 h 749452"/>
                <a:gd name="connsiteX21" fmla="*/ 2495550 w 2559050"/>
                <a:gd name="connsiteY21" fmla="*/ 660400 h 749452"/>
                <a:gd name="connsiteX22" fmla="*/ 2559050 w 2559050"/>
                <a:gd name="connsiteY22" fmla="*/ 660400 h 7494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Lst>
              <a:rect l="l" t="t" r="r" b="b"/>
              <a:pathLst>
                <a:path w="2559050" h="749452">
                  <a:moveTo>
                    <a:pt x="0" y="0"/>
                  </a:moveTo>
                  <a:cubicBezTo>
                    <a:pt x="26987" y="35983"/>
                    <a:pt x="52917" y="71967"/>
                    <a:pt x="76200" y="101600"/>
                  </a:cubicBezTo>
                  <a:cubicBezTo>
                    <a:pt x="99483" y="131233"/>
                    <a:pt x="106892" y="160867"/>
                    <a:pt x="139700" y="177800"/>
                  </a:cubicBezTo>
                  <a:cubicBezTo>
                    <a:pt x="172508" y="194733"/>
                    <a:pt x="246592" y="174625"/>
                    <a:pt x="273050" y="203200"/>
                  </a:cubicBezTo>
                  <a:cubicBezTo>
                    <a:pt x="299508" y="231775"/>
                    <a:pt x="265642" y="318558"/>
                    <a:pt x="298450" y="349250"/>
                  </a:cubicBezTo>
                  <a:cubicBezTo>
                    <a:pt x="331258" y="379942"/>
                    <a:pt x="430742" y="359833"/>
                    <a:pt x="469900" y="387350"/>
                  </a:cubicBezTo>
                  <a:cubicBezTo>
                    <a:pt x="509058" y="414867"/>
                    <a:pt x="494242" y="492125"/>
                    <a:pt x="533400" y="514350"/>
                  </a:cubicBezTo>
                  <a:cubicBezTo>
                    <a:pt x="572558" y="536575"/>
                    <a:pt x="642408" y="520700"/>
                    <a:pt x="704850" y="520700"/>
                  </a:cubicBezTo>
                  <a:cubicBezTo>
                    <a:pt x="767292" y="520700"/>
                    <a:pt x="854075" y="523875"/>
                    <a:pt x="908050" y="514350"/>
                  </a:cubicBezTo>
                  <a:cubicBezTo>
                    <a:pt x="962025" y="504825"/>
                    <a:pt x="985308" y="451908"/>
                    <a:pt x="1028700" y="463550"/>
                  </a:cubicBezTo>
                  <a:cubicBezTo>
                    <a:pt x="1072092" y="475192"/>
                    <a:pt x="1118658" y="553508"/>
                    <a:pt x="1168400" y="584200"/>
                  </a:cubicBezTo>
                  <a:cubicBezTo>
                    <a:pt x="1218142" y="614892"/>
                    <a:pt x="1275292" y="646642"/>
                    <a:pt x="1327150" y="647700"/>
                  </a:cubicBezTo>
                  <a:cubicBezTo>
                    <a:pt x="1379008" y="648758"/>
                    <a:pt x="1430867" y="581025"/>
                    <a:pt x="1479550" y="590550"/>
                  </a:cubicBezTo>
                  <a:cubicBezTo>
                    <a:pt x="1528233" y="600075"/>
                    <a:pt x="1583267" y="678392"/>
                    <a:pt x="1619250" y="704850"/>
                  </a:cubicBezTo>
                  <a:cubicBezTo>
                    <a:pt x="1655233" y="731308"/>
                    <a:pt x="1664758" y="751417"/>
                    <a:pt x="1695450" y="749300"/>
                  </a:cubicBezTo>
                  <a:cubicBezTo>
                    <a:pt x="1726142" y="747183"/>
                    <a:pt x="1765300" y="699558"/>
                    <a:pt x="1803400" y="692150"/>
                  </a:cubicBezTo>
                  <a:cubicBezTo>
                    <a:pt x="1841500" y="684742"/>
                    <a:pt x="1882775" y="708025"/>
                    <a:pt x="1924050" y="704850"/>
                  </a:cubicBezTo>
                  <a:cubicBezTo>
                    <a:pt x="1965325" y="701675"/>
                    <a:pt x="2011892" y="675217"/>
                    <a:pt x="2051050" y="673100"/>
                  </a:cubicBezTo>
                  <a:cubicBezTo>
                    <a:pt x="2090208" y="670983"/>
                    <a:pt x="2119842" y="693208"/>
                    <a:pt x="2159000" y="692150"/>
                  </a:cubicBezTo>
                  <a:cubicBezTo>
                    <a:pt x="2198158" y="691092"/>
                    <a:pt x="2247900" y="658283"/>
                    <a:pt x="2286000" y="666750"/>
                  </a:cubicBezTo>
                  <a:cubicBezTo>
                    <a:pt x="2324100" y="675217"/>
                    <a:pt x="2352675" y="744008"/>
                    <a:pt x="2387600" y="742950"/>
                  </a:cubicBezTo>
                  <a:cubicBezTo>
                    <a:pt x="2422525" y="741892"/>
                    <a:pt x="2466975" y="674158"/>
                    <a:pt x="2495550" y="660400"/>
                  </a:cubicBezTo>
                  <a:cubicBezTo>
                    <a:pt x="2524125" y="646642"/>
                    <a:pt x="2541587" y="653521"/>
                    <a:pt x="2559050" y="660400"/>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5" name="Freihandform: Form 34">
              <a:extLst>
                <a:ext uri="{FF2B5EF4-FFF2-40B4-BE49-F238E27FC236}">
                  <a16:creationId xmlns:a16="http://schemas.microsoft.com/office/drawing/2014/main" id="{361F98D6-1556-4720-BAEB-AB58F4D9B86F}"/>
                </a:ext>
              </a:extLst>
            </p:cNvPr>
            <p:cNvSpPr/>
            <p:nvPr/>
          </p:nvSpPr>
          <p:spPr>
            <a:xfrm>
              <a:off x="3544083" y="2751825"/>
              <a:ext cx="2597150" cy="590846"/>
            </a:xfrm>
            <a:custGeom>
              <a:avLst/>
              <a:gdLst>
                <a:gd name="connsiteX0" fmla="*/ 0 w 2597150"/>
                <a:gd name="connsiteY0" fmla="*/ 0 h 590846"/>
                <a:gd name="connsiteX1" fmla="*/ 76200 w 2597150"/>
                <a:gd name="connsiteY1" fmla="*/ 127000 h 590846"/>
                <a:gd name="connsiteX2" fmla="*/ 203200 w 2597150"/>
                <a:gd name="connsiteY2" fmla="*/ 171450 h 590846"/>
                <a:gd name="connsiteX3" fmla="*/ 254000 w 2597150"/>
                <a:gd name="connsiteY3" fmla="*/ 228600 h 590846"/>
                <a:gd name="connsiteX4" fmla="*/ 374650 w 2597150"/>
                <a:gd name="connsiteY4" fmla="*/ 254000 h 590846"/>
                <a:gd name="connsiteX5" fmla="*/ 527050 w 2597150"/>
                <a:gd name="connsiteY5" fmla="*/ 279400 h 590846"/>
                <a:gd name="connsiteX6" fmla="*/ 692150 w 2597150"/>
                <a:gd name="connsiteY6" fmla="*/ 254000 h 590846"/>
                <a:gd name="connsiteX7" fmla="*/ 749300 w 2597150"/>
                <a:gd name="connsiteY7" fmla="*/ 323850 h 590846"/>
                <a:gd name="connsiteX8" fmla="*/ 838200 w 2597150"/>
                <a:gd name="connsiteY8" fmla="*/ 323850 h 590846"/>
                <a:gd name="connsiteX9" fmla="*/ 863600 w 2597150"/>
                <a:gd name="connsiteY9" fmla="*/ 355600 h 590846"/>
                <a:gd name="connsiteX10" fmla="*/ 984250 w 2597150"/>
                <a:gd name="connsiteY10" fmla="*/ 336550 h 590846"/>
                <a:gd name="connsiteX11" fmla="*/ 1079500 w 2597150"/>
                <a:gd name="connsiteY11" fmla="*/ 425450 h 590846"/>
                <a:gd name="connsiteX12" fmla="*/ 1143000 w 2597150"/>
                <a:gd name="connsiteY12" fmla="*/ 425450 h 590846"/>
                <a:gd name="connsiteX13" fmla="*/ 1212850 w 2597150"/>
                <a:gd name="connsiteY13" fmla="*/ 482600 h 590846"/>
                <a:gd name="connsiteX14" fmla="*/ 1339850 w 2597150"/>
                <a:gd name="connsiteY14" fmla="*/ 488950 h 590846"/>
                <a:gd name="connsiteX15" fmla="*/ 1403350 w 2597150"/>
                <a:gd name="connsiteY15" fmla="*/ 469900 h 590846"/>
                <a:gd name="connsiteX16" fmla="*/ 1435100 w 2597150"/>
                <a:gd name="connsiteY16" fmla="*/ 488950 h 590846"/>
                <a:gd name="connsiteX17" fmla="*/ 1498600 w 2597150"/>
                <a:gd name="connsiteY17" fmla="*/ 457200 h 590846"/>
                <a:gd name="connsiteX18" fmla="*/ 1593850 w 2597150"/>
                <a:gd name="connsiteY18" fmla="*/ 463550 h 590846"/>
                <a:gd name="connsiteX19" fmla="*/ 1695450 w 2597150"/>
                <a:gd name="connsiteY19" fmla="*/ 520700 h 590846"/>
                <a:gd name="connsiteX20" fmla="*/ 1720850 w 2597150"/>
                <a:gd name="connsiteY20" fmla="*/ 539750 h 590846"/>
                <a:gd name="connsiteX21" fmla="*/ 1841500 w 2597150"/>
                <a:gd name="connsiteY21" fmla="*/ 501650 h 590846"/>
                <a:gd name="connsiteX22" fmla="*/ 1917700 w 2597150"/>
                <a:gd name="connsiteY22" fmla="*/ 539750 h 590846"/>
                <a:gd name="connsiteX23" fmla="*/ 2000250 w 2597150"/>
                <a:gd name="connsiteY23" fmla="*/ 571500 h 590846"/>
                <a:gd name="connsiteX24" fmla="*/ 2108200 w 2597150"/>
                <a:gd name="connsiteY24" fmla="*/ 533400 h 590846"/>
                <a:gd name="connsiteX25" fmla="*/ 2165350 w 2597150"/>
                <a:gd name="connsiteY25" fmla="*/ 520700 h 590846"/>
                <a:gd name="connsiteX26" fmla="*/ 2241550 w 2597150"/>
                <a:gd name="connsiteY26" fmla="*/ 571500 h 590846"/>
                <a:gd name="connsiteX27" fmla="*/ 2286000 w 2597150"/>
                <a:gd name="connsiteY27" fmla="*/ 590550 h 590846"/>
                <a:gd name="connsiteX28" fmla="*/ 2368550 w 2597150"/>
                <a:gd name="connsiteY28" fmla="*/ 558800 h 590846"/>
                <a:gd name="connsiteX29" fmla="*/ 2470150 w 2597150"/>
                <a:gd name="connsiteY29" fmla="*/ 546100 h 590846"/>
                <a:gd name="connsiteX30" fmla="*/ 2597150 w 2597150"/>
                <a:gd name="connsiteY30" fmla="*/ 419100 h 59084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Lst>
              <a:rect l="l" t="t" r="r" b="b"/>
              <a:pathLst>
                <a:path w="2597150" h="590846">
                  <a:moveTo>
                    <a:pt x="0" y="0"/>
                  </a:moveTo>
                  <a:cubicBezTo>
                    <a:pt x="21166" y="49212"/>
                    <a:pt x="42333" y="98425"/>
                    <a:pt x="76200" y="127000"/>
                  </a:cubicBezTo>
                  <a:cubicBezTo>
                    <a:pt x="110067" y="155575"/>
                    <a:pt x="173567" y="154517"/>
                    <a:pt x="203200" y="171450"/>
                  </a:cubicBezTo>
                  <a:cubicBezTo>
                    <a:pt x="232833" y="188383"/>
                    <a:pt x="225425" y="214842"/>
                    <a:pt x="254000" y="228600"/>
                  </a:cubicBezTo>
                  <a:cubicBezTo>
                    <a:pt x="282575" y="242358"/>
                    <a:pt x="329142" y="245533"/>
                    <a:pt x="374650" y="254000"/>
                  </a:cubicBezTo>
                  <a:cubicBezTo>
                    <a:pt x="420158" y="262467"/>
                    <a:pt x="474133" y="279400"/>
                    <a:pt x="527050" y="279400"/>
                  </a:cubicBezTo>
                  <a:cubicBezTo>
                    <a:pt x="579967" y="279400"/>
                    <a:pt x="655108" y="246592"/>
                    <a:pt x="692150" y="254000"/>
                  </a:cubicBezTo>
                  <a:cubicBezTo>
                    <a:pt x="729192" y="261408"/>
                    <a:pt x="724958" y="312208"/>
                    <a:pt x="749300" y="323850"/>
                  </a:cubicBezTo>
                  <a:cubicBezTo>
                    <a:pt x="773642" y="335492"/>
                    <a:pt x="819150" y="318558"/>
                    <a:pt x="838200" y="323850"/>
                  </a:cubicBezTo>
                  <a:cubicBezTo>
                    <a:pt x="857250" y="329142"/>
                    <a:pt x="839258" y="353483"/>
                    <a:pt x="863600" y="355600"/>
                  </a:cubicBezTo>
                  <a:cubicBezTo>
                    <a:pt x="887942" y="357717"/>
                    <a:pt x="948267" y="324908"/>
                    <a:pt x="984250" y="336550"/>
                  </a:cubicBezTo>
                  <a:cubicBezTo>
                    <a:pt x="1020233" y="348192"/>
                    <a:pt x="1053042" y="410633"/>
                    <a:pt x="1079500" y="425450"/>
                  </a:cubicBezTo>
                  <a:cubicBezTo>
                    <a:pt x="1105958" y="440267"/>
                    <a:pt x="1120775" y="415925"/>
                    <a:pt x="1143000" y="425450"/>
                  </a:cubicBezTo>
                  <a:cubicBezTo>
                    <a:pt x="1165225" y="434975"/>
                    <a:pt x="1180042" y="472017"/>
                    <a:pt x="1212850" y="482600"/>
                  </a:cubicBezTo>
                  <a:cubicBezTo>
                    <a:pt x="1245658" y="493183"/>
                    <a:pt x="1308100" y="491067"/>
                    <a:pt x="1339850" y="488950"/>
                  </a:cubicBezTo>
                  <a:cubicBezTo>
                    <a:pt x="1371600" y="486833"/>
                    <a:pt x="1387475" y="469900"/>
                    <a:pt x="1403350" y="469900"/>
                  </a:cubicBezTo>
                  <a:cubicBezTo>
                    <a:pt x="1419225" y="469900"/>
                    <a:pt x="1419225" y="491067"/>
                    <a:pt x="1435100" y="488950"/>
                  </a:cubicBezTo>
                  <a:cubicBezTo>
                    <a:pt x="1450975" y="486833"/>
                    <a:pt x="1472142" y="461433"/>
                    <a:pt x="1498600" y="457200"/>
                  </a:cubicBezTo>
                  <a:cubicBezTo>
                    <a:pt x="1525058" y="452967"/>
                    <a:pt x="1561042" y="452967"/>
                    <a:pt x="1593850" y="463550"/>
                  </a:cubicBezTo>
                  <a:cubicBezTo>
                    <a:pt x="1626658" y="474133"/>
                    <a:pt x="1695450" y="520700"/>
                    <a:pt x="1695450" y="520700"/>
                  </a:cubicBezTo>
                  <a:cubicBezTo>
                    <a:pt x="1716617" y="533400"/>
                    <a:pt x="1696508" y="542925"/>
                    <a:pt x="1720850" y="539750"/>
                  </a:cubicBezTo>
                  <a:cubicBezTo>
                    <a:pt x="1745192" y="536575"/>
                    <a:pt x="1808692" y="501650"/>
                    <a:pt x="1841500" y="501650"/>
                  </a:cubicBezTo>
                  <a:cubicBezTo>
                    <a:pt x="1874308" y="501650"/>
                    <a:pt x="1891242" y="528108"/>
                    <a:pt x="1917700" y="539750"/>
                  </a:cubicBezTo>
                  <a:cubicBezTo>
                    <a:pt x="1944158" y="551392"/>
                    <a:pt x="1968500" y="572558"/>
                    <a:pt x="2000250" y="571500"/>
                  </a:cubicBezTo>
                  <a:cubicBezTo>
                    <a:pt x="2032000" y="570442"/>
                    <a:pt x="2080683" y="541867"/>
                    <a:pt x="2108200" y="533400"/>
                  </a:cubicBezTo>
                  <a:cubicBezTo>
                    <a:pt x="2135717" y="524933"/>
                    <a:pt x="2143125" y="514350"/>
                    <a:pt x="2165350" y="520700"/>
                  </a:cubicBezTo>
                  <a:cubicBezTo>
                    <a:pt x="2187575" y="527050"/>
                    <a:pt x="2221442" y="559858"/>
                    <a:pt x="2241550" y="571500"/>
                  </a:cubicBezTo>
                  <a:cubicBezTo>
                    <a:pt x="2261658" y="583142"/>
                    <a:pt x="2264833" y="592667"/>
                    <a:pt x="2286000" y="590550"/>
                  </a:cubicBezTo>
                  <a:cubicBezTo>
                    <a:pt x="2307167" y="588433"/>
                    <a:pt x="2337858" y="566208"/>
                    <a:pt x="2368550" y="558800"/>
                  </a:cubicBezTo>
                  <a:cubicBezTo>
                    <a:pt x="2399242" y="551392"/>
                    <a:pt x="2432050" y="569383"/>
                    <a:pt x="2470150" y="546100"/>
                  </a:cubicBezTo>
                  <a:cubicBezTo>
                    <a:pt x="2508250" y="522817"/>
                    <a:pt x="2552700" y="470958"/>
                    <a:pt x="2597150" y="419100"/>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36" name="Grafik 35">
              <a:extLst>
                <a:ext uri="{FF2B5EF4-FFF2-40B4-BE49-F238E27FC236}">
                  <a16:creationId xmlns:a16="http://schemas.microsoft.com/office/drawing/2014/main" id="{44147C77-18C6-413E-9720-557ECA5F5CFF}"/>
                </a:ext>
              </a:extLst>
            </p:cNvPr>
            <p:cNvPicPr>
              <a:picLocks noChangeAspect="1"/>
            </p:cNvPicPr>
            <p:nvPr/>
          </p:nvPicPr>
          <p:blipFill>
            <a:blip r:embed="rId9" cstate="hqprint">
              <a:extLst>
                <a:ext uri="{BEBA8EAE-BF5A-486C-A8C5-ECC9F3942E4B}">
                  <a14:imgProps xmlns:a14="http://schemas.microsoft.com/office/drawing/2010/main">
                    <a14:imgLayer r:embed="rId10">
                      <a14:imgEffect>
                        <a14:brightnessContrast bright="20000"/>
                      </a14:imgEffect>
                    </a14:imgLayer>
                  </a14:imgProps>
                </a:ext>
                <a:ext uri="{28A0092B-C50C-407E-A947-70E740481C1C}">
                  <a14:useLocalDpi xmlns:a14="http://schemas.microsoft.com/office/drawing/2010/main"/>
                </a:ext>
              </a:extLst>
            </a:blip>
            <a:stretch>
              <a:fillRect/>
            </a:stretch>
          </p:blipFill>
          <p:spPr>
            <a:xfrm>
              <a:off x="6553482" y="633667"/>
              <a:ext cx="2678377" cy="2016660"/>
            </a:xfrm>
            <a:prstGeom prst="rect">
              <a:avLst/>
            </a:prstGeom>
          </p:spPr>
        </p:pic>
        <p:pic>
          <p:nvPicPr>
            <p:cNvPr id="37" name="Grafik 36">
              <a:extLst>
                <a:ext uri="{FF2B5EF4-FFF2-40B4-BE49-F238E27FC236}">
                  <a16:creationId xmlns:a16="http://schemas.microsoft.com/office/drawing/2014/main" id="{049AD4E0-B446-4919-823F-8CAC3F425D2F}"/>
                </a:ext>
              </a:extLst>
            </p:cNvPr>
            <p:cNvPicPr>
              <a:picLocks noChangeAspect="1"/>
            </p:cNvPicPr>
            <p:nvPr/>
          </p:nvPicPr>
          <p:blipFill>
            <a:blip r:embed="rId11" cstate="hqprint">
              <a:extLst>
                <a:ext uri="{BEBA8EAE-BF5A-486C-A8C5-ECC9F3942E4B}">
                  <a14:imgProps xmlns:a14="http://schemas.microsoft.com/office/drawing/2010/main">
                    <a14:imgLayer r:embed="rId12">
                      <a14:imgEffect>
                        <a14:brightnessContrast bright="20000"/>
                      </a14:imgEffect>
                    </a14:imgLayer>
                  </a14:imgProps>
                </a:ext>
                <a:ext uri="{28A0092B-C50C-407E-A947-70E740481C1C}">
                  <a14:useLocalDpi xmlns:a14="http://schemas.microsoft.com/office/drawing/2010/main"/>
                </a:ext>
              </a:extLst>
            </a:blip>
            <a:stretch>
              <a:fillRect/>
            </a:stretch>
          </p:blipFill>
          <p:spPr>
            <a:xfrm>
              <a:off x="6548027" y="2724638"/>
              <a:ext cx="2678376" cy="2016660"/>
            </a:xfrm>
            <a:prstGeom prst="rect">
              <a:avLst/>
            </a:prstGeom>
          </p:spPr>
        </p:pic>
        <p:cxnSp>
          <p:nvCxnSpPr>
            <p:cNvPr id="38" name="Gerader Verbinder 37">
              <a:extLst>
                <a:ext uri="{FF2B5EF4-FFF2-40B4-BE49-F238E27FC236}">
                  <a16:creationId xmlns:a16="http://schemas.microsoft.com/office/drawing/2014/main" id="{E9B80B60-05F6-43DA-949F-31B0395FDA56}"/>
                </a:ext>
              </a:extLst>
            </p:cNvPr>
            <p:cNvCxnSpPr>
              <a:cxnSpLocks/>
            </p:cNvCxnSpPr>
            <p:nvPr/>
          </p:nvCxnSpPr>
          <p:spPr>
            <a:xfrm>
              <a:off x="8708986" y="2549258"/>
              <a:ext cx="371475"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9" name="Gerader Verbinder 38">
              <a:extLst>
                <a:ext uri="{FF2B5EF4-FFF2-40B4-BE49-F238E27FC236}">
                  <a16:creationId xmlns:a16="http://schemas.microsoft.com/office/drawing/2014/main" id="{17D05983-CFF4-4280-96BC-A6F90A8AC9BA}"/>
                </a:ext>
              </a:extLst>
            </p:cNvPr>
            <p:cNvCxnSpPr>
              <a:cxnSpLocks/>
            </p:cNvCxnSpPr>
            <p:nvPr/>
          </p:nvCxnSpPr>
          <p:spPr>
            <a:xfrm>
              <a:off x="8708986" y="4624841"/>
              <a:ext cx="371475"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40" name="Freihandform: Form 39">
              <a:extLst>
                <a:ext uri="{FF2B5EF4-FFF2-40B4-BE49-F238E27FC236}">
                  <a16:creationId xmlns:a16="http://schemas.microsoft.com/office/drawing/2014/main" id="{50559A6E-F769-4C1A-8114-635763936513}"/>
                </a:ext>
              </a:extLst>
            </p:cNvPr>
            <p:cNvSpPr/>
            <p:nvPr/>
          </p:nvSpPr>
          <p:spPr>
            <a:xfrm>
              <a:off x="7265525" y="1280461"/>
              <a:ext cx="1958975" cy="510766"/>
            </a:xfrm>
            <a:custGeom>
              <a:avLst/>
              <a:gdLst>
                <a:gd name="connsiteX0" fmla="*/ 0 w 1958975"/>
                <a:gd name="connsiteY0" fmla="*/ 63091 h 510766"/>
                <a:gd name="connsiteX1" fmla="*/ 114300 w 1958975"/>
                <a:gd name="connsiteY1" fmla="*/ 2766 h 510766"/>
                <a:gd name="connsiteX2" fmla="*/ 234950 w 1958975"/>
                <a:gd name="connsiteY2" fmla="*/ 12291 h 510766"/>
                <a:gd name="connsiteX3" fmla="*/ 307975 w 1958975"/>
                <a:gd name="connsiteY3" fmla="*/ 31341 h 510766"/>
                <a:gd name="connsiteX4" fmla="*/ 444500 w 1958975"/>
                <a:gd name="connsiteY4" fmla="*/ 2766 h 510766"/>
                <a:gd name="connsiteX5" fmla="*/ 555625 w 1958975"/>
                <a:gd name="connsiteY5" fmla="*/ 31341 h 510766"/>
                <a:gd name="connsiteX6" fmla="*/ 669925 w 1958975"/>
                <a:gd name="connsiteY6" fmla="*/ 9116 h 510766"/>
                <a:gd name="connsiteX7" fmla="*/ 892175 w 1958975"/>
                <a:gd name="connsiteY7" fmla="*/ 28166 h 510766"/>
                <a:gd name="connsiteX8" fmla="*/ 1025525 w 1958975"/>
                <a:gd name="connsiteY8" fmla="*/ 72616 h 510766"/>
                <a:gd name="connsiteX9" fmla="*/ 1168400 w 1958975"/>
                <a:gd name="connsiteY9" fmla="*/ 107541 h 510766"/>
                <a:gd name="connsiteX10" fmla="*/ 1304925 w 1958975"/>
                <a:gd name="connsiteY10" fmla="*/ 177391 h 510766"/>
                <a:gd name="connsiteX11" fmla="*/ 1463675 w 1958975"/>
                <a:gd name="connsiteY11" fmla="*/ 237716 h 510766"/>
                <a:gd name="connsiteX12" fmla="*/ 1568450 w 1958975"/>
                <a:gd name="connsiteY12" fmla="*/ 237716 h 510766"/>
                <a:gd name="connsiteX13" fmla="*/ 1628775 w 1958975"/>
                <a:gd name="connsiteY13" fmla="*/ 301216 h 510766"/>
                <a:gd name="connsiteX14" fmla="*/ 1724025 w 1958975"/>
                <a:gd name="connsiteY14" fmla="*/ 253591 h 510766"/>
                <a:gd name="connsiteX15" fmla="*/ 1825625 w 1958975"/>
                <a:gd name="connsiteY15" fmla="*/ 320266 h 510766"/>
                <a:gd name="connsiteX16" fmla="*/ 1911350 w 1958975"/>
                <a:gd name="connsiteY16" fmla="*/ 434566 h 510766"/>
                <a:gd name="connsiteX17" fmla="*/ 1958975 w 1958975"/>
                <a:gd name="connsiteY17" fmla="*/ 510766 h 5107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1958975" h="510766">
                  <a:moveTo>
                    <a:pt x="0" y="63091"/>
                  </a:moveTo>
                  <a:cubicBezTo>
                    <a:pt x="37571" y="37162"/>
                    <a:pt x="75142" y="11233"/>
                    <a:pt x="114300" y="2766"/>
                  </a:cubicBezTo>
                  <a:cubicBezTo>
                    <a:pt x="153458" y="-5701"/>
                    <a:pt x="202671" y="7528"/>
                    <a:pt x="234950" y="12291"/>
                  </a:cubicBezTo>
                  <a:cubicBezTo>
                    <a:pt x="267229" y="17053"/>
                    <a:pt x="273050" y="32929"/>
                    <a:pt x="307975" y="31341"/>
                  </a:cubicBezTo>
                  <a:cubicBezTo>
                    <a:pt x="342900" y="29753"/>
                    <a:pt x="403225" y="2766"/>
                    <a:pt x="444500" y="2766"/>
                  </a:cubicBezTo>
                  <a:cubicBezTo>
                    <a:pt x="485775" y="2766"/>
                    <a:pt x="518054" y="30283"/>
                    <a:pt x="555625" y="31341"/>
                  </a:cubicBezTo>
                  <a:cubicBezTo>
                    <a:pt x="593196" y="32399"/>
                    <a:pt x="613833" y="9645"/>
                    <a:pt x="669925" y="9116"/>
                  </a:cubicBezTo>
                  <a:cubicBezTo>
                    <a:pt x="726017" y="8587"/>
                    <a:pt x="832908" y="17583"/>
                    <a:pt x="892175" y="28166"/>
                  </a:cubicBezTo>
                  <a:cubicBezTo>
                    <a:pt x="951442" y="38749"/>
                    <a:pt x="979487" y="59387"/>
                    <a:pt x="1025525" y="72616"/>
                  </a:cubicBezTo>
                  <a:cubicBezTo>
                    <a:pt x="1071563" y="85845"/>
                    <a:pt x="1121833" y="90078"/>
                    <a:pt x="1168400" y="107541"/>
                  </a:cubicBezTo>
                  <a:cubicBezTo>
                    <a:pt x="1214967" y="125004"/>
                    <a:pt x="1255713" y="155695"/>
                    <a:pt x="1304925" y="177391"/>
                  </a:cubicBezTo>
                  <a:cubicBezTo>
                    <a:pt x="1354137" y="199087"/>
                    <a:pt x="1419754" y="227662"/>
                    <a:pt x="1463675" y="237716"/>
                  </a:cubicBezTo>
                  <a:cubicBezTo>
                    <a:pt x="1507596" y="247770"/>
                    <a:pt x="1540933" y="227133"/>
                    <a:pt x="1568450" y="237716"/>
                  </a:cubicBezTo>
                  <a:cubicBezTo>
                    <a:pt x="1595967" y="248299"/>
                    <a:pt x="1602846" y="298570"/>
                    <a:pt x="1628775" y="301216"/>
                  </a:cubicBezTo>
                  <a:cubicBezTo>
                    <a:pt x="1654704" y="303862"/>
                    <a:pt x="1691217" y="250416"/>
                    <a:pt x="1724025" y="253591"/>
                  </a:cubicBezTo>
                  <a:cubicBezTo>
                    <a:pt x="1756833" y="256766"/>
                    <a:pt x="1794404" y="290104"/>
                    <a:pt x="1825625" y="320266"/>
                  </a:cubicBezTo>
                  <a:cubicBezTo>
                    <a:pt x="1856846" y="350428"/>
                    <a:pt x="1889125" y="402816"/>
                    <a:pt x="1911350" y="434566"/>
                  </a:cubicBezTo>
                  <a:cubicBezTo>
                    <a:pt x="1933575" y="466316"/>
                    <a:pt x="1946275" y="488541"/>
                    <a:pt x="1958975" y="510766"/>
                  </a:cubicBezTo>
                </a:path>
              </a:pathLst>
            </a:custGeom>
            <a:noFill/>
            <a:ln>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1" name="Freihandform: Form 40">
              <a:extLst>
                <a:ext uri="{FF2B5EF4-FFF2-40B4-BE49-F238E27FC236}">
                  <a16:creationId xmlns:a16="http://schemas.microsoft.com/office/drawing/2014/main" id="{FCAC801E-AFD6-4DD6-8917-9D6FA19F0739}"/>
                </a:ext>
              </a:extLst>
            </p:cNvPr>
            <p:cNvSpPr/>
            <p:nvPr/>
          </p:nvSpPr>
          <p:spPr>
            <a:xfrm>
              <a:off x="7011525" y="3238160"/>
              <a:ext cx="2114550" cy="1498600"/>
            </a:xfrm>
            <a:custGeom>
              <a:avLst/>
              <a:gdLst>
                <a:gd name="connsiteX0" fmla="*/ 0 w 2114550"/>
                <a:gd name="connsiteY0" fmla="*/ 0 h 1498600"/>
                <a:gd name="connsiteX1" fmla="*/ 82550 w 2114550"/>
                <a:gd name="connsiteY1" fmla="*/ 34925 h 1498600"/>
                <a:gd name="connsiteX2" fmla="*/ 139700 w 2114550"/>
                <a:gd name="connsiteY2" fmla="*/ 34925 h 1498600"/>
                <a:gd name="connsiteX3" fmla="*/ 200025 w 2114550"/>
                <a:gd name="connsiteY3" fmla="*/ 69850 h 1498600"/>
                <a:gd name="connsiteX4" fmla="*/ 254000 w 2114550"/>
                <a:gd name="connsiteY4" fmla="*/ 47625 h 1498600"/>
                <a:gd name="connsiteX5" fmla="*/ 387350 w 2114550"/>
                <a:gd name="connsiteY5" fmla="*/ 38100 h 1498600"/>
                <a:gd name="connsiteX6" fmla="*/ 422275 w 2114550"/>
                <a:gd name="connsiteY6" fmla="*/ 57150 h 1498600"/>
                <a:gd name="connsiteX7" fmla="*/ 501650 w 2114550"/>
                <a:gd name="connsiteY7" fmla="*/ 41275 h 1498600"/>
                <a:gd name="connsiteX8" fmla="*/ 577850 w 2114550"/>
                <a:gd name="connsiteY8" fmla="*/ 44450 h 1498600"/>
                <a:gd name="connsiteX9" fmla="*/ 644525 w 2114550"/>
                <a:gd name="connsiteY9" fmla="*/ 63500 h 1498600"/>
                <a:gd name="connsiteX10" fmla="*/ 727075 w 2114550"/>
                <a:gd name="connsiteY10" fmla="*/ 60325 h 1498600"/>
                <a:gd name="connsiteX11" fmla="*/ 796925 w 2114550"/>
                <a:gd name="connsiteY11" fmla="*/ 88900 h 1498600"/>
                <a:gd name="connsiteX12" fmla="*/ 879475 w 2114550"/>
                <a:gd name="connsiteY12" fmla="*/ 92075 h 1498600"/>
                <a:gd name="connsiteX13" fmla="*/ 955675 w 2114550"/>
                <a:gd name="connsiteY13" fmla="*/ 101600 h 1498600"/>
                <a:gd name="connsiteX14" fmla="*/ 1028700 w 2114550"/>
                <a:gd name="connsiteY14" fmla="*/ 101600 h 1498600"/>
                <a:gd name="connsiteX15" fmla="*/ 1104900 w 2114550"/>
                <a:gd name="connsiteY15" fmla="*/ 158750 h 1498600"/>
                <a:gd name="connsiteX16" fmla="*/ 1123950 w 2114550"/>
                <a:gd name="connsiteY16" fmla="*/ 165100 h 1498600"/>
                <a:gd name="connsiteX17" fmla="*/ 1181100 w 2114550"/>
                <a:gd name="connsiteY17" fmla="*/ 158750 h 1498600"/>
                <a:gd name="connsiteX18" fmla="*/ 1219200 w 2114550"/>
                <a:gd name="connsiteY18" fmla="*/ 196850 h 1498600"/>
                <a:gd name="connsiteX19" fmla="*/ 1343025 w 2114550"/>
                <a:gd name="connsiteY19" fmla="*/ 174625 h 1498600"/>
                <a:gd name="connsiteX20" fmla="*/ 1358900 w 2114550"/>
                <a:gd name="connsiteY20" fmla="*/ 149225 h 1498600"/>
                <a:gd name="connsiteX21" fmla="*/ 1447800 w 2114550"/>
                <a:gd name="connsiteY21" fmla="*/ 146050 h 1498600"/>
                <a:gd name="connsiteX22" fmla="*/ 1520825 w 2114550"/>
                <a:gd name="connsiteY22" fmla="*/ 171450 h 1498600"/>
                <a:gd name="connsiteX23" fmla="*/ 1638300 w 2114550"/>
                <a:gd name="connsiteY23" fmla="*/ 254000 h 1498600"/>
                <a:gd name="connsiteX24" fmla="*/ 1727200 w 2114550"/>
                <a:gd name="connsiteY24" fmla="*/ 311150 h 1498600"/>
                <a:gd name="connsiteX25" fmla="*/ 1768475 w 2114550"/>
                <a:gd name="connsiteY25" fmla="*/ 323850 h 1498600"/>
                <a:gd name="connsiteX26" fmla="*/ 1819275 w 2114550"/>
                <a:gd name="connsiteY26" fmla="*/ 422275 h 1498600"/>
                <a:gd name="connsiteX27" fmla="*/ 1876425 w 2114550"/>
                <a:gd name="connsiteY27" fmla="*/ 469900 h 1498600"/>
                <a:gd name="connsiteX28" fmla="*/ 1920875 w 2114550"/>
                <a:gd name="connsiteY28" fmla="*/ 546100 h 1498600"/>
                <a:gd name="connsiteX29" fmla="*/ 1978025 w 2114550"/>
                <a:gd name="connsiteY29" fmla="*/ 574675 h 1498600"/>
                <a:gd name="connsiteX30" fmla="*/ 2092325 w 2114550"/>
                <a:gd name="connsiteY30" fmla="*/ 609600 h 1498600"/>
                <a:gd name="connsiteX31" fmla="*/ 2082800 w 2114550"/>
                <a:gd name="connsiteY31" fmla="*/ 704850 h 1498600"/>
                <a:gd name="connsiteX32" fmla="*/ 2041525 w 2114550"/>
                <a:gd name="connsiteY32" fmla="*/ 774700 h 1498600"/>
                <a:gd name="connsiteX33" fmla="*/ 2044700 w 2114550"/>
                <a:gd name="connsiteY33" fmla="*/ 815975 h 1498600"/>
                <a:gd name="connsiteX34" fmla="*/ 2060575 w 2114550"/>
                <a:gd name="connsiteY34" fmla="*/ 860425 h 1498600"/>
                <a:gd name="connsiteX35" fmla="*/ 2022475 w 2114550"/>
                <a:gd name="connsiteY35" fmla="*/ 927100 h 1498600"/>
                <a:gd name="connsiteX36" fmla="*/ 2073275 w 2114550"/>
                <a:gd name="connsiteY36" fmla="*/ 990600 h 1498600"/>
                <a:gd name="connsiteX37" fmla="*/ 2114550 w 2114550"/>
                <a:gd name="connsiteY37" fmla="*/ 1044575 h 1498600"/>
                <a:gd name="connsiteX38" fmla="*/ 2073275 w 2114550"/>
                <a:gd name="connsiteY38" fmla="*/ 1117600 h 1498600"/>
                <a:gd name="connsiteX39" fmla="*/ 2009775 w 2114550"/>
                <a:gd name="connsiteY39" fmla="*/ 1165225 h 1498600"/>
                <a:gd name="connsiteX40" fmla="*/ 1949450 w 2114550"/>
                <a:gd name="connsiteY40" fmla="*/ 1174750 h 1498600"/>
                <a:gd name="connsiteX41" fmla="*/ 1927225 w 2114550"/>
                <a:gd name="connsiteY41" fmla="*/ 1200150 h 1498600"/>
                <a:gd name="connsiteX42" fmla="*/ 1958975 w 2114550"/>
                <a:gd name="connsiteY42" fmla="*/ 1231900 h 1498600"/>
                <a:gd name="connsiteX43" fmla="*/ 1949450 w 2114550"/>
                <a:gd name="connsiteY43" fmla="*/ 1282700 h 1498600"/>
                <a:gd name="connsiteX44" fmla="*/ 1962150 w 2114550"/>
                <a:gd name="connsiteY44" fmla="*/ 1314450 h 1498600"/>
                <a:gd name="connsiteX45" fmla="*/ 1876425 w 2114550"/>
                <a:gd name="connsiteY45" fmla="*/ 1346200 h 1498600"/>
                <a:gd name="connsiteX46" fmla="*/ 1838325 w 2114550"/>
                <a:gd name="connsiteY46" fmla="*/ 1377950 h 1498600"/>
                <a:gd name="connsiteX47" fmla="*/ 1765300 w 2114550"/>
                <a:gd name="connsiteY47" fmla="*/ 1412875 h 1498600"/>
                <a:gd name="connsiteX48" fmla="*/ 1758950 w 2114550"/>
                <a:gd name="connsiteY48" fmla="*/ 1438275 h 1498600"/>
                <a:gd name="connsiteX49" fmla="*/ 1787525 w 2114550"/>
                <a:gd name="connsiteY49" fmla="*/ 1479550 h 1498600"/>
                <a:gd name="connsiteX50" fmla="*/ 1797050 w 2114550"/>
                <a:gd name="connsiteY50" fmla="*/ 1498600 h 1498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Lst>
              <a:rect l="l" t="t" r="r" b="b"/>
              <a:pathLst>
                <a:path w="2114550" h="1498600">
                  <a:moveTo>
                    <a:pt x="0" y="0"/>
                  </a:moveTo>
                  <a:cubicBezTo>
                    <a:pt x="29633" y="14552"/>
                    <a:pt x="59267" y="29104"/>
                    <a:pt x="82550" y="34925"/>
                  </a:cubicBezTo>
                  <a:cubicBezTo>
                    <a:pt x="105833" y="40746"/>
                    <a:pt x="120121" y="29104"/>
                    <a:pt x="139700" y="34925"/>
                  </a:cubicBezTo>
                  <a:cubicBezTo>
                    <a:pt x="159279" y="40746"/>
                    <a:pt x="180975" y="67733"/>
                    <a:pt x="200025" y="69850"/>
                  </a:cubicBezTo>
                  <a:cubicBezTo>
                    <a:pt x="219075" y="71967"/>
                    <a:pt x="222779" y="52917"/>
                    <a:pt x="254000" y="47625"/>
                  </a:cubicBezTo>
                  <a:cubicBezTo>
                    <a:pt x="285221" y="42333"/>
                    <a:pt x="359304" y="36513"/>
                    <a:pt x="387350" y="38100"/>
                  </a:cubicBezTo>
                  <a:cubicBezTo>
                    <a:pt x="415396" y="39687"/>
                    <a:pt x="403225" y="56621"/>
                    <a:pt x="422275" y="57150"/>
                  </a:cubicBezTo>
                  <a:cubicBezTo>
                    <a:pt x="441325" y="57679"/>
                    <a:pt x="475721" y="43392"/>
                    <a:pt x="501650" y="41275"/>
                  </a:cubicBezTo>
                  <a:cubicBezTo>
                    <a:pt x="527579" y="39158"/>
                    <a:pt x="554038" y="40746"/>
                    <a:pt x="577850" y="44450"/>
                  </a:cubicBezTo>
                  <a:cubicBezTo>
                    <a:pt x="601663" y="48154"/>
                    <a:pt x="619654" y="60854"/>
                    <a:pt x="644525" y="63500"/>
                  </a:cubicBezTo>
                  <a:cubicBezTo>
                    <a:pt x="669396" y="66146"/>
                    <a:pt x="701675" y="56092"/>
                    <a:pt x="727075" y="60325"/>
                  </a:cubicBezTo>
                  <a:cubicBezTo>
                    <a:pt x="752475" y="64558"/>
                    <a:pt x="771525" y="83608"/>
                    <a:pt x="796925" y="88900"/>
                  </a:cubicBezTo>
                  <a:cubicBezTo>
                    <a:pt x="822325" y="94192"/>
                    <a:pt x="853017" y="89958"/>
                    <a:pt x="879475" y="92075"/>
                  </a:cubicBezTo>
                  <a:cubicBezTo>
                    <a:pt x="905933" y="94192"/>
                    <a:pt x="930804" y="100013"/>
                    <a:pt x="955675" y="101600"/>
                  </a:cubicBezTo>
                  <a:cubicBezTo>
                    <a:pt x="980546" y="103188"/>
                    <a:pt x="1003829" y="92075"/>
                    <a:pt x="1028700" y="101600"/>
                  </a:cubicBezTo>
                  <a:cubicBezTo>
                    <a:pt x="1053571" y="111125"/>
                    <a:pt x="1089025" y="148167"/>
                    <a:pt x="1104900" y="158750"/>
                  </a:cubicBezTo>
                  <a:cubicBezTo>
                    <a:pt x="1120775" y="169333"/>
                    <a:pt x="1111250" y="165100"/>
                    <a:pt x="1123950" y="165100"/>
                  </a:cubicBezTo>
                  <a:cubicBezTo>
                    <a:pt x="1136650" y="165100"/>
                    <a:pt x="1165225" y="153458"/>
                    <a:pt x="1181100" y="158750"/>
                  </a:cubicBezTo>
                  <a:cubicBezTo>
                    <a:pt x="1196975" y="164042"/>
                    <a:pt x="1192213" y="194204"/>
                    <a:pt x="1219200" y="196850"/>
                  </a:cubicBezTo>
                  <a:cubicBezTo>
                    <a:pt x="1246188" y="199496"/>
                    <a:pt x="1319742" y="182563"/>
                    <a:pt x="1343025" y="174625"/>
                  </a:cubicBezTo>
                  <a:cubicBezTo>
                    <a:pt x="1366308" y="166688"/>
                    <a:pt x="1341437" y="153988"/>
                    <a:pt x="1358900" y="149225"/>
                  </a:cubicBezTo>
                  <a:cubicBezTo>
                    <a:pt x="1376363" y="144462"/>
                    <a:pt x="1420813" y="142346"/>
                    <a:pt x="1447800" y="146050"/>
                  </a:cubicBezTo>
                  <a:cubicBezTo>
                    <a:pt x="1474787" y="149754"/>
                    <a:pt x="1489075" y="153458"/>
                    <a:pt x="1520825" y="171450"/>
                  </a:cubicBezTo>
                  <a:cubicBezTo>
                    <a:pt x="1552575" y="189442"/>
                    <a:pt x="1603904" y="230717"/>
                    <a:pt x="1638300" y="254000"/>
                  </a:cubicBezTo>
                  <a:cubicBezTo>
                    <a:pt x="1672696" y="277283"/>
                    <a:pt x="1705504" y="299508"/>
                    <a:pt x="1727200" y="311150"/>
                  </a:cubicBezTo>
                  <a:cubicBezTo>
                    <a:pt x="1748896" y="322792"/>
                    <a:pt x="1753129" y="305329"/>
                    <a:pt x="1768475" y="323850"/>
                  </a:cubicBezTo>
                  <a:cubicBezTo>
                    <a:pt x="1783821" y="342371"/>
                    <a:pt x="1801283" y="397933"/>
                    <a:pt x="1819275" y="422275"/>
                  </a:cubicBezTo>
                  <a:cubicBezTo>
                    <a:pt x="1837267" y="446617"/>
                    <a:pt x="1859492" y="449263"/>
                    <a:pt x="1876425" y="469900"/>
                  </a:cubicBezTo>
                  <a:cubicBezTo>
                    <a:pt x="1893358" y="490538"/>
                    <a:pt x="1903942" y="528638"/>
                    <a:pt x="1920875" y="546100"/>
                  </a:cubicBezTo>
                  <a:cubicBezTo>
                    <a:pt x="1937808" y="563562"/>
                    <a:pt x="1949450" y="564092"/>
                    <a:pt x="1978025" y="574675"/>
                  </a:cubicBezTo>
                  <a:cubicBezTo>
                    <a:pt x="2006600" y="585258"/>
                    <a:pt x="2074863" y="587904"/>
                    <a:pt x="2092325" y="609600"/>
                  </a:cubicBezTo>
                  <a:cubicBezTo>
                    <a:pt x="2109787" y="631296"/>
                    <a:pt x="2091267" y="677333"/>
                    <a:pt x="2082800" y="704850"/>
                  </a:cubicBezTo>
                  <a:cubicBezTo>
                    <a:pt x="2074333" y="732367"/>
                    <a:pt x="2047875" y="756179"/>
                    <a:pt x="2041525" y="774700"/>
                  </a:cubicBezTo>
                  <a:cubicBezTo>
                    <a:pt x="2035175" y="793221"/>
                    <a:pt x="2041525" y="801688"/>
                    <a:pt x="2044700" y="815975"/>
                  </a:cubicBezTo>
                  <a:cubicBezTo>
                    <a:pt x="2047875" y="830262"/>
                    <a:pt x="2064279" y="841904"/>
                    <a:pt x="2060575" y="860425"/>
                  </a:cubicBezTo>
                  <a:cubicBezTo>
                    <a:pt x="2056871" y="878946"/>
                    <a:pt x="2020358" y="905404"/>
                    <a:pt x="2022475" y="927100"/>
                  </a:cubicBezTo>
                  <a:cubicBezTo>
                    <a:pt x="2024592" y="948796"/>
                    <a:pt x="2057929" y="971021"/>
                    <a:pt x="2073275" y="990600"/>
                  </a:cubicBezTo>
                  <a:cubicBezTo>
                    <a:pt x="2088621" y="1010179"/>
                    <a:pt x="2114550" y="1023408"/>
                    <a:pt x="2114550" y="1044575"/>
                  </a:cubicBezTo>
                  <a:cubicBezTo>
                    <a:pt x="2114550" y="1065742"/>
                    <a:pt x="2090737" y="1097492"/>
                    <a:pt x="2073275" y="1117600"/>
                  </a:cubicBezTo>
                  <a:cubicBezTo>
                    <a:pt x="2055813" y="1137708"/>
                    <a:pt x="2030412" y="1155700"/>
                    <a:pt x="2009775" y="1165225"/>
                  </a:cubicBezTo>
                  <a:cubicBezTo>
                    <a:pt x="1989138" y="1174750"/>
                    <a:pt x="1963208" y="1168929"/>
                    <a:pt x="1949450" y="1174750"/>
                  </a:cubicBezTo>
                  <a:cubicBezTo>
                    <a:pt x="1935692" y="1180571"/>
                    <a:pt x="1925638" y="1190625"/>
                    <a:pt x="1927225" y="1200150"/>
                  </a:cubicBezTo>
                  <a:cubicBezTo>
                    <a:pt x="1928813" y="1209675"/>
                    <a:pt x="1955271" y="1218142"/>
                    <a:pt x="1958975" y="1231900"/>
                  </a:cubicBezTo>
                  <a:cubicBezTo>
                    <a:pt x="1962679" y="1245658"/>
                    <a:pt x="1948921" y="1268942"/>
                    <a:pt x="1949450" y="1282700"/>
                  </a:cubicBezTo>
                  <a:cubicBezTo>
                    <a:pt x="1949979" y="1296458"/>
                    <a:pt x="1974321" y="1303867"/>
                    <a:pt x="1962150" y="1314450"/>
                  </a:cubicBezTo>
                  <a:cubicBezTo>
                    <a:pt x="1949979" y="1325033"/>
                    <a:pt x="1897063" y="1335617"/>
                    <a:pt x="1876425" y="1346200"/>
                  </a:cubicBezTo>
                  <a:cubicBezTo>
                    <a:pt x="1855788" y="1356783"/>
                    <a:pt x="1856846" y="1366838"/>
                    <a:pt x="1838325" y="1377950"/>
                  </a:cubicBezTo>
                  <a:cubicBezTo>
                    <a:pt x="1819804" y="1389063"/>
                    <a:pt x="1778529" y="1402821"/>
                    <a:pt x="1765300" y="1412875"/>
                  </a:cubicBezTo>
                  <a:cubicBezTo>
                    <a:pt x="1752071" y="1422929"/>
                    <a:pt x="1755246" y="1427163"/>
                    <a:pt x="1758950" y="1438275"/>
                  </a:cubicBezTo>
                  <a:cubicBezTo>
                    <a:pt x="1762654" y="1449387"/>
                    <a:pt x="1781175" y="1469496"/>
                    <a:pt x="1787525" y="1479550"/>
                  </a:cubicBezTo>
                  <a:cubicBezTo>
                    <a:pt x="1793875" y="1489604"/>
                    <a:pt x="1795462" y="1494102"/>
                    <a:pt x="1797050" y="1498600"/>
                  </a:cubicBezTo>
                </a:path>
              </a:pathLst>
            </a:custGeom>
            <a:noFill/>
            <a:ln>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2" name="Freihandform: Form 41">
              <a:extLst>
                <a:ext uri="{FF2B5EF4-FFF2-40B4-BE49-F238E27FC236}">
                  <a16:creationId xmlns:a16="http://schemas.microsoft.com/office/drawing/2014/main" id="{2A6B08C3-AD9A-417E-99F9-55676619A34E}"/>
                </a:ext>
              </a:extLst>
            </p:cNvPr>
            <p:cNvSpPr/>
            <p:nvPr/>
          </p:nvSpPr>
          <p:spPr>
            <a:xfrm>
              <a:off x="6555119" y="1346727"/>
              <a:ext cx="714375" cy="127832"/>
            </a:xfrm>
            <a:custGeom>
              <a:avLst/>
              <a:gdLst>
                <a:gd name="connsiteX0" fmla="*/ 0 w 714375"/>
                <a:gd name="connsiteY0" fmla="*/ 121444 h 127832"/>
                <a:gd name="connsiteX1" fmla="*/ 119062 w 714375"/>
                <a:gd name="connsiteY1" fmla="*/ 119063 h 127832"/>
                <a:gd name="connsiteX2" fmla="*/ 176212 w 714375"/>
                <a:gd name="connsiteY2" fmla="*/ 123825 h 127832"/>
                <a:gd name="connsiteX3" fmla="*/ 247650 w 714375"/>
                <a:gd name="connsiteY3" fmla="*/ 52388 h 127832"/>
                <a:gd name="connsiteX4" fmla="*/ 385762 w 714375"/>
                <a:gd name="connsiteY4" fmla="*/ 64294 h 127832"/>
                <a:gd name="connsiteX5" fmla="*/ 395287 w 714375"/>
                <a:gd name="connsiteY5" fmla="*/ 14288 h 127832"/>
                <a:gd name="connsiteX6" fmla="*/ 492919 w 714375"/>
                <a:gd name="connsiteY6" fmla="*/ 50006 h 127832"/>
                <a:gd name="connsiteX7" fmla="*/ 521494 w 714375"/>
                <a:gd name="connsiteY7" fmla="*/ 4763 h 127832"/>
                <a:gd name="connsiteX8" fmla="*/ 626269 w 714375"/>
                <a:gd name="connsiteY8" fmla="*/ 52388 h 127832"/>
                <a:gd name="connsiteX9" fmla="*/ 695325 w 714375"/>
                <a:gd name="connsiteY9" fmla="*/ 38100 h 127832"/>
                <a:gd name="connsiteX10" fmla="*/ 714375 w 714375"/>
                <a:gd name="connsiteY10" fmla="*/ 0 h 12783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4375" h="127832">
                  <a:moveTo>
                    <a:pt x="0" y="121444"/>
                  </a:moveTo>
                  <a:cubicBezTo>
                    <a:pt x="44846" y="120055"/>
                    <a:pt x="89693" y="118666"/>
                    <a:pt x="119062" y="119063"/>
                  </a:cubicBezTo>
                  <a:cubicBezTo>
                    <a:pt x="148431" y="119460"/>
                    <a:pt x="154781" y="134937"/>
                    <a:pt x="176212" y="123825"/>
                  </a:cubicBezTo>
                  <a:cubicBezTo>
                    <a:pt x="197643" y="112713"/>
                    <a:pt x="212725" y="62310"/>
                    <a:pt x="247650" y="52388"/>
                  </a:cubicBezTo>
                  <a:cubicBezTo>
                    <a:pt x="282575" y="42466"/>
                    <a:pt x="361156" y="70644"/>
                    <a:pt x="385762" y="64294"/>
                  </a:cubicBezTo>
                  <a:cubicBezTo>
                    <a:pt x="410368" y="57944"/>
                    <a:pt x="377428" y="16669"/>
                    <a:pt x="395287" y="14288"/>
                  </a:cubicBezTo>
                  <a:cubicBezTo>
                    <a:pt x="413147" y="11907"/>
                    <a:pt x="471885" y="51593"/>
                    <a:pt x="492919" y="50006"/>
                  </a:cubicBezTo>
                  <a:cubicBezTo>
                    <a:pt x="513953" y="48419"/>
                    <a:pt x="499269" y="4366"/>
                    <a:pt x="521494" y="4763"/>
                  </a:cubicBezTo>
                  <a:cubicBezTo>
                    <a:pt x="543719" y="5160"/>
                    <a:pt x="597297" y="46832"/>
                    <a:pt x="626269" y="52388"/>
                  </a:cubicBezTo>
                  <a:cubicBezTo>
                    <a:pt x="655241" y="57944"/>
                    <a:pt x="680641" y="46831"/>
                    <a:pt x="695325" y="38100"/>
                  </a:cubicBezTo>
                  <a:cubicBezTo>
                    <a:pt x="710009" y="29369"/>
                    <a:pt x="712192" y="14684"/>
                    <a:pt x="714375" y="0"/>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3" name="Freihandform: Form 42">
              <a:extLst>
                <a:ext uri="{FF2B5EF4-FFF2-40B4-BE49-F238E27FC236}">
                  <a16:creationId xmlns:a16="http://schemas.microsoft.com/office/drawing/2014/main" id="{121504F7-ACF0-4788-81A8-2C88059D1D14}"/>
                </a:ext>
              </a:extLst>
            </p:cNvPr>
            <p:cNvSpPr/>
            <p:nvPr/>
          </p:nvSpPr>
          <p:spPr>
            <a:xfrm>
              <a:off x="6547975" y="3239187"/>
              <a:ext cx="466725" cy="130735"/>
            </a:xfrm>
            <a:custGeom>
              <a:avLst/>
              <a:gdLst>
                <a:gd name="connsiteX0" fmla="*/ 0 w 466725"/>
                <a:gd name="connsiteY0" fmla="*/ 128354 h 130735"/>
                <a:gd name="connsiteX1" fmla="*/ 52388 w 466725"/>
                <a:gd name="connsiteY1" fmla="*/ 125973 h 130735"/>
                <a:gd name="connsiteX2" fmla="*/ 159544 w 466725"/>
                <a:gd name="connsiteY2" fmla="*/ 85492 h 130735"/>
                <a:gd name="connsiteX3" fmla="*/ 230981 w 466725"/>
                <a:gd name="connsiteY3" fmla="*/ 90254 h 130735"/>
                <a:gd name="connsiteX4" fmla="*/ 278606 w 466725"/>
                <a:gd name="connsiteY4" fmla="*/ 73586 h 130735"/>
                <a:gd name="connsiteX5" fmla="*/ 340519 w 466725"/>
                <a:gd name="connsiteY5" fmla="*/ 75967 h 130735"/>
                <a:gd name="connsiteX6" fmla="*/ 404813 w 466725"/>
                <a:gd name="connsiteY6" fmla="*/ 9292 h 130735"/>
                <a:gd name="connsiteX7" fmla="*/ 466725 w 466725"/>
                <a:gd name="connsiteY7" fmla="*/ 2148 h 1307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466725" h="130735">
                  <a:moveTo>
                    <a:pt x="0" y="128354"/>
                  </a:moveTo>
                  <a:cubicBezTo>
                    <a:pt x="12898" y="130735"/>
                    <a:pt x="25797" y="133117"/>
                    <a:pt x="52388" y="125973"/>
                  </a:cubicBezTo>
                  <a:cubicBezTo>
                    <a:pt x="78979" y="118829"/>
                    <a:pt x="129779" y="91445"/>
                    <a:pt x="159544" y="85492"/>
                  </a:cubicBezTo>
                  <a:cubicBezTo>
                    <a:pt x="189310" y="79539"/>
                    <a:pt x="211137" y="92238"/>
                    <a:pt x="230981" y="90254"/>
                  </a:cubicBezTo>
                  <a:cubicBezTo>
                    <a:pt x="250825" y="88270"/>
                    <a:pt x="260350" y="75967"/>
                    <a:pt x="278606" y="73586"/>
                  </a:cubicBezTo>
                  <a:cubicBezTo>
                    <a:pt x="296862" y="71205"/>
                    <a:pt x="319484" y="86683"/>
                    <a:pt x="340519" y="75967"/>
                  </a:cubicBezTo>
                  <a:cubicBezTo>
                    <a:pt x="361554" y="65251"/>
                    <a:pt x="383779" y="21595"/>
                    <a:pt x="404813" y="9292"/>
                  </a:cubicBezTo>
                  <a:cubicBezTo>
                    <a:pt x="425847" y="-3011"/>
                    <a:pt x="446286" y="-432"/>
                    <a:pt x="466725" y="2148"/>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44" name="Grafik 43">
              <a:extLst>
                <a:ext uri="{FF2B5EF4-FFF2-40B4-BE49-F238E27FC236}">
                  <a16:creationId xmlns:a16="http://schemas.microsoft.com/office/drawing/2014/main" id="{A972956A-6339-41DA-A810-77662D922B58}"/>
                </a:ext>
              </a:extLst>
            </p:cNvPr>
            <p:cNvPicPr>
              <a:picLocks noChangeAspect="1"/>
            </p:cNvPicPr>
            <p:nvPr/>
          </p:nvPicPr>
          <p:blipFill>
            <a:blip r:embed="rId13" cstate="hqprint">
              <a:extLst>
                <a:ext uri="{28A0092B-C50C-407E-A947-70E740481C1C}">
                  <a14:useLocalDpi xmlns:a14="http://schemas.microsoft.com/office/drawing/2010/main"/>
                </a:ext>
              </a:extLst>
            </a:blip>
            <a:stretch>
              <a:fillRect/>
            </a:stretch>
          </p:blipFill>
          <p:spPr>
            <a:xfrm>
              <a:off x="9309873" y="639755"/>
              <a:ext cx="2678378" cy="2016661"/>
            </a:xfrm>
            <a:prstGeom prst="rect">
              <a:avLst/>
            </a:prstGeom>
          </p:spPr>
        </p:pic>
        <p:pic>
          <p:nvPicPr>
            <p:cNvPr id="45" name="Grafik 44">
              <a:extLst>
                <a:ext uri="{FF2B5EF4-FFF2-40B4-BE49-F238E27FC236}">
                  <a16:creationId xmlns:a16="http://schemas.microsoft.com/office/drawing/2014/main" id="{77AD582A-0034-436D-AB24-622C9EBA5E0E}"/>
                </a:ext>
              </a:extLst>
            </p:cNvPr>
            <p:cNvPicPr>
              <a:picLocks noChangeAspect="1"/>
            </p:cNvPicPr>
            <p:nvPr/>
          </p:nvPicPr>
          <p:blipFill>
            <a:blip r:embed="rId14" cstate="hqprint">
              <a:extLst>
                <a:ext uri="{28A0092B-C50C-407E-A947-70E740481C1C}">
                  <a14:useLocalDpi xmlns:a14="http://schemas.microsoft.com/office/drawing/2010/main"/>
                </a:ext>
              </a:extLst>
            </a:blip>
            <a:stretch>
              <a:fillRect/>
            </a:stretch>
          </p:blipFill>
          <p:spPr>
            <a:xfrm>
              <a:off x="9309872" y="2703017"/>
              <a:ext cx="2678376" cy="2016660"/>
            </a:xfrm>
            <a:prstGeom prst="rect">
              <a:avLst/>
            </a:prstGeom>
          </p:spPr>
        </p:pic>
        <p:sp>
          <p:nvSpPr>
            <p:cNvPr id="46" name="Freihandform: Form 45">
              <a:extLst>
                <a:ext uri="{FF2B5EF4-FFF2-40B4-BE49-F238E27FC236}">
                  <a16:creationId xmlns:a16="http://schemas.microsoft.com/office/drawing/2014/main" id="{1E2C5883-73D3-4139-894D-80A98809FAB8}"/>
                </a:ext>
              </a:extLst>
            </p:cNvPr>
            <p:cNvSpPr/>
            <p:nvPr/>
          </p:nvSpPr>
          <p:spPr>
            <a:xfrm>
              <a:off x="9310058" y="990694"/>
              <a:ext cx="1948574" cy="1347501"/>
            </a:xfrm>
            <a:custGeom>
              <a:avLst/>
              <a:gdLst>
                <a:gd name="connsiteX0" fmla="*/ 0 w 1959029"/>
                <a:gd name="connsiteY0" fmla="*/ 235915 h 1374152"/>
                <a:gd name="connsiteX1" fmla="*/ 69056 w 1959029"/>
                <a:gd name="connsiteY1" fmla="*/ 221627 h 1374152"/>
                <a:gd name="connsiteX2" fmla="*/ 100012 w 1959029"/>
                <a:gd name="connsiteY2" fmla="*/ 202577 h 1374152"/>
                <a:gd name="connsiteX3" fmla="*/ 119062 w 1959029"/>
                <a:gd name="connsiteY3" fmla="*/ 212102 h 1374152"/>
                <a:gd name="connsiteX4" fmla="*/ 161925 w 1959029"/>
                <a:gd name="connsiteY4" fmla="*/ 200196 h 1374152"/>
                <a:gd name="connsiteX5" fmla="*/ 171450 w 1959029"/>
                <a:gd name="connsiteY5" fmla="*/ 247821 h 1374152"/>
                <a:gd name="connsiteX6" fmla="*/ 269081 w 1959029"/>
                <a:gd name="connsiteY6" fmla="*/ 247821 h 1374152"/>
                <a:gd name="connsiteX7" fmla="*/ 330993 w 1959029"/>
                <a:gd name="connsiteY7" fmla="*/ 188290 h 1374152"/>
                <a:gd name="connsiteX8" fmla="*/ 419100 w 1959029"/>
                <a:gd name="connsiteY8" fmla="*/ 176384 h 1374152"/>
                <a:gd name="connsiteX9" fmla="*/ 478631 w 1959029"/>
                <a:gd name="connsiteY9" fmla="*/ 164477 h 1374152"/>
                <a:gd name="connsiteX10" fmla="*/ 490537 w 1959029"/>
                <a:gd name="connsiteY10" fmla="*/ 123996 h 1374152"/>
                <a:gd name="connsiteX11" fmla="*/ 540543 w 1959029"/>
                <a:gd name="connsiteY11" fmla="*/ 93040 h 1374152"/>
                <a:gd name="connsiteX12" fmla="*/ 538162 w 1959029"/>
                <a:gd name="connsiteY12" fmla="*/ 78752 h 1374152"/>
                <a:gd name="connsiteX13" fmla="*/ 638175 w 1959029"/>
                <a:gd name="connsiteY13" fmla="*/ 19221 h 1374152"/>
                <a:gd name="connsiteX14" fmla="*/ 666750 w 1959029"/>
                <a:gd name="connsiteY14" fmla="*/ 2552 h 1374152"/>
                <a:gd name="connsiteX15" fmla="*/ 692943 w 1959029"/>
                <a:gd name="connsiteY15" fmla="*/ 14459 h 1374152"/>
                <a:gd name="connsiteX16" fmla="*/ 759618 w 1959029"/>
                <a:gd name="connsiteY16" fmla="*/ 171 h 1374152"/>
                <a:gd name="connsiteX17" fmla="*/ 835818 w 1959029"/>
                <a:gd name="connsiteY17" fmla="*/ 26365 h 1374152"/>
                <a:gd name="connsiteX18" fmla="*/ 831056 w 1959029"/>
                <a:gd name="connsiteY18" fmla="*/ 69227 h 1374152"/>
                <a:gd name="connsiteX19" fmla="*/ 878681 w 1959029"/>
                <a:gd name="connsiteY19" fmla="*/ 145427 h 1374152"/>
                <a:gd name="connsiteX20" fmla="*/ 907256 w 1959029"/>
                <a:gd name="connsiteY20" fmla="*/ 195434 h 1374152"/>
                <a:gd name="connsiteX21" fmla="*/ 954881 w 1959029"/>
                <a:gd name="connsiteY21" fmla="*/ 212102 h 1374152"/>
                <a:gd name="connsiteX22" fmla="*/ 1004887 w 1959029"/>
                <a:gd name="connsiteY22" fmla="*/ 262109 h 1374152"/>
                <a:gd name="connsiteX23" fmla="*/ 1097756 w 1959029"/>
                <a:gd name="connsiteY23" fmla="*/ 293065 h 1374152"/>
                <a:gd name="connsiteX24" fmla="*/ 1164431 w 1959029"/>
                <a:gd name="connsiteY24" fmla="*/ 288302 h 1374152"/>
                <a:gd name="connsiteX25" fmla="*/ 1266825 w 1959029"/>
                <a:gd name="connsiteY25" fmla="*/ 257346 h 1374152"/>
                <a:gd name="connsiteX26" fmla="*/ 1297781 w 1959029"/>
                <a:gd name="connsiteY26" fmla="*/ 195434 h 1374152"/>
                <a:gd name="connsiteX27" fmla="*/ 1340643 w 1959029"/>
                <a:gd name="connsiteY27" fmla="*/ 131140 h 1374152"/>
                <a:gd name="connsiteX28" fmla="*/ 1409700 w 1959029"/>
                <a:gd name="connsiteY28" fmla="*/ 157334 h 1374152"/>
                <a:gd name="connsiteX29" fmla="*/ 1412081 w 1959029"/>
                <a:gd name="connsiteY29" fmla="*/ 247821 h 1374152"/>
                <a:gd name="connsiteX30" fmla="*/ 1393031 w 1959029"/>
                <a:gd name="connsiteY30" fmla="*/ 328784 h 1374152"/>
                <a:gd name="connsiteX31" fmla="*/ 1383506 w 1959029"/>
                <a:gd name="connsiteY31" fmla="*/ 440702 h 1374152"/>
                <a:gd name="connsiteX32" fmla="*/ 1526381 w 1959029"/>
                <a:gd name="connsiteY32" fmla="*/ 533571 h 1374152"/>
                <a:gd name="connsiteX33" fmla="*/ 1631156 w 1959029"/>
                <a:gd name="connsiteY33" fmla="*/ 502615 h 1374152"/>
                <a:gd name="connsiteX34" fmla="*/ 1685925 w 1959029"/>
                <a:gd name="connsiteY34" fmla="*/ 616915 h 1374152"/>
                <a:gd name="connsiteX35" fmla="*/ 1764506 w 1959029"/>
                <a:gd name="connsiteY35" fmla="*/ 714546 h 1374152"/>
                <a:gd name="connsiteX36" fmla="*/ 1876425 w 1959029"/>
                <a:gd name="connsiteY36" fmla="*/ 812177 h 1374152"/>
                <a:gd name="connsiteX37" fmla="*/ 1835943 w 1959029"/>
                <a:gd name="connsiteY37" fmla="*/ 907427 h 1374152"/>
                <a:gd name="connsiteX38" fmla="*/ 1795462 w 1959029"/>
                <a:gd name="connsiteY38" fmla="*/ 945527 h 1374152"/>
                <a:gd name="connsiteX39" fmla="*/ 1819275 w 1959029"/>
                <a:gd name="connsiteY39" fmla="*/ 993152 h 1374152"/>
                <a:gd name="connsiteX40" fmla="*/ 1790700 w 1959029"/>
                <a:gd name="connsiteY40" fmla="*/ 1009821 h 1374152"/>
                <a:gd name="connsiteX41" fmla="*/ 1797843 w 1959029"/>
                <a:gd name="connsiteY41" fmla="*/ 1047921 h 1374152"/>
                <a:gd name="connsiteX42" fmla="*/ 1747837 w 1959029"/>
                <a:gd name="connsiteY42" fmla="*/ 1090784 h 1374152"/>
                <a:gd name="connsiteX43" fmla="*/ 1759743 w 1959029"/>
                <a:gd name="connsiteY43" fmla="*/ 1197940 h 1374152"/>
                <a:gd name="connsiteX44" fmla="*/ 1781175 w 1959029"/>
                <a:gd name="connsiteY44" fmla="*/ 1262234 h 1374152"/>
                <a:gd name="connsiteX45" fmla="*/ 1955006 w 1959029"/>
                <a:gd name="connsiteY45" fmla="*/ 1214609 h 1374152"/>
                <a:gd name="connsiteX46" fmla="*/ 1907381 w 1959029"/>
                <a:gd name="connsiteY46" fmla="*/ 1276521 h 1374152"/>
                <a:gd name="connsiteX47" fmla="*/ 1952625 w 1959029"/>
                <a:gd name="connsiteY47" fmla="*/ 1345577 h 1374152"/>
                <a:gd name="connsiteX48" fmla="*/ 1907381 w 1959029"/>
                <a:gd name="connsiteY48" fmla="*/ 1374152 h 13741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Lst>
              <a:rect l="l" t="t" r="r" b="b"/>
              <a:pathLst>
                <a:path w="1959029" h="1374152">
                  <a:moveTo>
                    <a:pt x="0" y="235915"/>
                  </a:moveTo>
                  <a:cubicBezTo>
                    <a:pt x="26193" y="231549"/>
                    <a:pt x="52387" y="227183"/>
                    <a:pt x="69056" y="221627"/>
                  </a:cubicBezTo>
                  <a:cubicBezTo>
                    <a:pt x="85725" y="216071"/>
                    <a:pt x="91678" y="204164"/>
                    <a:pt x="100012" y="202577"/>
                  </a:cubicBezTo>
                  <a:cubicBezTo>
                    <a:pt x="108346" y="200990"/>
                    <a:pt x="108743" y="212499"/>
                    <a:pt x="119062" y="212102"/>
                  </a:cubicBezTo>
                  <a:cubicBezTo>
                    <a:pt x="129381" y="211705"/>
                    <a:pt x="153194" y="194243"/>
                    <a:pt x="161925" y="200196"/>
                  </a:cubicBezTo>
                  <a:cubicBezTo>
                    <a:pt x="170656" y="206149"/>
                    <a:pt x="153591" y="239884"/>
                    <a:pt x="171450" y="247821"/>
                  </a:cubicBezTo>
                  <a:cubicBezTo>
                    <a:pt x="189309" y="255758"/>
                    <a:pt x="242490" y="257743"/>
                    <a:pt x="269081" y="247821"/>
                  </a:cubicBezTo>
                  <a:cubicBezTo>
                    <a:pt x="295672" y="237899"/>
                    <a:pt x="305990" y="200196"/>
                    <a:pt x="330993" y="188290"/>
                  </a:cubicBezTo>
                  <a:cubicBezTo>
                    <a:pt x="355996" y="176384"/>
                    <a:pt x="394494" y="180353"/>
                    <a:pt x="419100" y="176384"/>
                  </a:cubicBezTo>
                  <a:cubicBezTo>
                    <a:pt x="443706" y="172415"/>
                    <a:pt x="466725" y="173208"/>
                    <a:pt x="478631" y="164477"/>
                  </a:cubicBezTo>
                  <a:cubicBezTo>
                    <a:pt x="490537" y="155746"/>
                    <a:pt x="480218" y="135902"/>
                    <a:pt x="490537" y="123996"/>
                  </a:cubicBezTo>
                  <a:cubicBezTo>
                    <a:pt x="500856" y="112090"/>
                    <a:pt x="532606" y="100581"/>
                    <a:pt x="540543" y="93040"/>
                  </a:cubicBezTo>
                  <a:cubicBezTo>
                    <a:pt x="548480" y="85499"/>
                    <a:pt x="521890" y="91055"/>
                    <a:pt x="538162" y="78752"/>
                  </a:cubicBezTo>
                  <a:cubicBezTo>
                    <a:pt x="554434" y="66449"/>
                    <a:pt x="638175" y="19221"/>
                    <a:pt x="638175" y="19221"/>
                  </a:cubicBezTo>
                  <a:cubicBezTo>
                    <a:pt x="659606" y="6521"/>
                    <a:pt x="657622" y="3346"/>
                    <a:pt x="666750" y="2552"/>
                  </a:cubicBezTo>
                  <a:cubicBezTo>
                    <a:pt x="675878" y="1758"/>
                    <a:pt x="677465" y="14856"/>
                    <a:pt x="692943" y="14459"/>
                  </a:cubicBezTo>
                  <a:cubicBezTo>
                    <a:pt x="708421" y="14062"/>
                    <a:pt x="735805" y="-1813"/>
                    <a:pt x="759618" y="171"/>
                  </a:cubicBezTo>
                  <a:cubicBezTo>
                    <a:pt x="783431" y="2155"/>
                    <a:pt x="823912" y="14856"/>
                    <a:pt x="835818" y="26365"/>
                  </a:cubicBezTo>
                  <a:cubicBezTo>
                    <a:pt x="847724" y="37874"/>
                    <a:pt x="823912" y="49383"/>
                    <a:pt x="831056" y="69227"/>
                  </a:cubicBezTo>
                  <a:cubicBezTo>
                    <a:pt x="838200" y="89071"/>
                    <a:pt x="865981" y="124393"/>
                    <a:pt x="878681" y="145427"/>
                  </a:cubicBezTo>
                  <a:cubicBezTo>
                    <a:pt x="891381" y="166461"/>
                    <a:pt x="894556" y="184322"/>
                    <a:pt x="907256" y="195434"/>
                  </a:cubicBezTo>
                  <a:cubicBezTo>
                    <a:pt x="919956" y="206546"/>
                    <a:pt x="938609" y="200990"/>
                    <a:pt x="954881" y="212102"/>
                  </a:cubicBezTo>
                  <a:cubicBezTo>
                    <a:pt x="971153" y="223214"/>
                    <a:pt x="981075" y="248615"/>
                    <a:pt x="1004887" y="262109"/>
                  </a:cubicBezTo>
                  <a:cubicBezTo>
                    <a:pt x="1028699" y="275603"/>
                    <a:pt x="1071165" y="288700"/>
                    <a:pt x="1097756" y="293065"/>
                  </a:cubicBezTo>
                  <a:cubicBezTo>
                    <a:pt x="1124347" y="297430"/>
                    <a:pt x="1136253" y="294255"/>
                    <a:pt x="1164431" y="288302"/>
                  </a:cubicBezTo>
                  <a:cubicBezTo>
                    <a:pt x="1192609" y="282349"/>
                    <a:pt x="1244600" y="272824"/>
                    <a:pt x="1266825" y="257346"/>
                  </a:cubicBezTo>
                  <a:cubicBezTo>
                    <a:pt x="1289050" y="241868"/>
                    <a:pt x="1285478" y="216468"/>
                    <a:pt x="1297781" y="195434"/>
                  </a:cubicBezTo>
                  <a:cubicBezTo>
                    <a:pt x="1310084" y="174400"/>
                    <a:pt x="1321990" y="137490"/>
                    <a:pt x="1340643" y="131140"/>
                  </a:cubicBezTo>
                  <a:cubicBezTo>
                    <a:pt x="1359296" y="124790"/>
                    <a:pt x="1397794" y="137887"/>
                    <a:pt x="1409700" y="157334"/>
                  </a:cubicBezTo>
                  <a:cubicBezTo>
                    <a:pt x="1421606" y="176781"/>
                    <a:pt x="1414859" y="219246"/>
                    <a:pt x="1412081" y="247821"/>
                  </a:cubicBezTo>
                  <a:cubicBezTo>
                    <a:pt x="1409303" y="276396"/>
                    <a:pt x="1397793" y="296637"/>
                    <a:pt x="1393031" y="328784"/>
                  </a:cubicBezTo>
                  <a:cubicBezTo>
                    <a:pt x="1388269" y="360931"/>
                    <a:pt x="1361281" y="406571"/>
                    <a:pt x="1383506" y="440702"/>
                  </a:cubicBezTo>
                  <a:cubicBezTo>
                    <a:pt x="1405731" y="474833"/>
                    <a:pt x="1485106" y="523252"/>
                    <a:pt x="1526381" y="533571"/>
                  </a:cubicBezTo>
                  <a:cubicBezTo>
                    <a:pt x="1567656" y="543890"/>
                    <a:pt x="1604565" y="488724"/>
                    <a:pt x="1631156" y="502615"/>
                  </a:cubicBezTo>
                  <a:cubicBezTo>
                    <a:pt x="1657747" y="516506"/>
                    <a:pt x="1663700" y="581593"/>
                    <a:pt x="1685925" y="616915"/>
                  </a:cubicBezTo>
                  <a:cubicBezTo>
                    <a:pt x="1708150" y="652237"/>
                    <a:pt x="1732756" y="682003"/>
                    <a:pt x="1764506" y="714546"/>
                  </a:cubicBezTo>
                  <a:cubicBezTo>
                    <a:pt x="1796256" y="747089"/>
                    <a:pt x="1864519" y="780030"/>
                    <a:pt x="1876425" y="812177"/>
                  </a:cubicBezTo>
                  <a:cubicBezTo>
                    <a:pt x="1888331" y="844324"/>
                    <a:pt x="1849437" y="885202"/>
                    <a:pt x="1835943" y="907427"/>
                  </a:cubicBezTo>
                  <a:cubicBezTo>
                    <a:pt x="1822449" y="929652"/>
                    <a:pt x="1798240" y="931239"/>
                    <a:pt x="1795462" y="945527"/>
                  </a:cubicBezTo>
                  <a:cubicBezTo>
                    <a:pt x="1792684" y="959815"/>
                    <a:pt x="1820069" y="982436"/>
                    <a:pt x="1819275" y="993152"/>
                  </a:cubicBezTo>
                  <a:cubicBezTo>
                    <a:pt x="1818481" y="1003868"/>
                    <a:pt x="1794272" y="1000693"/>
                    <a:pt x="1790700" y="1009821"/>
                  </a:cubicBezTo>
                  <a:cubicBezTo>
                    <a:pt x="1787128" y="1018949"/>
                    <a:pt x="1804987" y="1034427"/>
                    <a:pt x="1797843" y="1047921"/>
                  </a:cubicBezTo>
                  <a:cubicBezTo>
                    <a:pt x="1790699" y="1061415"/>
                    <a:pt x="1754187" y="1065781"/>
                    <a:pt x="1747837" y="1090784"/>
                  </a:cubicBezTo>
                  <a:cubicBezTo>
                    <a:pt x="1741487" y="1115787"/>
                    <a:pt x="1754187" y="1169365"/>
                    <a:pt x="1759743" y="1197940"/>
                  </a:cubicBezTo>
                  <a:cubicBezTo>
                    <a:pt x="1765299" y="1226515"/>
                    <a:pt x="1748631" y="1259456"/>
                    <a:pt x="1781175" y="1262234"/>
                  </a:cubicBezTo>
                  <a:cubicBezTo>
                    <a:pt x="1813719" y="1265012"/>
                    <a:pt x="1933972" y="1212228"/>
                    <a:pt x="1955006" y="1214609"/>
                  </a:cubicBezTo>
                  <a:cubicBezTo>
                    <a:pt x="1976040" y="1216990"/>
                    <a:pt x="1907778" y="1254693"/>
                    <a:pt x="1907381" y="1276521"/>
                  </a:cubicBezTo>
                  <a:cubicBezTo>
                    <a:pt x="1906984" y="1298349"/>
                    <a:pt x="1952625" y="1329305"/>
                    <a:pt x="1952625" y="1345577"/>
                  </a:cubicBezTo>
                  <a:cubicBezTo>
                    <a:pt x="1952625" y="1361849"/>
                    <a:pt x="1930003" y="1368000"/>
                    <a:pt x="1907381" y="1374152"/>
                  </a:cubicBezTo>
                </a:path>
              </a:pathLst>
            </a:custGeom>
            <a:noFill/>
            <a:ln>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7" name="Freihandform: Form 46">
              <a:extLst>
                <a:ext uri="{FF2B5EF4-FFF2-40B4-BE49-F238E27FC236}">
                  <a16:creationId xmlns:a16="http://schemas.microsoft.com/office/drawing/2014/main" id="{B050F753-79F4-48FE-B9AC-094D0481B961}"/>
                </a:ext>
              </a:extLst>
            </p:cNvPr>
            <p:cNvSpPr/>
            <p:nvPr/>
          </p:nvSpPr>
          <p:spPr>
            <a:xfrm>
              <a:off x="11262682" y="2338195"/>
              <a:ext cx="721518" cy="206146"/>
            </a:xfrm>
            <a:custGeom>
              <a:avLst/>
              <a:gdLst>
                <a:gd name="connsiteX0" fmla="*/ 0 w 721518"/>
                <a:gd name="connsiteY0" fmla="*/ 14745 h 206146"/>
                <a:gd name="connsiteX1" fmla="*/ 69056 w 721518"/>
                <a:gd name="connsiteY1" fmla="*/ 26651 h 206146"/>
                <a:gd name="connsiteX2" fmla="*/ 207168 w 721518"/>
                <a:gd name="connsiteY2" fmla="*/ 458 h 206146"/>
                <a:gd name="connsiteX3" fmla="*/ 271462 w 721518"/>
                <a:gd name="connsiteY3" fmla="*/ 52845 h 206146"/>
                <a:gd name="connsiteX4" fmla="*/ 483393 w 721518"/>
                <a:gd name="connsiteY4" fmla="*/ 138570 h 206146"/>
                <a:gd name="connsiteX5" fmla="*/ 661987 w 721518"/>
                <a:gd name="connsiteY5" fmla="*/ 202864 h 206146"/>
                <a:gd name="connsiteX6" fmla="*/ 721518 w 721518"/>
                <a:gd name="connsiteY6" fmla="*/ 190958 h 20614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721518" h="206146">
                  <a:moveTo>
                    <a:pt x="0" y="14745"/>
                  </a:moveTo>
                  <a:cubicBezTo>
                    <a:pt x="17264" y="21888"/>
                    <a:pt x="34528" y="29032"/>
                    <a:pt x="69056" y="26651"/>
                  </a:cubicBezTo>
                  <a:cubicBezTo>
                    <a:pt x="103584" y="24270"/>
                    <a:pt x="173434" y="-3908"/>
                    <a:pt x="207168" y="458"/>
                  </a:cubicBezTo>
                  <a:cubicBezTo>
                    <a:pt x="240902" y="4824"/>
                    <a:pt x="225425" y="29826"/>
                    <a:pt x="271462" y="52845"/>
                  </a:cubicBezTo>
                  <a:cubicBezTo>
                    <a:pt x="317499" y="75864"/>
                    <a:pt x="418305" y="113567"/>
                    <a:pt x="483393" y="138570"/>
                  </a:cubicBezTo>
                  <a:cubicBezTo>
                    <a:pt x="548481" y="163573"/>
                    <a:pt x="622300" y="194133"/>
                    <a:pt x="661987" y="202864"/>
                  </a:cubicBezTo>
                  <a:cubicBezTo>
                    <a:pt x="701675" y="211595"/>
                    <a:pt x="711596" y="201276"/>
                    <a:pt x="721518" y="190958"/>
                  </a:cubicBezTo>
                </a:path>
              </a:pathLst>
            </a:custGeom>
            <a:noFill/>
            <a:ln>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8" name="Freihandform: Form 47">
              <a:extLst>
                <a:ext uri="{FF2B5EF4-FFF2-40B4-BE49-F238E27FC236}">
                  <a16:creationId xmlns:a16="http://schemas.microsoft.com/office/drawing/2014/main" id="{4ABEB4ED-4503-420E-8EE2-929DBB0C2507}"/>
                </a:ext>
              </a:extLst>
            </p:cNvPr>
            <p:cNvSpPr/>
            <p:nvPr/>
          </p:nvSpPr>
          <p:spPr>
            <a:xfrm>
              <a:off x="9610094" y="3060770"/>
              <a:ext cx="2105025" cy="1611508"/>
            </a:xfrm>
            <a:custGeom>
              <a:avLst/>
              <a:gdLst>
                <a:gd name="connsiteX0" fmla="*/ 0 w 2105025"/>
                <a:gd name="connsiteY0" fmla="*/ 87508 h 1611508"/>
                <a:gd name="connsiteX1" fmla="*/ 133350 w 2105025"/>
                <a:gd name="connsiteY1" fmla="*/ 92270 h 1611508"/>
                <a:gd name="connsiteX2" fmla="*/ 80963 w 2105025"/>
                <a:gd name="connsiteY2" fmla="*/ 149420 h 1611508"/>
                <a:gd name="connsiteX3" fmla="*/ 128588 w 2105025"/>
                <a:gd name="connsiteY3" fmla="*/ 201808 h 1611508"/>
                <a:gd name="connsiteX4" fmla="*/ 242888 w 2105025"/>
                <a:gd name="connsiteY4" fmla="*/ 173233 h 1611508"/>
                <a:gd name="connsiteX5" fmla="*/ 304800 w 2105025"/>
                <a:gd name="connsiteY5" fmla="*/ 106558 h 1611508"/>
                <a:gd name="connsiteX6" fmla="*/ 361950 w 2105025"/>
                <a:gd name="connsiteY6" fmla="*/ 120845 h 1611508"/>
                <a:gd name="connsiteX7" fmla="*/ 381000 w 2105025"/>
                <a:gd name="connsiteY7" fmla="*/ 158945 h 1611508"/>
                <a:gd name="connsiteX8" fmla="*/ 504825 w 2105025"/>
                <a:gd name="connsiteY8" fmla="*/ 92270 h 1611508"/>
                <a:gd name="connsiteX9" fmla="*/ 609600 w 2105025"/>
                <a:gd name="connsiteY9" fmla="*/ 87508 h 1611508"/>
                <a:gd name="connsiteX10" fmla="*/ 642938 w 2105025"/>
                <a:gd name="connsiteY10" fmla="*/ 30358 h 1611508"/>
                <a:gd name="connsiteX11" fmla="*/ 781050 w 2105025"/>
                <a:gd name="connsiteY11" fmla="*/ 1783 h 1611508"/>
                <a:gd name="connsiteX12" fmla="*/ 895350 w 2105025"/>
                <a:gd name="connsiteY12" fmla="*/ 35120 h 1611508"/>
                <a:gd name="connsiteX13" fmla="*/ 876300 w 2105025"/>
                <a:gd name="connsiteY13" fmla="*/ 120845 h 1611508"/>
                <a:gd name="connsiteX14" fmla="*/ 838200 w 2105025"/>
                <a:gd name="connsiteY14" fmla="*/ 220858 h 1611508"/>
                <a:gd name="connsiteX15" fmla="*/ 852488 w 2105025"/>
                <a:gd name="connsiteY15" fmla="*/ 268483 h 1611508"/>
                <a:gd name="connsiteX16" fmla="*/ 957263 w 2105025"/>
                <a:gd name="connsiteY16" fmla="*/ 230383 h 1611508"/>
                <a:gd name="connsiteX17" fmla="*/ 1023938 w 2105025"/>
                <a:gd name="connsiteY17" fmla="*/ 149420 h 1611508"/>
                <a:gd name="connsiteX18" fmla="*/ 1095375 w 2105025"/>
                <a:gd name="connsiteY18" fmla="*/ 154183 h 1611508"/>
                <a:gd name="connsiteX19" fmla="*/ 1176338 w 2105025"/>
                <a:gd name="connsiteY19" fmla="*/ 120845 h 1611508"/>
                <a:gd name="connsiteX20" fmla="*/ 1185863 w 2105025"/>
                <a:gd name="connsiteY20" fmla="*/ 54170 h 1611508"/>
                <a:gd name="connsiteX21" fmla="*/ 1233488 w 2105025"/>
                <a:gd name="connsiteY21" fmla="*/ 1783 h 1611508"/>
                <a:gd name="connsiteX22" fmla="*/ 1323975 w 2105025"/>
                <a:gd name="connsiteY22" fmla="*/ 120845 h 1611508"/>
                <a:gd name="connsiteX23" fmla="*/ 1333500 w 2105025"/>
                <a:gd name="connsiteY23" fmla="*/ 163708 h 1611508"/>
                <a:gd name="connsiteX24" fmla="*/ 1419225 w 2105025"/>
                <a:gd name="connsiteY24" fmla="*/ 254195 h 1611508"/>
                <a:gd name="connsiteX25" fmla="*/ 1419225 w 2105025"/>
                <a:gd name="connsiteY25" fmla="*/ 316108 h 1611508"/>
                <a:gd name="connsiteX26" fmla="*/ 1395413 w 2105025"/>
                <a:gd name="connsiteY26" fmla="*/ 358970 h 1611508"/>
                <a:gd name="connsiteX27" fmla="*/ 1319213 w 2105025"/>
                <a:gd name="connsiteY27" fmla="*/ 411358 h 1611508"/>
                <a:gd name="connsiteX28" fmla="*/ 1295400 w 2105025"/>
                <a:gd name="connsiteY28" fmla="*/ 482795 h 1611508"/>
                <a:gd name="connsiteX29" fmla="*/ 1238250 w 2105025"/>
                <a:gd name="connsiteY29" fmla="*/ 525658 h 1611508"/>
                <a:gd name="connsiteX30" fmla="*/ 1409700 w 2105025"/>
                <a:gd name="connsiteY30" fmla="*/ 725683 h 1611508"/>
                <a:gd name="connsiteX31" fmla="*/ 1481138 w 2105025"/>
                <a:gd name="connsiteY31" fmla="*/ 701870 h 1611508"/>
                <a:gd name="connsiteX32" fmla="*/ 1547813 w 2105025"/>
                <a:gd name="connsiteY32" fmla="*/ 759020 h 1611508"/>
                <a:gd name="connsiteX33" fmla="*/ 1609725 w 2105025"/>
                <a:gd name="connsiteY33" fmla="*/ 773308 h 1611508"/>
                <a:gd name="connsiteX34" fmla="*/ 1547813 w 2105025"/>
                <a:gd name="connsiteY34" fmla="*/ 873320 h 1611508"/>
                <a:gd name="connsiteX35" fmla="*/ 1590675 w 2105025"/>
                <a:gd name="connsiteY35" fmla="*/ 944758 h 1611508"/>
                <a:gd name="connsiteX36" fmla="*/ 1647825 w 2105025"/>
                <a:gd name="connsiteY36" fmla="*/ 1059058 h 1611508"/>
                <a:gd name="connsiteX37" fmla="*/ 1581150 w 2105025"/>
                <a:gd name="connsiteY37" fmla="*/ 1130495 h 1611508"/>
                <a:gd name="connsiteX38" fmla="*/ 1590675 w 2105025"/>
                <a:gd name="connsiteY38" fmla="*/ 1259083 h 1611508"/>
                <a:gd name="connsiteX39" fmla="*/ 1471613 w 2105025"/>
                <a:gd name="connsiteY39" fmla="*/ 1316233 h 1611508"/>
                <a:gd name="connsiteX40" fmla="*/ 1381125 w 2105025"/>
                <a:gd name="connsiteY40" fmla="*/ 1382908 h 1611508"/>
                <a:gd name="connsiteX41" fmla="*/ 1376363 w 2105025"/>
                <a:gd name="connsiteY41" fmla="*/ 1487683 h 1611508"/>
                <a:gd name="connsiteX42" fmla="*/ 1552575 w 2105025"/>
                <a:gd name="connsiteY42" fmla="*/ 1582933 h 1611508"/>
                <a:gd name="connsiteX43" fmla="*/ 1685925 w 2105025"/>
                <a:gd name="connsiteY43" fmla="*/ 1578170 h 1611508"/>
                <a:gd name="connsiteX44" fmla="*/ 1824038 w 2105025"/>
                <a:gd name="connsiteY44" fmla="*/ 1530545 h 1611508"/>
                <a:gd name="connsiteX45" fmla="*/ 1947863 w 2105025"/>
                <a:gd name="connsiteY45" fmla="*/ 1525783 h 1611508"/>
                <a:gd name="connsiteX46" fmla="*/ 2105025 w 2105025"/>
                <a:gd name="connsiteY46" fmla="*/ 1611508 h 161150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2105025" h="1611508">
                  <a:moveTo>
                    <a:pt x="0" y="87508"/>
                  </a:moveTo>
                  <a:cubicBezTo>
                    <a:pt x="59928" y="84729"/>
                    <a:pt x="119856" y="81951"/>
                    <a:pt x="133350" y="92270"/>
                  </a:cubicBezTo>
                  <a:cubicBezTo>
                    <a:pt x="146844" y="102589"/>
                    <a:pt x="81757" y="131164"/>
                    <a:pt x="80963" y="149420"/>
                  </a:cubicBezTo>
                  <a:cubicBezTo>
                    <a:pt x="80169" y="167676"/>
                    <a:pt x="101601" y="197839"/>
                    <a:pt x="128588" y="201808"/>
                  </a:cubicBezTo>
                  <a:cubicBezTo>
                    <a:pt x="155576" y="205777"/>
                    <a:pt x="213519" y="189108"/>
                    <a:pt x="242888" y="173233"/>
                  </a:cubicBezTo>
                  <a:cubicBezTo>
                    <a:pt x="272257" y="157358"/>
                    <a:pt x="284956" y="115289"/>
                    <a:pt x="304800" y="106558"/>
                  </a:cubicBezTo>
                  <a:cubicBezTo>
                    <a:pt x="324644" y="97827"/>
                    <a:pt x="349250" y="112114"/>
                    <a:pt x="361950" y="120845"/>
                  </a:cubicBezTo>
                  <a:cubicBezTo>
                    <a:pt x="374650" y="129576"/>
                    <a:pt x="357188" y="163707"/>
                    <a:pt x="381000" y="158945"/>
                  </a:cubicBezTo>
                  <a:cubicBezTo>
                    <a:pt x="404812" y="154183"/>
                    <a:pt x="466725" y="104176"/>
                    <a:pt x="504825" y="92270"/>
                  </a:cubicBezTo>
                  <a:cubicBezTo>
                    <a:pt x="542925" y="80364"/>
                    <a:pt x="586581" y="97827"/>
                    <a:pt x="609600" y="87508"/>
                  </a:cubicBezTo>
                  <a:cubicBezTo>
                    <a:pt x="632619" y="77189"/>
                    <a:pt x="614363" y="44645"/>
                    <a:pt x="642938" y="30358"/>
                  </a:cubicBezTo>
                  <a:cubicBezTo>
                    <a:pt x="671513" y="16071"/>
                    <a:pt x="738981" y="989"/>
                    <a:pt x="781050" y="1783"/>
                  </a:cubicBezTo>
                  <a:cubicBezTo>
                    <a:pt x="823119" y="2577"/>
                    <a:pt x="879475" y="15276"/>
                    <a:pt x="895350" y="35120"/>
                  </a:cubicBezTo>
                  <a:cubicBezTo>
                    <a:pt x="911225" y="54964"/>
                    <a:pt x="885825" y="89889"/>
                    <a:pt x="876300" y="120845"/>
                  </a:cubicBezTo>
                  <a:cubicBezTo>
                    <a:pt x="866775" y="151801"/>
                    <a:pt x="842169" y="196252"/>
                    <a:pt x="838200" y="220858"/>
                  </a:cubicBezTo>
                  <a:cubicBezTo>
                    <a:pt x="834231" y="245464"/>
                    <a:pt x="832644" y="266896"/>
                    <a:pt x="852488" y="268483"/>
                  </a:cubicBezTo>
                  <a:cubicBezTo>
                    <a:pt x="872332" y="270071"/>
                    <a:pt x="928688" y="250227"/>
                    <a:pt x="957263" y="230383"/>
                  </a:cubicBezTo>
                  <a:cubicBezTo>
                    <a:pt x="985838" y="210539"/>
                    <a:pt x="1000919" y="162120"/>
                    <a:pt x="1023938" y="149420"/>
                  </a:cubicBezTo>
                  <a:cubicBezTo>
                    <a:pt x="1046957" y="136720"/>
                    <a:pt x="1069975" y="158945"/>
                    <a:pt x="1095375" y="154183"/>
                  </a:cubicBezTo>
                  <a:cubicBezTo>
                    <a:pt x="1120775" y="149421"/>
                    <a:pt x="1161257" y="137514"/>
                    <a:pt x="1176338" y="120845"/>
                  </a:cubicBezTo>
                  <a:cubicBezTo>
                    <a:pt x="1191419" y="104176"/>
                    <a:pt x="1176338" y="74014"/>
                    <a:pt x="1185863" y="54170"/>
                  </a:cubicBezTo>
                  <a:cubicBezTo>
                    <a:pt x="1195388" y="34326"/>
                    <a:pt x="1210469" y="-9330"/>
                    <a:pt x="1233488" y="1783"/>
                  </a:cubicBezTo>
                  <a:cubicBezTo>
                    <a:pt x="1256507" y="12896"/>
                    <a:pt x="1307306" y="93858"/>
                    <a:pt x="1323975" y="120845"/>
                  </a:cubicBezTo>
                  <a:cubicBezTo>
                    <a:pt x="1340644" y="147832"/>
                    <a:pt x="1317625" y="141483"/>
                    <a:pt x="1333500" y="163708"/>
                  </a:cubicBezTo>
                  <a:cubicBezTo>
                    <a:pt x="1349375" y="185933"/>
                    <a:pt x="1404938" y="228795"/>
                    <a:pt x="1419225" y="254195"/>
                  </a:cubicBezTo>
                  <a:cubicBezTo>
                    <a:pt x="1433512" y="279595"/>
                    <a:pt x="1423194" y="298645"/>
                    <a:pt x="1419225" y="316108"/>
                  </a:cubicBezTo>
                  <a:cubicBezTo>
                    <a:pt x="1415256" y="333571"/>
                    <a:pt x="1412082" y="343095"/>
                    <a:pt x="1395413" y="358970"/>
                  </a:cubicBezTo>
                  <a:cubicBezTo>
                    <a:pt x="1378744" y="374845"/>
                    <a:pt x="1335882" y="390720"/>
                    <a:pt x="1319213" y="411358"/>
                  </a:cubicBezTo>
                  <a:cubicBezTo>
                    <a:pt x="1302544" y="431996"/>
                    <a:pt x="1308894" y="463745"/>
                    <a:pt x="1295400" y="482795"/>
                  </a:cubicBezTo>
                  <a:cubicBezTo>
                    <a:pt x="1281906" y="501845"/>
                    <a:pt x="1219200" y="485177"/>
                    <a:pt x="1238250" y="525658"/>
                  </a:cubicBezTo>
                  <a:cubicBezTo>
                    <a:pt x="1257300" y="566139"/>
                    <a:pt x="1369219" y="696314"/>
                    <a:pt x="1409700" y="725683"/>
                  </a:cubicBezTo>
                  <a:cubicBezTo>
                    <a:pt x="1450181" y="755052"/>
                    <a:pt x="1458119" y="696314"/>
                    <a:pt x="1481138" y="701870"/>
                  </a:cubicBezTo>
                  <a:cubicBezTo>
                    <a:pt x="1504157" y="707426"/>
                    <a:pt x="1526382" y="747114"/>
                    <a:pt x="1547813" y="759020"/>
                  </a:cubicBezTo>
                  <a:cubicBezTo>
                    <a:pt x="1569244" y="770926"/>
                    <a:pt x="1609725" y="754258"/>
                    <a:pt x="1609725" y="773308"/>
                  </a:cubicBezTo>
                  <a:cubicBezTo>
                    <a:pt x="1609725" y="792358"/>
                    <a:pt x="1550988" y="844745"/>
                    <a:pt x="1547813" y="873320"/>
                  </a:cubicBezTo>
                  <a:cubicBezTo>
                    <a:pt x="1544638" y="901895"/>
                    <a:pt x="1574006" y="913802"/>
                    <a:pt x="1590675" y="944758"/>
                  </a:cubicBezTo>
                  <a:cubicBezTo>
                    <a:pt x="1607344" y="975714"/>
                    <a:pt x="1649412" y="1028102"/>
                    <a:pt x="1647825" y="1059058"/>
                  </a:cubicBezTo>
                  <a:cubicBezTo>
                    <a:pt x="1646238" y="1090014"/>
                    <a:pt x="1590675" y="1097158"/>
                    <a:pt x="1581150" y="1130495"/>
                  </a:cubicBezTo>
                  <a:cubicBezTo>
                    <a:pt x="1571625" y="1163833"/>
                    <a:pt x="1608931" y="1228127"/>
                    <a:pt x="1590675" y="1259083"/>
                  </a:cubicBezTo>
                  <a:cubicBezTo>
                    <a:pt x="1572419" y="1290039"/>
                    <a:pt x="1506538" y="1295595"/>
                    <a:pt x="1471613" y="1316233"/>
                  </a:cubicBezTo>
                  <a:cubicBezTo>
                    <a:pt x="1436688" y="1336871"/>
                    <a:pt x="1397000" y="1354333"/>
                    <a:pt x="1381125" y="1382908"/>
                  </a:cubicBezTo>
                  <a:cubicBezTo>
                    <a:pt x="1365250" y="1411483"/>
                    <a:pt x="1347788" y="1454346"/>
                    <a:pt x="1376363" y="1487683"/>
                  </a:cubicBezTo>
                  <a:cubicBezTo>
                    <a:pt x="1404938" y="1521021"/>
                    <a:pt x="1500981" y="1567852"/>
                    <a:pt x="1552575" y="1582933"/>
                  </a:cubicBezTo>
                  <a:cubicBezTo>
                    <a:pt x="1604169" y="1598014"/>
                    <a:pt x="1640681" y="1586901"/>
                    <a:pt x="1685925" y="1578170"/>
                  </a:cubicBezTo>
                  <a:cubicBezTo>
                    <a:pt x="1731169" y="1569439"/>
                    <a:pt x="1780382" y="1539276"/>
                    <a:pt x="1824038" y="1530545"/>
                  </a:cubicBezTo>
                  <a:cubicBezTo>
                    <a:pt x="1867694" y="1521814"/>
                    <a:pt x="1901032" y="1512289"/>
                    <a:pt x="1947863" y="1525783"/>
                  </a:cubicBezTo>
                  <a:cubicBezTo>
                    <a:pt x="1994694" y="1539277"/>
                    <a:pt x="2049859" y="1575392"/>
                    <a:pt x="2105025" y="1611508"/>
                  </a:cubicBezTo>
                </a:path>
              </a:pathLst>
            </a:custGeom>
            <a:noFill/>
            <a:ln>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9" name="Freihandform: Form 48">
              <a:extLst>
                <a:ext uri="{FF2B5EF4-FFF2-40B4-BE49-F238E27FC236}">
                  <a16:creationId xmlns:a16="http://schemas.microsoft.com/office/drawing/2014/main" id="{16C48866-6C93-4E32-AD3E-462AC9FDFB50}"/>
                </a:ext>
              </a:extLst>
            </p:cNvPr>
            <p:cNvSpPr/>
            <p:nvPr/>
          </p:nvSpPr>
          <p:spPr>
            <a:xfrm>
              <a:off x="9314819" y="3199782"/>
              <a:ext cx="378619" cy="110827"/>
            </a:xfrm>
            <a:custGeom>
              <a:avLst/>
              <a:gdLst>
                <a:gd name="connsiteX0" fmla="*/ 0 w 378619"/>
                <a:gd name="connsiteY0" fmla="*/ 108039 h 110827"/>
                <a:gd name="connsiteX1" fmla="*/ 59531 w 378619"/>
                <a:gd name="connsiteY1" fmla="*/ 91371 h 110827"/>
                <a:gd name="connsiteX2" fmla="*/ 126206 w 378619"/>
                <a:gd name="connsiteY2" fmla="*/ 100896 h 110827"/>
                <a:gd name="connsiteX3" fmla="*/ 176213 w 378619"/>
                <a:gd name="connsiteY3" fmla="*/ 110421 h 110827"/>
                <a:gd name="connsiteX4" fmla="*/ 247650 w 378619"/>
                <a:gd name="connsiteY4" fmla="*/ 86608 h 110827"/>
                <a:gd name="connsiteX5" fmla="*/ 307181 w 378619"/>
                <a:gd name="connsiteY5" fmla="*/ 93752 h 110827"/>
                <a:gd name="connsiteX6" fmla="*/ 333375 w 378619"/>
                <a:gd name="connsiteY6" fmla="*/ 50889 h 110827"/>
                <a:gd name="connsiteX7" fmla="*/ 333375 w 378619"/>
                <a:gd name="connsiteY7" fmla="*/ 3264 h 110827"/>
                <a:gd name="connsiteX8" fmla="*/ 378619 w 378619"/>
                <a:gd name="connsiteY8" fmla="*/ 8027 h 11082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78619" h="110827">
                  <a:moveTo>
                    <a:pt x="0" y="108039"/>
                  </a:moveTo>
                  <a:cubicBezTo>
                    <a:pt x="19248" y="100300"/>
                    <a:pt x="38497" y="92562"/>
                    <a:pt x="59531" y="91371"/>
                  </a:cubicBezTo>
                  <a:cubicBezTo>
                    <a:pt x="80565" y="90180"/>
                    <a:pt x="106759" y="97721"/>
                    <a:pt x="126206" y="100896"/>
                  </a:cubicBezTo>
                  <a:cubicBezTo>
                    <a:pt x="145653" y="104071"/>
                    <a:pt x="155972" y="112802"/>
                    <a:pt x="176213" y="110421"/>
                  </a:cubicBezTo>
                  <a:cubicBezTo>
                    <a:pt x="196454" y="108040"/>
                    <a:pt x="225822" y="89386"/>
                    <a:pt x="247650" y="86608"/>
                  </a:cubicBezTo>
                  <a:cubicBezTo>
                    <a:pt x="269478" y="83830"/>
                    <a:pt x="292894" y="99705"/>
                    <a:pt x="307181" y="93752"/>
                  </a:cubicBezTo>
                  <a:cubicBezTo>
                    <a:pt x="321468" y="87799"/>
                    <a:pt x="329009" y="65970"/>
                    <a:pt x="333375" y="50889"/>
                  </a:cubicBezTo>
                  <a:cubicBezTo>
                    <a:pt x="337741" y="35808"/>
                    <a:pt x="325834" y="10408"/>
                    <a:pt x="333375" y="3264"/>
                  </a:cubicBezTo>
                  <a:cubicBezTo>
                    <a:pt x="340916" y="-3880"/>
                    <a:pt x="359767" y="2073"/>
                    <a:pt x="378619" y="8027"/>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0" name="Titel 1">
              <a:extLst>
                <a:ext uri="{FF2B5EF4-FFF2-40B4-BE49-F238E27FC236}">
                  <a16:creationId xmlns:a16="http://schemas.microsoft.com/office/drawing/2014/main" id="{9225E70C-C06A-4958-BEB1-3C9270A98BF4}"/>
                </a:ext>
              </a:extLst>
            </p:cNvPr>
            <p:cNvSpPr txBox="1">
              <a:spLocks/>
            </p:cNvSpPr>
            <p:nvPr/>
          </p:nvSpPr>
          <p:spPr>
            <a:xfrm>
              <a:off x="3481364" y="263463"/>
              <a:ext cx="2676525" cy="45156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de-DE" sz="1400" b="1" dirty="0" err="1">
                  <a:latin typeface="Times New Roman" panose="02020603050405020304" pitchFamily="18" charset="0"/>
                  <a:cs typeface="Times New Roman" panose="02020603050405020304" pitchFamily="18" charset="0"/>
                </a:rPr>
                <a:t>Disulfiram</a:t>
              </a:r>
              <a:endParaRPr lang="de-DE" sz="1400" b="1" dirty="0">
                <a:latin typeface="Times New Roman" panose="02020603050405020304" pitchFamily="18" charset="0"/>
                <a:cs typeface="Times New Roman" panose="02020603050405020304" pitchFamily="18" charset="0"/>
              </a:endParaRPr>
            </a:p>
          </p:txBody>
        </p:sp>
        <p:sp>
          <p:nvSpPr>
            <p:cNvPr id="51" name="Titel 1">
              <a:extLst>
                <a:ext uri="{FF2B5EF4-FFF2-40B4-BE49-F238E27FC236}">
                  <a16:creationId xmlns:a16="http://schemas.microsoft.com/office/drawing/2014/main" id="{F1EECEF1-7F12-4233-9F07-C73C90E1C2D6}"/>
                </a:ext>
              </a:extLst>
            </p:cNvPr>
            <p:cNvSpPr txBox="1">
              <a:spLocks/>
            </p:cNvSpPr>
            <p:nvPr/>
          </p:nvSpPr>
          <p:spPr>
            <a:xfrm>
              <a:off x="6566327" y="263462"/>
              <a:ext cx="2676525" cy="45156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de-DE" sz="1400" b="1" dirty="0">
                  <a:latin typeface="Times New Roman" panose="02020603050405020304" pitchFamily="18" charset="0"/>
                  <a:cs typeface="Times New Roman" panose="02020603050405020304" pitchFamily="18" charset="0"/>
                </a:rPr>
                <a:t>Vehicle</a:t>
              </a:r>
            </a:p>
          </p:txBody>
        </p:sp>
        <p:sp>
          <p:nvSpPr>
            <p:cNvPr id="52" name="Titel 1">
              <a:extLst>
                <a:ext uri="{FF2B5EF4-FFF2-40B4-BE49-F238E27FC236}">
                  <a16:creationId xmlns:a16="http://schemas.microsoft.com/office/drawing/2014/main" id="{2C6B4011-F90F-4F0C-842F-BD86A3DD2D68}"/>
                </a:ext>
              </a:extLst>
            </p:cNvPr>
            <p:cNvSpPr txBox="1">
              <a:spLocks/>
            </p:cNvSpPr>
            <p:nvPr/>
          </p:nvSpPr>
          <p:spPr>
            <a:xfrm>
              <a:off x="9332619" y="258847"/>
              <a:ext cx="2676525" cy="45156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de-DE" sz="1400" b="1" dirty="0" err="1">
                  <a:latin typeface="Times New Roman" panose="02020603050405020304" pitchFamily="18" charset="0"/>
                  <a:cs typeface="Times New Roman" panose="02020603050405020304" pitchFamily="18" charset="0"/>
                </a:rPr>
                <a:t>Disulfiram</a:t>
              </a:r>
              <a:endParaRPr lang="de-DE" sz="1400" b="1" dirty="0">
                <a:latin typeface="Times New Roman" panose="02020603050405020304" pitchFamily="18" charset="0"/>
                <a:cs typeface="Times New Roman" panose="02020603050405020304" pitchFamily="18" charset="0"/>
              </a:endParaRPr>
            </a:p>
          </p:txBody>
        </p:sp>
        <p:cxnSp>
          <p:nvCxnSpPr>
            <p:cNvPr id="53" name="Gerader Verbinder 52">
              <a:extLst>
                <a:ext uri="{FF2B5EF4-FFF2-40B4-BE49-F238E27FC236}">
                  <a16:creationId xmlns:a16="http://schemas.microsoft.com/office/drawing/2014/main" id="{373EF5E7-C2D2-493A-8293-A9D20BD2D25A}"/>
                </a:ext>
              </a:extLst>
            </p:cNvPr>
            <p:cNvCxnSpPr>
              <a:cxnSpLocks/>
            </p:cNvCxnSpPr>
            <p:nvPr/>
          </p:nvCxnSpPr>
          <p:spPr>
            <a:xfrm>
              <a:off x="2898679" y="6742077"/>
              <a:ext cx="371475"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54" name="Grafik 53">
              <a:extLst>
                <a:ext uri="{FF2B5EF4-FFF2-40B4-BE49-F238E27FC236}">
                  <a16:creationId xmlns:a16="http://schemas.microsoft.com/office/drawing/2014/main" id="{46EFC006-2231-4CD5-98B1-93772BB026C7}"/>
                </a:ext>
              </a:extLst>
            </p:cNvPr>
            <p:cNvPicPr>
              <a:picLocks/>
            </p:cNvPicPr>
            <p:nvPr/>
          </p:nvPicPr>
          <p:blipFill>
            <a:blip r:embed="rId15" cstate="hqprint">
              <a:extLst>
                <a:ext uri="{BEBA8EAE-BF5A-486C-A8C5-ECC9F3942E4B}">
                  <a14:imgProps xmlns:a14="http://schemas.microsoft.com/office/drawing/2010/main">
                    <a14:imgLayer r:embed="rId16">
                      <a14:imgEffect>
                        <a14:sharpenSoften amount="25000"/>
                      </a14:imgEffect>
                    </a14:imgLayer>
                  </a14:imgProps>
                </a:ext>
                <a:ext uri="{28A0092B-C50C-407E-A947-70E740481C1C}">
                  <a14:useLocalDpi xmlns:a14="http://schemas.microsoft.com/office/drawing/2010/main"/>
                </a:ext>
              </a:extLst>
            </a:blip>
            <a:stretch>
              <a:fillRect/>
            </a:stretch>
          </p:blipFill>
          <p:spPr>
            <a:xfrm>
              <a:off x="719833" y="4797132"/>
              <a:ext cx="2678400" cy="2016000"/>
            </a:xfrm>
            <a:prstGeom prst="rect">
              <a:avLst/>
            </a:prstGeom>
            <a:ln w="12700">
              <a:solidFill>
                <a:schemeClr val="tx1"/>
              </a:solidFill>
            </a:ln>
          </p:spPr>
        </p:pic>
        <p:sp>
          <p:nvSpPr>
            <p:cNvPr id="55" name="Titel 1">
              <a:extLst>
                <a:ext uri="{FF2B5EF4-FFF2-40B4-BE49-F238E27FC236}">
                  <a16:creationId xmlns:a16="http://schemas.microsoft.com/office/drawing/2014/main" id="{97C577C1-9438-4D64-8EB2-D4EDCA0DD0BD}"/>
                </a:ext>
              </a:extLst>
            </p:cNvPr>
            <p:cNvSpPr txBox="1">
              <a:spLocks/>
            </p:cNvSpPr>
            <p:nvPr/>
          </p:nvSpPr>
          <p:spPr>
            <a:xfrm rot="16200000">
              <a:off x="-364451" y="5737729"/>
              <a:ext cx="1908152" cy="198861"/>
            </a:xfrm>
            <a:prstGeom prst="rect">
              <a:avLst/>
            </a:prstGeom>
          </p:spPr>
          <p:txBody>
            <a:bodyPr vert="horz" lIns="51435" tIns="25718" rIns="51435" bIns="25718"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de-DE" sz="1400" b="1" dirty="0" err="1">
                  <a:latin typeface="Times New Roman" panose="02020603050405020304" pitchFamily="18" charset="0"/>
                  <a:cs typeface="Times New Roman" panose="02020603050405020304" pitchFamily="18" charset="0"/>
                </a:rPr>
                <a:t>Hematoxylin</a:t>
              </a:r>
              <a:r>
                <a:rPr lang="de-DE" sz="1400" b="1" dirty="0">
                  <a:latin typeface="Times New Roman" panose="02020603050405020304" pitchFamily="18" charset="0"/>
                  <a:cs typeface="Times New Roman" panose="02020603050405020304" pitchFamily="18" charset="0"/>
                </a:rPr>
                <a:t> &amp; </a:t>
              </a:r>
              <a:r>
                <a:rPr lang="de-DE" sz="1400" b="1" dirty="0" err="1">
                  <a:latin typeface="Times New Roman" panose="02020603050405020304" pitchFamily="18" charset="0"/>
                  <a:cs typeface="Times New Roman" panose="02020603050405020304" pitchFamily="18" charset="0"/>
                </a:rPr>
                <a:t>eosin</a:t>
              </a:r>
              <a:endParaRPr lang="de-DE" sz="1400" b="1" dirty="0">
                <a:latin typeface="Times New Roman" panose="02020603050405020304" pitchFamily="18" charset="0"/>
                <a:cs typeface="Times New Roman" panose="02020603050405020304" pitchFamily="18" charset="0"/>
              </a:endParaRPr>
            </a:p>
          </p:txBody>
        </p:sp>
        <p:pic>
          <p:nvPicPr>
            <p:cNvPr id="56" name="Grafik 55">
              <a:extLst>
                <a:ext uri="{FF2B5EF4-FFF2-40B4-BE49-F238E27FC236}">
                  <a16:creationId xmlns:a16="http://schemas.microsoft.com/office/drawing/2014/main" id="{D028DD68-E799-4000-972D-9247FF5132EE}"/>
                </a:ext>
              </a:extLst>
            </p:cNvPr>
            <p:cNvPicPr>
              <a:picLocks/>
            </p:cNvPicPr>
            <p:nvPr/>
          </p:nvPicPr>
          <p:blipFill>
            <a:blip r:embed="rId17" cstate="hqprint">
              <a:extLst>
                <a:ext uri="{BEBA8EAE-BF5A-486C-A8C5-ECC9F3942E4B}">
                  <a14:imgProps xmlns:a14="http://schemas.microsoft.com/office/drawing/2010/main">
                    <a14:imgLayer r:embed="rId18">
                      <a14:imgEffect>
                        <a14:sharpenSoften amount="25000"/>
                      </a14:imgEffect>
                    </a14:imgLayer>
                  </a14:imgProps>
                </a:ext>
                <a:ext uri="{28A0092B-C50C-407E-A947-70E740481C1C}">
                  <a14:useLocalDpi xmlns:a14="http://schemas.microsoft.com/office/drawing/2010/main"/>
                </a:ext>
              </a:extLst>
            </a:blip>
            <a:stretch>
              <a:fillRect/>
            </a:stretch>
          </p:blipFill>
          <p:spPr>
            <a:xfrm rot="10800000">
              <a:off x="3469246" y="4795781"/>
              <a:ext cx="2678400" cy="2016000"/>
            </a:xfrm>
            <a:prstGeom prst="rect">
              <a:avLst/>
            </a:prstGeom>
            <a:ln w="12700">
              <a:solidFill>
                <a:schemeClr val="tx1"/>
              </a:solidFill>
            </a:ln>
          </p:spPr>
        </p:pic>
        <p:cxnSp>
          <p:nvCxnSpPr>
            <p:cNvPr id="57" name="Gerader Verbinder 56">
              <a:extLst>
                <a:ext uri="{FF2B5EF4-FFF2-40B4-BE49-F238E27FC236}">
                  <a16:creationId xmlns:a16="http://schemas.microsoft.com/office/drawing/2014/main" id="{4614543D-5A5C-40A8-9082-72563E74E901}"/>
                </a:ext>
              </a:extLst>
            </p:cNvPr>
            <p:cNvCxnSpPr>
              <a:cxnSpLocks/>
            </p:cNvCxnSpPr>
            <p:nvPr/>
          </p:nvCxnSpPr>
          <p:spPr>
            <a:xfrm>
              <a:off x="8715245" y="6745040"/>
              <a:ext cx="371475"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58" name="Grafik 57">
              <a:extLst>
                <a:ext uri="{FF2B5EF4-FFF2-40B4-BE49-F238E27FC236}">
                  <a16:creationId xmlns:a16="http://schemas.microsoft.com/office/drawing/2014/main" id="{4D8E9279-BB9F-4D69-9CA3-D38B35D6EF01}"/>
                </a:ext>
              </a:extLst>
            </p:cNvPr>
            <p:cNvPicPr>
              <a:picLocks/>
            </p:cNvPicPr>
            <p:nvPr/>
          </p:nvPicPr>
          <p:blipFill>
            <a:blip r:embed="rId19" cstate="hqprint">
              <a:extLst>
                <a:ext uri="{BEBA8EAE-BF5A-486C-A8C5-ECC9F3942E4B}">
                  <a14:imgProps xmlns:a14="http://schemas.microsoft.com/office/drawing/2010/main">
                    <a14:imgLayer r:embed="rId20">
                      <a14:imgEffect>
                        <a14:sharpenSoften amount="25000"/>
                      </a14:imgEffect>
                    </a14:imgLayer>
                  </a14:imgProps>
                </a:ext>
                <a:ext uri="{28A0092B-C50C-407E-A947-70E740481C1C}">
                  <a14:useLocalDpi xmlns:a14="http://schemas.microsoft.com/office/drawing/2010/main"/>
                </a:ext>
              </a:extLst>
            </a:blip>
            <a:stretch>
              <a:fillRect/>
            </a:stretch>
          </p:blipFill>
          <p:spPr>
            <a:xfrm>
              <a:off x="6547325" y="4812599"/>
              <a:ext cx="2678400" cy="2016000"/>
            </a:xfrm>
            <a:prstGeom prst="rect">
              <a:avLst/>
            </a:prstGeom>
            <a:ln w="12700">
              <a:solidFill>
                <a:schemeClr val="tx1"/>
              </a:solidFill>
            </a:ln>
          </p:spPr>
        </p:pic>
        <p:sp>
          <p:nvSpPr>
            <p:cNvPr id="59" name="Freihandform: Form 58">
              <a:extLst>
                <a:ext uri="{FF2B5EF4-FFF2-40B4-BE49-F238E27FC236}">
                  <a16:creationId xmlns:a16="http://schemas.microsoft.com/office/drawing/2014/main" id="{C41DF6B0-9855-4CDC-B103-0604FEE3E8BB}"/>
                </a:ext>
              </a:extLst>
            </p:cNvPr>
            <p:cNvSpPr/>
            <p:nvPr/>
          </p:nvSpPr>
          <p:spPr>
            <a:xfrm>
              <a:off x="11069057" y="6313526"/>
              <a:ext cx="258527" cy="555625"/>
            </a:xfrm>
            <a:custGeom>
              <a:avLst/>
              <a:gdLst>
                <a:gd name="connsiteX0" fmla="*/ 118827 w 258527"/>
                <a:gd name="connsiteY0" fmla="*/ 0 h 555625"/>
                <a:gd name="connsiteX1" fmla="*/ 102952 w 258527"/>
                <a:gd name="connsiteY1" fmla="*/ 63500 h 555625"/>
                <a:gd name="connsiteX2" fmla="*/ 29927 w 258527"/>
                <a:gd name="connsiteY2" fmla="*/ 149225 h 555625"/>
                <a:gd name="connsiteX3" fmla="*/ 1352 w 258527"/>
                <a:gd name="connsiteY3" fmla="*/ 241300 h 555625"/>
                <a:gd name="connsiteX4" fmla="*/ 10877 w 258527"/>
                <a:gd name="connsiteY4" fmla="*/ 365125 h 555625"/>
                <a:gd name="connsiteX5" fmla="*/ 64852 w 258527"/>
                <a:gd name="connsiteY5" fmla="*/ 454025 h 555625"/>
                <a:gd name="connsiteX6" fmla="*/ 185502 w 258527"/>
                <a:gd name="connsiteY6" fmla="*/ 457200 h 555625"/>
                <a:gd name="connsiteX7" fmla="*/ 258527 w 258527"/>
                <a:gd name="connsiteY7" fmla="*/ 555625 h 5556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258527" h="555625">
                  <a:moveTo>
                    <a:pt x="118827" y="0"/>
                  </a:moveTo>
                  <a:cubicBezTo>
                    <a:pt x="118298" y="19314"/>
                    <a:pt x="117769" y="38629"/>
                    <a:pt x="102952" y="63500"/>
                  </a:cubicBezTo>
                  <a:cubicBezTo>
                    <a:pt x="88135" y="88371"/>
                    <a:pt x="46860" y="119592"/>
                    <a:pt x="29927" y="149225"/>
                  </a:cubicBezTo>
                  <a:cubicBezTo>
                    <a:pt x="12994" y="178858"/>
                    <a:pt x="4527" y="205317"/>
                    <a:pt x="1352" y="241300"/>
                  </a:cubicBezTo>
                  <a:cubicBezTo>
                    <a:pt x="-1823" y="277283"/>
                    <a:pt x="294" y="329671"/>
                    <a:pt x="10877" y="365125"/>
                  </a:cubicBezTo>
                  <a:cubicBezTo>
                    <a:pt x="21460" y="400579"/>
                    <a:pt x="35748" y="438679"/>
                    <a:pt x="64852" y="454025"/>
                  </a:cubicBezTo>
                  <a:cubicBezTo>
                    <a:pt x="93956" y="469371"/>
                    <a:pt x="153223" y="440267"/>
                    <a:pt x="185502" y="457200"/>
                  </a:cubicBezTo>
                  <a:cubicBezTo>
                    <a:pt x="217781" y="474133"/>
                    <a:pt x="238154" y="514879"/>
                    <a:pt x="258527" y="555625"/>
                  </a:cubicBezTo>
                </a:path>
              </a:pathLst>
            </a:custGeom>
            <a:noFill/>
            <a:ln>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60" name="Grafik 59">
              <a:extLst>
                <a:ext uri="{FF2B5EF4-FFF2-40B4-BE49-F238E27FC236}">
                  <a16:creationId xmlns:a16="http://schemas.microsoft.com/office/drawing/2014/main" id="{849F76DE-66A3-47DD-B0B7-47E39B701DFE}"/>
                </a:ext>
              </a:extLst>
            </p:cNvPr>
            <p:cNvPicPr>
              <a:picLocks/>
            </p:cNvPicPr>
            <p:nvPr/>
          </p:nvPicPr>
          <p:blipFill>
            <a:blip r:embed="rId21" cstate="hqprint">
              <a:extLst>
                <a:ext uri="{BEBA8EAE-BF5A-486C-A8C5-ECC9F3942E4B}">
                  <a14:imgProps xmlns:a14="http://schemas.microsoft.com/office/drawing/2010/main">
                    <a14:imgLayer r:embed="rId22">
                      <a14:imgEffect>
                        <a14:sharpenSoften amount="25000"/>
                      </a14:imgEffect>
                    </a14:imgLayer>
                  </a14:imgProps>
                </a:ext>
                <a:ext uri="{28A0092B-C50C-407E-A947-70E740481C1C}">
                  <a14:useLocalDpi xmlns:a14="http://schemas.microsoft.com/office/drawing/2010/main"/>
                </a:ext>
              </a:extLst>
            </a:blip>
            <a:stretch>
              <a:fillRect/>
            </a:stretch>
          </p:blipFill>
          <p:spPr>
            <a:xfrm>
              <a:off x="9309872" y="4811554"/>
              <a:ext cx="2678400" cy="2016000"/>
            </a:xfrm>
            <a:prstGeom prst="rect">
              <a:avLst/>
            </a:prstGeom>
            <a:ln w="12700">
              <a:solidFill>
                <a:schemeClr val="tx1"/>
              </a:solidFill>
            </a:ln>
          </p:spPr>
        </p:pic>
      </p:grpSp>
      <p:graphicFrame>
        <p:nvGraphicFramePr>
          <p:cNvPr id="61" name="Objekt 60">
            <a:extLst>
              <a:ext uri="{FF2B5EF4-FFF2-40B4-BE49-F238E27FC236}">
                <a16:creationId xmlns:a16="http://schemas.microsoft.com/office/drawing/2014/main" id="{BE53179F-A181-458A-9A3C-07DAA0AE99AA}"/>
              </a:ext>
            </a:extLst>
          </p:cNvPr>
          <p:cNvGraphicFramePr>
            <a:graphicFrameLocks noChangeAspect="1"/>
          </p:cNvGraphicFramePr>
          <p:nvPr>
            <p:extLst>
              <p:ext uri="{D42A27DB-BD31-4B8C-83A1-F6EECF244321}">
                <p14:modId xmlns:p14="http://schemas.microsoft.com/office/powerpoint/2010/main" val="3694011916"/>
              </p:ext>
            </p:extLst>
          </p:nvPr>
        </p:nvGraphicFramePr>
        <p:xfrm>
          <a:off x="9522281" y="1493244"/>
          <a:ext cx="2006600" cy="2887663"/>
        </p:xfrm>
        <a:graphic>
          <a:graphicData uri="http://schemas.openxmlformats.org/presentationml/2006/ole">
            <mc:AlternateContent xmlns:mc="http://schemas.openxmlformats.org/markup-compatibility/2006">
              <mc:Choice xmlns:v="urn:schemas-microsoft-com:vml" Requires="v">
                <p:oleObj spid="_x0000_s2056" name="Prism 7" r:id="rId23" imgW="2006316" imgH="2888298" progId="Prism7.Document">
                  <p:embed/>
                </p:oleObj>
              </mc:Choice>
              <mc:Fallback>
                <p:oleObj name="Prism 7" r:id="rId23" imgW="2006316" imgH="2888298" progId="Prism7.Document">
                  <p:embed/>
                  <p:pic>
                    <p:nvPicPr>
                      <p:cNvPr id="61" name="Objekt 60">
                        <a:extLst>
                          <a:ext uri="{FF2B5EF4-FFF2-40B4-BE49-F238E27FC236}">
                            <a16:creationId xmlns:a16="http://schemas.microsoft.com/office/drawing/2014/main" id="{1856D997-2612-4765-97E6-FC883A7C9EA1}"/>
                          </a:ext>
                        </a:extLst>
                      </p:cNvPr>
                      <p:cNvPicPr/>
                      <p:nvPr/>
                    </p:nvPicPr>
                    <p:blipFill>
                      <a:blip r:embed="rId24"/>
                      <a:stretch>
                        <a:fillRect/>
                      </a:stretch>
                    </p:blipFill>
                    <p:spPr>
                      <a:xfrm>
                        <a:off x="9522281" y="1493244"/>
                        <a:ext cx="2006600" cy="2887663"/>
                      </a:xfrm>
                      <a:prstGeom prst="rect">
                        <a:avLst/>
                      </a:prstGeom>
                    </p:spPr>
                  </p:pic>
                </p:oleObj>
              </mc:Fallback>
            </mc:AlternateContent>
          </a:graphicData>
        </a:graphic>
      </p:graphicFrame>
      <p:sp>
        <p:nvSpPr>
          <p:cNvPr id="62" name="Textfeld 61">
            <a:extLst>
              <a:ext uri="{FF2B5EF4-FFF2-40B4-BE49-F238E27FC236}">
                <a16:creationId xmlns:a16="http://schemas.microsoft.com/office/drawing/2014/main" id="{86448243-0FAF-4792-BBBC-FDF58F706A7B}"/>
              </a:ext>
            </a:extLst>
          </p:cNvPr>
          <p:cNvSpPr txBox="1"/>
          <p:nvPr/>
        </p:nvSpPr>
        <p:spPr>
          <a:xfrm>
            <a:off x="273565" y="5380672"/>
            <a:ext cx="11549742" cy="1477328"/>
          </a:xfrm>
          <a:prstGeom prst="rect">
            <a:avLst/>
          </a:prstGeom>
          <a:noFill/>
        </p:spPr>
        <p:txBody>
          <a:bodyPr wrap="square">
            <a:spAutoFit/>
          </a:bodyPr>
          <a:lstStyle/>
          <a:p>
            <a:pPr algn="just">
              <a:spcBef>
                <a:spcPts val="600"/>
              </a:spcBef>
              <a:spcAft>
                <a:spcPts val="1200"/>
              </a:spcAft>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Supplemental Figure 2: The inflammatory infiltrate in the skin was comparable between vehicle and disulfiram-treated mice</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Indirect immunofluorescence staining of skin biopsies obtained after systemic treatment with either vehicle or disulfiram showed comparable signals for macrophages (F4/80) and dendritic cells (Cd11c). Dotted lines depict the basement membrane zone. Histological changes with subepidermal split formation and a dense inflammatory infiltrate were similar among both treatment groups. Scale bar = 100 µm</a:t>
            </a:r>
            <a:endParaRPr lang="en-DE" sz="18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66075167"/>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96</Words>
  <Application>Microsoft Office PowerPoint</Application>
  <PresentationFormat>Breitbild</PresentationFormat>
  <Paragraphs>17</Paragraphs>
  <Slides>2</Slides>
  <Notes>0</Notes>
  <HiddenSlides>0</HiddenSlides>
  <MMClips>0</MMClips>
  <ScaleCrop>false</ScaleCrop>
  <HeadingPairs>
    <vt:vector size="8" baseType="variant">
      <vt:variant>
        <vt:lpstr>Verwendete Schriftarten</vt:lpstr>
      </vt:variant>
      <vt:variant>
        <vt:i4>4</vt:i4>
      </vt:variant>
      <vt:variant>
        <vt:lpstr>Design</vt:lpstr>
      </vt:variant>
      <vt:variant>
        <vt:i4>1</vt:i4>
      </vt:variant>
      <vt:variant>
        <vt:lpstr>Eingebettete OLE-Server</vt:lpstr>
      </vt:variant>
      <vt:variant>
        <vt:i4>1</vt:i4>
      </vt:variant>
      <vt:variant>
        <vt:lpstr>Folientitel</vt:lpstr>
      </vt:variant>
      <vt:variant>
        <vt:i4>2</vt:i4>
      </vt:variant>
    </vt:vector>
  </HeadingPairs>
  <TitlesOfParts>
    <vt:vector size="8" baseType="lpstr">
      <vt:lpstr>Arial</vt:lpstr>
      <vt:lpstr>Calibri</vt:lpstr>
      <vt:lpstr>Calibri Light</vt:lpstr>
      <vt:lpstr>Times New Roman</vt:lpstr>
      <vt:lpstr>Office</vt:lpstr>
      <vt:lpstr>Prism 7</vt:lpstr>
      <vt:lpstr>Lesional ski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Tofern, Sabrina</dc:creator>
  <cp:lastModifiedBy>Manuela Pigors</cp:lastModifiedBy>
  <cp:revision>23</cp:revision>
  <dcterms:created xsi:type="dcterms:W3CDTF">2021-12-16T12:20:14Z</dcterms:created>
  <dcterms:modified xsi:type="dcterms:W3CDTF">2021-12-23T12:19:20Z</dcterms:modified>
</cp:coreProperties>
</file>